
<file path=[Content_Types].xml><?xml version="1.0" encoding="utf-8"?>
<Types xmlns="http://schemas.openxmlformats.org/package/2006/content-types">
  <Default Extension="png" ContentType="image/png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4780280" cy="1911350"/>
  <p:notesSz cx="6858000" cy="9144000"/>
  <p:custDataLst>
    <p:tags r:id="rId7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7" userDrawn="1">
          <p15:clr>
            <a:srgbClr val="A4A3A4"/>
          </p15:clr>
        </p15:guide>
        <p15:guide id="2" pos="14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262673"/>
    <a:srgbClr val="F58D14"/>
    <a:srgbClr val="F8F171"/>
    <a:srgbClr val="DD9609"/>
    <a:srgbClr val="FF7E1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647"/>
        <p:guide pos="1460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97692" y="312892"/>
            <a:ext cx="3586151" cy="665614"/>
          </a:xfrm>
        </p:spPr>
        <p:txBody>
          <a:bodyPr anchor="b"/>
          <a:lstStyle>
            <a:lvl1pPr algn="ctr">
              <a:defRPr sz="1255"/>
            </a:lvl1pPr>
          </a:lstStyle>
          <a:p>
            <a:pPr fontAlgn="base"/>
            <a:r>
              <a:rPr lang="zh-CN" altLang="en-US" sz="125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597692" y="1004175"/>
            <a:ext cx="3586151" cy="461593"/>
          </a:xfrm>
        </p:spPr>
        <p:txBody>
          <a:bodyPr/>
          <a:lstStyle>
            <a:lvl1pPr marL="0" indent="0" algn="ctr">
              <a:buNone/>
              <a:defRPr sz="500"/>
            </a:lvl1pPr>
            <a:lvl2pPr marL="95885" indent="0" algn="ctr">
              <a:buNone/>
              <a:defRPr sz="420"/>
            </a:lvl2pPr>
            <a:lvl3pPr marL="191135" indent="0" algn="ctr">
              <a:buNone/>
              <a:defRPr sz="375"/>
            </a:lvl3pPr>
            <a:lvl4pPr marL="287020" indent="0" algn="ctr">
              <a:buNone/>
              <a:defRPr sz="335"/>
            </a:lvl4pPr>
            <a:lvl5pPr marL="382270" indent="0" algn="ctr">
              <a:buNone/>
              <a:defRPr sz="335"/>
            </a:lvl5pPr>
            <a:lvl6pPr marL="478155" indent="0" algn="ctr">
              <a:buNone/>
              <a:defRPr sz="335"/>
            </a:lvl6pPr>
            <a:lvl7pPr marL="573405" indent="0" algn="ctr">
              <a:buNone/>
              <a:defRPr sz="335"/>
            </a:lvl7pPr>
            <a:lvl8pPr marL="669290" indent="0" algn="ctr">
              <a:buNone/>
              <a:defRPr sz="335"/>
            </a:lvl8pPr>
            <a:lvl9pPr marL="764540" indent="0" algn="ctr">
              <a:buNone/>
              <a:defRPr sz="335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z="122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z="89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780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z="670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56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56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466613" y="76563"/>
            <a:ext cx="1075845" cy="1631286"/>
          </a:xfrm>
        </p:spPr>
        <p:txBody>
          <a:bodyPr vert="eaVert"/>
          <a:lstStyle/>
          <a:p>
            <a:pPr fontAlgn="base"/>
            <a:r>
              <a:rPr lang="zh-CN" altLang="en-US" sz="122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39077" y="76563"/>
            <a:ext cx="3165168" cy="1631286"/>
          </a:xfrm>
        </p:spPr>
        <p:txBody>
          <a:bodyPr vert="eaVert"/>
          <a:lstStyle/>
          <a:p>
            <a:pPr lvl="0" fontAlgn="base"/>
            <a:r>
              <a:rPr lang="zh-CN" altLang="en-US" sz="89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780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z="670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56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56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z="122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z="89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780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z="670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56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56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6240" y="476640"/>
            <a:ext cx="4124074" cy="795285"/>
          </a:xfrm>
        </p:spPr>
        <p:txBody>
          <a:bodyPr anchor="b"/>
          <a:lstStyle>
            <a:lvl1pPr>
              <a:defRPr sz="1255"/>
            </a:lvl1pPr>
          </a:lstStyle>
          <a:p>
            <a:pPr fontAlgn="base"/>
            <a:r>
              <a:rPr lang="zh-CN" altLang="en-US" sz="125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6240" y="1279448"/>
            <a:ext cx="4124074" cy="418221"/>
          </a:xfrm>
        </p:spPr>
        <p:txBody>
          <a:bodyPr/>
          <a:lstStyle>
            <a:lvl1pPr marL="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1pPr>
            <a:lvl2pPr marL="9588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2pPr>
            <a:lvl3pPr marL="191135" indent="0">
              <a:buNone/>
              <a:defRPr sz="375">
                <a:solidFill>
                  <a:schemeClr val="tx1">
                    <a:tint val="75000"/>
                  </a:schemeClr>
                </a:solidFill>
              </a:defRPr>
            </a:lvl3pPr>
            <a:lvl4pPr marL="287020" indent="0">
              <a:buNone/>
              <a:defRPr sz="335">
                <a:solidFill>
                  <a:schemeClr val="tx1">
                    <a:tint val="75000"/>
                  </a:schemeClr>
                </a:solidFill>
              </a:defRPr>
            </a:lvl4pPr>
            <a:lvl5pPr marL="382270" indent="0">
              <a:buNone/>
              <a:defRPr sz="335">
                <a:solidFill>
                  <a:schemeClr val="tx1">
                    <a:tint val="75000"/>
                  </a:schemeClr>
                </a:solidFill>
              </a:defRPr>
            </a:lvl5pPr>
            <a:lvl6pPr marL="478155" indent="0">
              <a:buNone/>
              <a:defRPr sz="335">
                <a:solidFill>
                  <a:schemeClr val="tx1">
                    <a:tint val="75000"/>
                  </a:schemeClr>
                </a:solidFill>
              </a:defRPr>
            </a:lvl6pPr>
            <a:lvl7pPr marL="573405" indent="0">
              <a:buNone/>
              <a:defRPr sz="335">
                <a:solidFill>
                  <a:schemeClr val="tx1">
                    <a:tint val="75000"/>
                  </a:schemeClr>
                </a:solidFill>
              </a:defRPr>
            </a:lvl7pPr>
            <a:lvl8pPr marL="669290" indent="0">
              <a:buNone/>
              <a:defRPr sz="335">
                <a:solidFill>
                  <a:schemeClr val="tx1">
                    <a:tint val="75000"/>
                  </a:schemeClr>
                </a:solidFill>
              </a:defRPr>
            </a:lvl8pPr>
            <a:lvl9pPr marL="764540" indent="0">
              <a:buNone/>
              <a:defRPr sz="3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z="122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39077" y="446103"/>
            <a:ext cx="2108657" cy="1261746"/>
          </a:xfrm>
        </p:spPr>
        <p:txBody>
          <a:bodyPr/>
          <a:lstStyle/>
          <a:p>
            <a:pPr lvl="0" fontAlgn="base"/>
            <a:r>
              <a:rPr lang="zh-CN" altLang="en-US" sz="89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780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z="670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56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56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433801" y="446103"/>
            <a:ext cx="2108657" cy="1261746"/>
          </a:xfrm>
        </p:spPr>
        <p:txBody>
          <a:bodyPr/>
          <a:lstStyle/>
          <a:p>
            <a:pPr lvl="0" fontAlgn="base"/>
            <a:r>
              <a:rPr lang="zh-CN" altLang="en-US" sz="89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780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z="670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56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56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9353" y="101789"/>
            <a:ext cx="4124074" cy="369540"/>
          </a:xfrm>
        </p:spPr>
        <p:txBody>
          <a:bodyPr/>
          <a:lstStyle/>
          <a:p>
            <a:pPr fontAlgn="base"/>
            <a:r>
              <a:rPr lang="zh-CN" altLang="en-US" sz="122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5437" y="495792"/>
            <a:ext cx="1911349" cy="229690"/>
          </a:xfrm>
        </p:spPr>
        <p:txBody>
          <a:bodyPr anchor="ctr" anchorCtr="0"/>
          <a:lstStyle>
            <a:lvl1pPr marL="0" indent="0">
              <a:buNone/>
              <a:defRPr sz="585"/>
            </a:lvl1pPr>
            <a:lvl2pPr marL="95885" indent="0">
              <a:buNone/>
              <a:defRPr sz="500"/>
            </a:lvl2pPr>
            <a:lvl3pPr marL="191135" indent="0">
              <a:buNone/>
              <a:defRPr sz="420"/>
            </a:lvl3pPr>
            <a:lvl4pPr marL="287020" indent="0">
              <a:buNone/>
              <a:defRPr sz="375"/>
            </a:lvl4pPr>
            <a:lvl5pPr marL="382270" indent="0">
              <a:buNone/>
              <a:defRPr sz="375"/>
            </a:lvl5pPr>
            <a:lvl6pPr marL="478155" indent="0">
              <a:buNone/>
              <a:defRPr sz="375"/>
            </a:lvl6pPr>
            <a:lvl7pPr marL="573405" indent="0">
              <a:buNone/>
              <a:defRPr sz="375"/>
            </a:lvl7pPr>
            <a:lvl8pPr marL="669290" indent="0">
              <a:buNone/>
              <a:defRPr sz="375"/>
            </a:lvl8pPr>
            <a:lvl9pPr marL="764540" indent="0">
              <a:buNone/>
              <a:defRPr sz="375"/>
            </a:lvl9pPr>
          </a:lstStyle>
          <a:p>
            <a:pPr lvl="0" fontAlgn="base"/>
            <a:r>
              <a:rPr lang="zh-CN" altLang="en-US" sz="585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37" y="743053"/>
            <a:ext cx="1911349" cy="982498"/>
          </a:xfrm>
        </p:spPr>
        <p:txBody>
          <a:bodyPr/>
          <a:lstStyle/>
          <a:p>
            <a:pPr lvl="0" fontAlgn="base"/>
            <a:r>
              <a:rPr lang="zh-CN" altLang="en-US" sz="89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780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z="670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56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56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2453886" y="495792"/>
            <a:ext cx="1920762" cy="229690"/>
          </a:xfrm>
        </p:spPr>
        <p:txBody>
          <a:bodyPr anchor="ctr" anchorCtr="0"/>
          <a:lstStyle>
            <a:lvl1pPr marL="0" indent="0">
              <a:buNone/>
              <a:defRPr sz="585"/>
            </a:lvl1pPr>
            <a:lvl2pPr marL="95885" indent="0">
              <a:buNone/>
              <a:defRPr sz="500"/>
            </a:lvl2pPr>
            <a:lvl3pPr marL="191135" indent="0">
              <a:buNone/>
              <a:defRPr sz="420"/>
            </a:lvl3pPr>
            <a:lvl4pPr marL="287020" indent="0">
              <a:buNone/>
              <a:defRPr sz="375"/>
            </a:lvl4pPr>
            <a:lvl5pPr marL="382270" indent="0">
              <a:buNone/>
              <a:defRPr sz="375"/>
            </a:lvl5pPr>
            <a:lvl6pPr marL="478155" indent="0">
              <a:buNone/>
              <a:defRPr sz="375"/>
            </a:lvl6pPr>
            <a:lvl7pPr marL="573405" indent="0">
              <a:buNone/>
              <a:defRPr sz="375"/>
            </a:lvl7pPr>
            <a:lvl8pPr marL="669290" indent="0">
              <a:buNone/>
              <a:defRPr sz="375"/>
            </a:lvl8pPr>
            <a:lvl9pPr marL="764540" indent="0">
              <a:buNone/>
              <a:defRPr sz="375"/>
            </a:lvl9pPr>
          </a:lstStyle>
          <a:p>
            <a:pPr lvl="0" fontAlgn="base"/>
            <a:r>
              <a:rPr lang="zh-CN" altLang="en-US" sz="585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2453886" y="743053"/>
            <a:ext cx="1920762" cy="982498"/>
          </a:xfrm>
        </p:spPr>
        <p:txBody>
          <a:bodyPr/>
          <a:lstStyle/>
          <a:p>
            <a:pPr lvl="0" fontAlgn="base"/>
            <a:r>
              <a:rPr lang="zh-CN" altLang="en-US" sz="89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780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z="670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56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56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z="1225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9353" y="127458"/>
            <a:ext cx="1542170" cy="446103"/>
          </a:xfrm>
        </p:spPr>
        <p:txBody>
          <a:bodyPr anchor="b"/>
          <a:lstStyle>
            <a:lvl1pPr>
              <a:defRPr sz="670"/>
            </a:lvl1pPr>
          </a:lstStyle>
          <a:p>
            <a:pPr fontAlgn="base"/>
            <a:r>
              <a:rPr lang="zh-CN" altLang="en-US" sz="670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032775" y="275274"/>
            <a:ext cx="2420652" cy="1358667"/>
          </a:xfrm>
        </p:spPr>
        <p:txBody>
          <a:bodyPr/>
          <a:lstStyle>
            <a:lvl1pPr>
              <a:defRPr sz="670"/>
            </a:lvl1pPr>
            <a:lvl2pPr>
              <a:defRPr sz="585"/>
            </a:lvl2pPr>
            <a:lvl3pPr>
              <a:defRPr sz="500"/>
            </a:lvl3pPr>
            <a:lvl4pPr>
              <a:defRPr sz="420"/>
            </a:lvl4pPr>
            <a:lvl5pPr>
              <a:defRPr sz="420"/>
            </a:lvl5pPr>
            <a:lvl6pPr>
              <a:defRPr sz="420"/>
            </a:lvl6pPr>
            <a:lvl7pPr>
              <a:defRPr sz="420"/>
            </a:lvl7pPr>
            <a:lvl8pPr>
              <a:defRPr sz="420"/>
            </a:lvl8pPr>
            <a:lvl9pPr>
              <a:defRPr sz="420"/>
            </a:lvl9pPr>
          </a:lstStyle>
          <a:p>
            <a:pPr lvl="0" fontAlgn="base"/>
            <a:r>
              <a:rPr lang="zh-CN" altLang="en-US" sz="670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z="585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z="420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z="420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29353" y="573561"/>
            <a:ext cx="1542170" cy="1062593"/>
          </a:xfrm>
        </p:spPr>
        <p:txBody>
          <a:bodyPr/>
          <a:lstStyle>
            <a:lvl1pPr marL="0" indent="0">
              <a:buNone/>
              <a:defRPr sz="335"/>
            </a:lvl1pPr>
            <a:lvl2pPr marL="95885" indent="0">
              <a:buNone/>
              <a:defRPr sz="290"/>
            </a:lvl2pPr>
            <a:lvl3pPr marL="191135" indent="0">
              <a:buNone/>
              <a:defRPr sz="250"/>
            </a:lvl3pPr>
            <a:lvl4pPr marL="287020" indent="0">
              <a:buNone/>
              <a:defRPr sz="210"/>
            </a:lvl4pPr>
            <a:lvl5pPr marL="382270" indent="0">
              <a:buNone/>
              <a:defRPr sz="210"/>
            </a:lvl5pPr>
            <a:lvl6pPr marL="478155" indent="0">
              <a:buNone/>
              <a:defRPr sz="210"/>
            </a:lvl6pPr>
            <a:lvl7pPr marL="573405" indent="0">
              <a:buNone/>
              <a:defRPr sz="210"/>
            </a:lvl7pPr>
            <a:lvl8pPr marL="669290" indent="0">
              <a:buNone/>
              <a:defRPr sz="210"/>
            </a:lvl8pPr>
            <a:lvl9pPr marL="764540" indent="0">
              <a:buNone/>
              <a:defRPr sz="210"/>
            </a:lvl9pPr>
          </a:lstStyle>
          <a:p>
            <a:pPr lvl="0" fontAlgn="base"/>
            <a:r>
              <a:rPr lang="zh-CN" altLang="en-US" sz="335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9353" y="127458"/>
            <a:ext cx="1633593" cy="446103"/>
          </a:xfrm>
        </p:spPr>
        <p:txBody>
          <a:bodyPr anchor="b"/>
          <a:lstStyle>
            <a:lvl1pPr>
              <a:defRPr sz="670"/>
            </a:lvl1pPr>
          </a:lstStyle>
          <a:p>
            <a:pPr fontAlgn="base"/>
            <a:r>
              <a:rPr lang="zh-CN" altLang="en-US" sz="670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032775" y="127458"/>
            <a:ext cx="2420652" cy="1506483"/>
          </a:xfrm>
        </p:spPr>
        <p:txBody>
          <a:bodyPr/>
          <a:lstStyle>
            <a:lvl1pPr marL="0" indent="0">
              <a:buNone/>
              <a:defRPr sz="670"/>
            </a:lvl1pPr>
            <a:lvl2pPr marL="95885" indent="0">
              <a:buNone/>
              <a:defRPr sz="585"/>
            </a:lvl2pPr>
            <a:lvl3pPr marL="191135" indent="0">
              <a:buNone/>
              <a:defRPr sz="500"/>
            </a:lvl3pPr>
            <a:lvl4pPr marL="287020" indent="0">
              <a:buNone/>
              <a:defRPr sz="420"/>
            </a:lvl4pPr>
            <a:lvl5pPr marL="382270" indent="0">
              <a:buNone/>
              <a:defRPr sz="420"/>
            </a:lvl5pPr>
            <a:lvl6pPr marL="478155" indent="0">
              <a:buNone/>
              <a:defRPr sz="420"/>
            </a:lvl6pPr>
            <a:lvl7pPr marL="573405" indent="0">
              <a:buNone/>
              <a:defRPr sz="420"/>
            </a:lvl7pPr>
            <a:lvl8pPr marL="669290" indent="0">
              <a:buNone/>
              <a:defRPr sz="420"/>
            </a:lvl8pPr>
            <a:lvl9pPr marL="764540" indent="0">
              <a:buNone/>
              <a:defRPr sz="42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29353" y="573561"/>
            <a:ext cx="1633593" cy="1062593"/>
          </a:xfrm>
        </p:spPr>
        <p:txBody>
          <a:bodyPr/>
          <a:lstStyle>
            <a:lvl1pPr marL="0" indent="0">
              <a:buNone/>
              <a:defRPr sz="420"/>
            </a:lvl1pPr>
            <a:lvl2pPr marL="95885" indent="0">
              <a:buNone/>
              <a:defRPr sz="375"/>
            </a:lvl2pPr>
            <a:lvl3pPr marL="191135" indent="0">
              <a:buNone/>
              <a:defRPr sz="335"/>
            </a:lvl3pPr>
            <a:lvl4pPr marL="287020" indent="0">
              <a:buNone/>
              <a:defRPr sz="290"/>
            </a:lvl4pPr>
            <a:lvl5pPr marL="382270" indent="0">
              <a:buNone/>
              <a:defRPr sz="290"/>
            </a:lvl5pPr>
            <a:lvl6pPr marL="478155" indent="0">
              <a:buNone/>
              <a:defRPr sz="290"/>
            </a:lvl6pPr>
            <a:lvl7pPr marL="573405" indent="0">
              <a:buNone/>
              <a:defRPr sz="290"/>
            </a:lvl7pPr>
            <a:lvl8pPr marL="669290" indent="0">
              <a:buNone/>
              <a:defRPr sz="290"/>
            </a:lvl8pPr>
            <a:lvl9pPr marL="764540" indent="0">
              <a:buNone/>
              <a:defRPr sz="290"/>
            </a:lvl9pPr>
          </a:lstStyle>
          <a:p>
            <a:pPr lvl="0" fontAlgn="base"/>
            <a:r>
              <a:rPr lang="zh-CN" altLang="en-US" sz="420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239713" y="76200"/>
            <a:ext cx="4302125" cy="319088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p>
            <a:pPr lvl="0" fontAlgn="base"/>
            <a:r>
              <a:rPr lang="zh-CN" altLang="en-US" sz="1225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239713" y="446088"/>
            <a:ext cx="4302125" cy="12620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p>
            <a:pPr lvl="0" fontAlgn="base"/>
            <a:r>
              <a:rPr lang="zh-CN" altLang="en-US" sz="890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z="780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z="670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z="560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z="560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239713" y="1741488"/>
            <a:ext cx="1114425" cy="131763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39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1633538" y="1741488"/>
            <a:ext cx="1514475" cy="131763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39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3427413" y="1741488"/>
            <a:ext cx="1114425" cy="131763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390"/>
            </a:lvl1pPr>
          </a:lstStyle>
          <a:p>
            <a:pPr lvl="0" fontAlgn="base"/>
            <a:fld id="{9A0DB2DC-4C9A-4742-B13C-FB6460FD3503}" type="slidenum">
              <a:rPr lang="zh-CN" altLang="en-US" sz="390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225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95885" lvl="0" indent="-95885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•"/>
        <a:defRPr sz="89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207010" lvl="1" indent="-79375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–"/>
        <a:defRPr sz="78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318770" lvl="2" indent="-63500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•"/>
        <a:defRPr sz="67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446405" lvl="3" indent="-63500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–"/>
        <a:defRPr sz="56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573405" lvl="4" indent="-63500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»"/>
        <a:defRPr sz="56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701040" lvl="5" indent="-63500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»"/>
        <a:defRPr sz="56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828675" lvl="6" indent="-63500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»"/>
        <a:defRPr sz="56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955675" lvl="7" indent="-63500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»"/>
        <a:defRPr sz="56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1083310" lvl="8" indent="-63500" algn="l" defTabSz="255270" eaLnBrk="1" fontAlgn="base" latinLnBrk="0" hangingPunct="1">
        <a:lnSpc>
          <a:spcPct val="100000"/>
        </a:lnSpc>
        <a:spcBef>
          <a:spcPts val="25"/>
        </a:spcBef>
        <a:spcAft>
          <a:spcPct val="0"/>
        </a:spcAft>
        <a:buChar char="»"/>
        <a:defRPr sz="56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127635" lvl="1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255270" lvl="2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382270" lvl="3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509905" lvl="4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637540" lvl="5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764540" lvl="6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892175" lvl="7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1019810" lvl="8" indent="0" algn="l" defTabSz="25527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148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5885" y="1027430"/>
            <a:ext cx="990600" cy="79438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49" name="图片 1" descr="水稻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6100" y="595630"/>
            <a:ext cx="569913" cy="3794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0" name="图片 2" descr="Fig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6495" y="556260"/>
            <a:ext cx="1007745" cy="13017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2" name="图片 4" descr="Fig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73300" y="629920"/>
            <a:ext cx="1228725" cy="650240"/>
          </a:xfrm>
          <a:prstGeom prst="rect">
            <a:avLst/>
          </a:prstGeom>
          <a:noFill/>
          <a:ln w="9525">
            <a:noFill/>
          </a:ln>
        </p:spPr>
      </p:pic>
      <p:grpSp>
        <p:nvGrpSpPr>
          <p:cNvPr id="2049" name="组合 2"/>
          <p:cNvGrpSpPr/>
          <p:nvPr/>
        </p:nvGrpSpPr>
        <p:grpSpPr>
          <a:xfrm>
            <a:off x="188595" y="587058"/>
            <a:ext cx="385763" cy="379412"/>
            <a:chOff x="2728" y="1200"/>
            <a:chExt cx="3344" cy="3174"/>
          </a:xfrm>
        </p:grpSpPr>
        <p:grpSp>
          <p:nvGrpSpPr>
            <p:cNvPr id="2050" name="Group 67"/>
            <p:cNvGrpSpPr/>
            <p:nvPr/>
          </p:nvGrpSpPr>
          <p:grpSpPr>
            <a:xfrm>
              <a:off x="2727" y="1200"/>
              <a:ext cx="3345" cy="3175"/>
              <a:chOff x="2189" y="1681"/>
              <a:chExt cx="1338" cy="1270"/>
            </a:xfrm>
          </p:grpSpPr>
          <p:sp>
            <p:nvSpPr>
              <p:cNvPr id="2051" name="Freeform 68"/>
              <p:cNvSpPr/>
              <p:nvPr/>
            </p:nvSpPr>
            <p:spPr>
              <a:xfrm>
                <a:off x="2214" y="1681"/>
                <a:ext cx="1313" cy="1270"/>
              </a:xfrm>
              <a:custGeom>
                <a:avLst/>
                <a:gdLst/>
                <a:ahLst/>
                <a:cxnLst>
                  <a:cxn ang="0">
                    <a:pos x="3096" y="6897"/>
                  </a:cxn>
                  <a:cxn ang="0">
                    <a:pos x="2471" y="11659"/>
                  </a:cxn>
                  <a:cxn ang="0">
                    <a:pos x="313" y="16374"/>
                  </a:cxn>
                  <a:cxn ang="0">
                    <a:pos x="4897" y="21027"/>
                  </a:cxn>
                  <a:cxn ang="0">
                    <a:pos x="13060" y="21542"/>
                  </a:cxn>
                  <a:cxn ang="0">
                    <a:pos x="20540" y="24117"/>
                  </a:cxn>
                  <a:cxn ang="0">
                    <a:pos x="13498" y="21027"/>
                  </a:cxn>
                  <a:cxn ang="0">
                    <a:pos x="5630" y="20267"/>
                  </a:cxn>
                  <a:cxn ang="0">
                    <a:pos x="1376" y="16465"/>
                  </a:cxn>
                  <a:cxn ang="0">
                    <a:pos x="2864" y="14037"/>
                  </a:cxn>
                  <a:cxn ang="0">
                    <a:pos x="4034" y="13882"/>
                  </a:cxn>
                  <a:cxn ang="0">
                    <a:pos x="6535" y="14893"/>
                  </a:cxn>
                  <a:cxn ang="0">
                    <a:pos x="9231" y="14792"/>
                  </a:cxn>
                  <a:cxn ang="0">
                    <a:pos x="11622" y="14701"/>
                  </a:cxn>
                  <a:cxn ang="0">
                    <a:pos x="12797" y="15859"/>
                  </a:cxn>
                  <a:cxn ang="0">
                    <a:pos x="13968" y="16865"/>
                  </a:cxn>
                  <a:cxn ang="0">
                    <a:pos x="14280" y="17377"/>
                  </a:cxn>
                  <a:cxn ang="0">
                    <a:pos x="14468" y="17591"/>
                  </a:cxn>
                  <a:cxn ang="0">
                    <a:pos x="14435" y="17318"/>
                  </a:cxn>
                  <a:cxn ang="0">
                    <a:pos x="14393" y="16828"/>
                  </a:cxn>
                  <a:cxn ang="0">
                    <a:pos x="14781" y="17020"/>
                  </a:cxn>
                  <a:cxn ang="0">
                    <a:pos x="15018" y="17134"/>
                  </a:cxn>
                  <a:cxn ang="0">
                    <a:pos x="15093" y="17228"/>
                  </a:cxn>
                  <a:cxn ang="0">
                    <a:pos x="15018" y="16771"/>
                  </a:cxn>
                  <a:cxn ang="0">
                    <a:pos x="15093" y="16828"/>
                  </a:cxn>
                  <a:cxn ang="0">
                    <a:pos x="15218" y="16865"/>
                  </a:cxn>
                  <a:cxn ang="0">
                    <a:pos x="15143" y="16566"/>
                  </a:cxn>
                  <a:cxn ang="0">
                    <a:pos x="15018" y="16225"/>
                  </a:cxn>
                  <a:cxn ang="0">
                    <a:pos x="14706" y="16067"/>
                  </a:cxn>
                  <a:cxn ang="0">
                    <a:pos x="14623" y="15918"/>
                  </a:cxn>
                  <a:cxn ang="0">
                    <a:pos x="14080" y="15859"/>
                  </a:cxn>
                  <a:cxn ang="0">
                    <a:pos x="13455" y="15099"/>
                  </a:cxn>
                  <a:cxn ang="0">
                    <a:pos x="13580" y="14736"/>
                  </a:cxn>
                  <a:cxn ang="0">
                    <a:pos x="13998" y="15043"/>
                  </a:cxn>
                  <a:cxn ang="0">
                    <a:pos x="14310" y="15461"/>
                  </a:cxn>
                  <a:cxn ang="0">
                    <a:pos x="14435" y="15611"/>
                  </a:cxn>
                  <a:cxn ang="0">
                    <a:pos x="14435" y="15304"/>
                  </a:cxn>
                  <a:cxn ang="0">
                    <a:pos x="14623" y="15304"/>
                  </a:cxn>
                  <a:cxn ang="0">
                    <a:pos x="14861" y="15461"/>
                  </a:cxn>
                  <a:cxn ang="0">
                    <a:pos x="14936" y="15611"/>
                  </a:cxn>
                  <a:cxn ang="0">
                    <a:pos x="14781" y="14893"/>
                  </a:cxn>
                  <a:cxn ang="0">
                    <a:pos x="15018" y="15005"/>
                  </a:cxn>
                  <a:cxn ang="0">
                    <a:pos x="14706" y="14336"/>
                  </a:cxn>
                  <a:cxn ang="0">
                    <a:pos x="14235" y="14130"/>
                  </a:cxn>
                  <a:cxn ang="0">
                    <a:pos x="13810" y="13882"/>
                  </a:cxn>
                  <a:cxn ang="0">
                    <a:pos x="13580" y="13482"/>
                  </a:cxn>
                  <a:cxn ang="0">
                    <a:pos x="13655" y="13183"/>
                  </a:cxn>
                  <a:cxn ang="0">
                    <a:pos x="13580" y="13276"/>
                  </a:cxn>
                  <a:cxn ang="0">
                    <a:pos x="15061" y="12273"/>
                  </a:cxn>
                  <a:cxn ang="0">
                    <a:pos x="15769" y="12273"/>
                  </a:cxn>
                  <a:cxn ang="0">
                    <a:pos x="17102" y="12820"/>
                  </a:cxn>
                  <a:cxn ang="0">
                    <a:pos x="18194" y="12572"/>
                  </a:cxn>
                  <a:cxn ang="0">
                    <a:pos x="18852" y="12001"/>
                  </a:cxn>
                  <a:cxn ang="0">
                    <a:pos x="18457" y="10387"/>
                  </a:cxn>
                  <a:cxn ang="0">
                    <a:pos x="17882" y="8778"/>
                  </a:cxn>
                  <a:cxn ang="0">
                    <a:pos x="17444" y="7503"/>
                  </a:cxn>
                  <a:cxn ang="0">
                    <a:pos x="16739" y="6230"/>
                  </a:cxn>
                  <a:cxn ang="0">
                    <a:pos x="15999" y="4771"/>
                  </a:cxn>
                  <a:cxn ang="0">
                    <a:pos x="15143" y="2185"/>
                  </a:cxn>
                  <a:cxn ang="0">
                    <a:pos x="14123" y="2377"/>
                  </a:cxn>
                  <a:cxn ang="0">
                    <a:pos x="14280" y="3858"/>
                  </a:cxn>
                  <a:cxn ang="0">
                    <a:pos x="13685" y="3701"/>
                  </a:cxn>
                  <a:cxn ang="0">
                    <a:pos x="3096" y="6897"/>
                  </a:cxn>
                </a:cxnLst>
                <a:pathLst>
                  <a:path w="525" h="476">
                    <a:moveTo>
                      <a:pt x="79" y="136"/>
                    </a:moveTo>
                    <a:cubicBezTo>
                      <a:pt x="63" y="190"/>
                      <a:pt x="69" y="212"/>
                      <a:pt x="63" y="230"/>
                    </a:cubicBezTo>
                    <a:cubicBezTo>
                      <a:pt x="56" y="247"/>
                      <a:pt x="19" y="271"/>
                      <a:pt x="8" y="323"/>
                    </a:cubicBezTo>
                    <a:cubicBezTo>
                      <a:pt x="0" y="357"/>
                      <a:pt x="24" y="394"/>
                      <a:pt x="125" y="415"/>
                    </a:cubicBezTo>
                    <a:cubicBezTo>
                      <a:pt x="227" y="436"/>
                      <a:pt x="284" y="423"/>
                      <a:pt x="334" y="425"/>
                    </a:cubicBezTo>
                    <a:cubicBezTo>
                      <a:pt x="385" y="427"/>
                      <a:pt x="490" y="426"/>
                      <a:pt x="525" y="476"/>
                    </a:cubicBezTo>
                    <a:cubicBezTo>
                      <a:pt x="490" y="426"/>
                      <a:pt x="396" y="417"/>
                      <a:pt x="345" y="415"/>
                    </a:cubicBezTo>
                    <a:cubicBezTo>
                      <a:pt x="295" y="412"/>
                      <a:pt x="246" y="421"/>
                      <a:pt x="144" y="400"/>
                    </a:cubicBezTo>
                    <a:cubicBezTo>
                      <a:pt x="60" y="379"/>
                      <a:pt x="28" y="359"/>
                      <a:pt x="35" y="325"/>
                    </a:cubicBezTo>
                    <a:cubicBezTo>
                      <a:pt x="40" y="303"/>
                      <a:pt x="68" y="280"/>
                      <a:pt x="73" y="277"/>
                    </a:cubicBezTo>
                    <a:cubicBezTo>
                      <a:pt x="82" y="270"/>
                      <a:pt x="92" y="269"/>
                      <a:pt x="103" y="274"/>
                    </a:cubicBezTo>
                    <a:cubicBezTo>
                      <a:pt x="121" y="283"/>
                      <a:pt x="156" y="294"/>
                      <a:pt x="167" y="294"/>
                    </a:cubicBezTo>
                    <a:cubicBezTo>
                      <a:pt x="179" y="294"/>
                      <a:pt x="214" y="296"/>
                      <a:pt x="236" y="292"/>
                    </a:cubicBezTo>
                    <a:cubicBezTo>
                      <a:pt x="259" y="287"/>
                      <a:pt x="277" y="274"/>
                      <a:pt x="297" y="290"/>
                    </a:cubicBezTo>
                    <a:cubicBezTo>
                      <a:pt x="305" y="297"/>
                      <a:pt x="318" y="307"/>
                      <a:pt x="327" y="313"/>
                    </a:cubicBezTo>
                    <a:cubicBezTo>
                      <a:pt x="335" y="319"/>
                      <a:pt x="354" y="329"/>
                      <a:pt x="357" y="333"/>
                    </a:cubicBezTo>
                    <a:cubicBezTo>
                      <a:pt x="359" y="337"/>
                      <a:pt x="364" y="341"/>
                      <a:pt x="365" y="343"/>
                    </a:cubicBezTo>
                    <a:cubicBezTo>
                      <a:pt x="367" y="344"/>
                      <a:pt x="367" y="347"/>
                      <a:pt x="370" y="347"/>
                    </a:cubicBezTo>
                    <a:cubicBezTo>
                      <a:pt x="372" y="346"/>
                      <a:pt x="369" y="344"/>
                      <a:pt x="369" y="342"/>
                    </a:cubicBezTo>
                    <a:cubicBezTo>
                      <a:pt x="369" y="340"/>
                      <a:pt x="370" y="335"/>
                      <a:pt x="368" y="332"/>
                    </a:cubicBezTo>
                    <a:cubicBezTo>
                      <a:pt x="370" y="333"/>
                      <a:pt x="375" y="336"/>
                      <a:pt x="378" y="336"/>
                    </a:cubicBezTo>
                    <a:cubicBezTo>
                      <a:pt x="381" y="337"/>
                      <a:pt x="382" y="337"/>
                      <a:pt x="384" y="338"/>
                    </a:cubicBezTo>
                    <a:cubicBezTo>
                      <a:pt x="385" y="339"/>
                      <a:pt x="385" y="341"/>
                      <a:pt x="386" y="340"/>
                    </a:cubicBezTo>
                    <a:cubicBezTo>
                      <a:pt x="388" y="338"/>
                      <a:pt x="387" y="336"/>
                      <a:pt x="384" y="331"/>
                    </a:cubicBezTo>
                    <a:cubicBezTo>
                      <a:pt x="384" y="331"/>
                      <a:pt x="385" y="331"/>
                      <a:pt x="386" y="332"/>
                    </a:cubicBezTo>
                    <a:cubicBezTo>
                      <a:pt x="387" y="334"/>
                      <a:pt x="389" y="333"/>
                      <a:pt x="389" y="333"/>
                    </a:cubicBezTo>
                    <a:cubicBezTo>
                      <a:pt x="389" y="333"/>
                      <a:pt x="388" y="330"/>
                      <a:pt x="387" y="327"/>
                    </a:cubicBezTo>
                    <a:cubicBezTo>
                      <a:pt x="386" y="324"/>
                      <a:pt x="385" y="322"/>
                      <a:pt x="384" y="320"/>
                    </a:cubicBezTo>
                    <a:cubicBezTo>
                      <a:pt x="382" y="318"/>
                      <a:pt x="376" y="317"/>
                      <a:pt x="376" y="317"/>
                    </a:cubicBezTo>
                    <a:cubicBezTo>
                      <a:pt x="376" y="317"/>
                      <a:pt x="375" y="316"/>
                      <a:pt x="374" y="314"/>
                    </a:cubicBezTo>
                    <a:cubicBezTo>
                      <a:pt x="372" y="313"/>
                      <a:pt x="361" y="314"/>
                      <a:pt x="360" y="313"/>
                    </a:cubicBezTo>
                    <a:cubicBezTo>
                      <a:pt x="359" y="313"/>
                      <a:pt x="345" y="301"/>
                      <a:pt x="344" y="298"/>
                    </a:cubicBezTo>
                    <a:cubicBezTo>
                      <a:pt x="342" y="296"/>
                      <a:pt x="345" y="290"/>
                      <a:pt x="347" y="291"/>
                    </a:cubicBezTo>
                    <a:cubicBezTo>
                      <a:pt x="349" y="292"/>
                      <a:pt x="355" y="293"/>
                      <a:pt x="358" y="297"/>
                    </a:cubicBezTo>
                    <a:cubicBezTo>
                      <a:pt x="360" y="299"/>
                      <a:pt x="364" y="303"/>
                      <a:pt x="366" y="305"/>
                    </a:cubicBezTo>
                    <a:cubicBezTo>
                      <a:pt x="369" y="307"/>
                      <a:pt x="367" y="308"/>
                      <a:pt x="369" y="308"/>
                    </a:cubicBezTo>
                    <a:cubicBezTo>
                      <a:pt x="370" y="307"/>
                      <a:pt x="371" y="305"/>
                      <a:pt x="369" y="302"/>
                    </a:cubicBezTo>
                    <a:cubicBezTo>
                      <a:pt x="369" y="302"/>
                      <a:pt x="371" y="302"/>
                      <a:pt x="374" y="302"/>
                    </a:cubicBezTo>
                    <a:cubicBezTo>
                      <a:pt x="376" y="303"/>
                      <a:pt x="379" y="303"/>
                      <a:pt x="380" y="305"/>
                    </a:cubicBezTo>
                    <a:cubicBezTo>
                      <a:pt x="381" y="307"/>
                      <a:pt x="381" y="309"/>
                      <a:pt x="382" y="308"/>
                    </a:cubicBezTo>
                    <a:cubicBezTo>
                      <a:pt x="383" y="306"/>
                      <a:pt x="383" y="301"/>
                      <a:pt x="378" y="294"/>
                    </a:cubicBezTo>
                    <a:cubicBezTo>
                      <a:pt x="378" y="294"/>
                      <a:pt x="382" y="294"/>
                      <a:pt x="384" y="296"/>
                    </a:cubicBezTo>
                    <a:cubicBezTo>
                      <a:pt x="385" y="294"/>
                      <a:pt x="380" y="286"/>
                      <a:pt x="376" y="283"/>
                    </a:cubicBezTo>
                    <a:cubicBezTo>
                      <a:pt x="373" y="281"/>
                      <a:pt x="366" y="280"/>
                      <a:pt x="364" y="279"/>
                    </a:cubicBezTo>
                    <a:cubicBezTo>
                      <a:pt x="361" y="277"/>
                      <a:pt x="358" y="275"/>
                      <a:pt x="353" y="274"/>
                    </a:cubicBezTo>
                    <a:cubicBezTo>
                      <a:pt x="348" y="272"/>
                      <a:pt x="350" y="272"/>
                      <a:pt x="347" y="266"/>
                    </a:cubicBezTo>
                    <a:cubicBezTo>
                      <a:pt x="347" y="264"/>
                      <a:pt x="347" y="262"/>
                      <a:pt x="349" y="260"/>
                    </a:cubicBezTo>
                    <a:cubicBezTo>
                      <a:pt x="347" y="262"/>
                      <a:pt x="347" y="262"/>
                      <a:pt x="347" y="262"/>
                    </a:cubicBezTo>
                    <a:cubicBezTo>
                      <a:pt x="350" y="255"/>
                      <a:pt x="362" y="241"/>
                      <a:pt x="385" y="242"/>
                    </a:cubicBezTo>
                    <a:cubicBezTo>
                      <a:pt x="385" y="242"/>
                      <a:pt x="391" y="244"/>
                      <a:pt x="403" y="242"/>
                    </a:cubicBezTo>
                    <a:cubicBezTo>
                      <a:pt x="416" y="240"/>
                      <a:pt x="430" y="250"/>
                      <a:pt x="437" y="253"/>
                    </a:cubicBezTo>
                    <a:cubicBezTo>
                      <a:pt x="445" y="256"/>
                      <a:pt x="459" y="249"/>
                      <a:pt x="465" y="248"/>
                    </a:cubicBezTo>
                    <a:cubicBezTo>
                      <a:pt x="470" y="246"/>
                      <a:pt x="478" y="244"/>
                      <a:pt x="482" y="237"/>
                    </a:cubicBezTo>
                    <a:cubicBezTo>
                      <a:pt x="487" y="229"/>
                      <a:pt x="478" y="218"/>
                      <a:pt x="472" y="205"/>
                    </a:cubicBezTo>
                    <a:cubicBezTo>
                      <a:pt x="467" y="192"/>
                      <a:pt x="459" y="182"/>
                      <a:pt x="457" y="173"/>
                    </a:cubicBezTo>
                    <a:cubicBezTo>
                      <a:pt x="458" y="151"/>
                      <a:pt x="446" y="148"/>
                      <a:pt x="446" y="148"/>
                    </a:cubicBezTo>
                    <a:cubicBezTo>
                      <a:pt x="446" y="148"/>
                      <a:pt x="434" y="137"/>
                      <a:pt x="428" y="123"/>
                    </a:cubicBezTo>
                    <a:cubicBezTo>
                      <a:pt x="421" y="109"/>
                      <a:pt x="417" y="104"/>
                      <a:pt x="409" y="94"/>
                    </a:cubicBezTo>
                    <a:cubicBezTo>
                      <a:pt x="409" y="94"/>
                      <a:pt x="411" y="63"/>
                      <a:pt x="387" y="43"/>
                    </a:cubicBezTo>
                    <a:cubicBezTo>
                      <a:pt x="363" y="23"/>
                      <a:pt x="357" y="32"/>
                      <a:pt x="361" y="47"/>
                    </a:cubicBezTo>
                    <a:cubicBezTo>
                      <a:pt x="364" y="63"/>
                      <a:pt x="365" y="76"/>
                      <a:pt x="365" y="76"/>
                    </a:cubicBezTo>
                    <a:cubicBezTo>
                      <a:pt x="365" y="76"/>
                      <a:pt x="361" y="79"/>
                      <a:pt x="350" y="73"/>
                    </a:cubicBezTo>
                    <a:cubicBezTo>
                      <a:pt x="183" y="0"/>
                      <a:pt x="92" y="92"/>
                      <a:pt x="79" y="136"/>
                    </a:cubicBezTo>
                    <a:close/>
                  </a:path>
                </a:pathLst>
              </a:custGeom>
              <a:solidFill>
                <a:srgbClr val="E6E6E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2" name="Freeform 69"/>
              <p:cNvSpPr/>
              <p:nvPr/>
            </p:nvSpPr>
            <p:spPr>
              <a:xfrm>
                <a:off x="2557" y="2017"/>
                <a:ext cx="498" cy="406"/>
              </a:xfrm>
              <a:custGeom>
                <a:avLst/>
                <a:gdLst/>
                <a:ahLst/>
                <a:cxnLst>
                  <a:cxn ang="0">
                    <a:pos x="0" y="6728"/>
                  </a:cxn>
                  <a:cxn ang="0">
                    <a:pos x="2192" y="6763"/>
                  </a:cxn>
                  <a:cxn ang="0">
                    <a:pos x="4902" y="4573"/>
                  </a:cxn>
                  <a:cxn ang="0">
                    <a:pos x="6031" y="0"/>
                  </a:cxn>
                  <a:cxn ang="0">
                    <a:pos x="6582" y="857"/>
                  </a:cxn>
                  <a:cxn ang="0">
                    <a:pos x="7490" y="2348"/>
                  </a:cxn>
                  <a:cxn ang="0">
                    <a:pos x="6507" y="5601"/>
                  </a:cxn>
                  <a:cxn ang="0">
                    <a:pos x="4702" y="7070"/>
                  </a:cxn>
                  <a:cxn ang="0">
                    <a:pos x="2663" y="7583"/>
                  </a:cxn>
                  <a:cxn ang="0">
                    <a:pos x="313" y="7220"/>
                  </a:cxn>
                </a:cxnLst>
                <a:pathLst>
                  <a:path w="199" h="152">
                    <a:moveTo>
                      <a:pt x="0" y="132"/>
                    </a:moveTo>
                    <a:cubicBezTo>
                      <a:pt x="9" y="138"/>
                      <a:pt x="46" y="135"/>
                      <a:pt x="56" y="133"/>
                    </a:cubicBezTo>
                    <a:cubicBezTo>
                      <a:pt x="83" y="126"/>
                      <a:pt x="107" y="111"/>
                      <a:pt x="125" y="90"/>
                    </a:cubicBezTo>
                    <a:cubicBezTo>
                      <a:pt x="144" y="66"/>
                      <a:pt x="155" y="31"/>
                      <a:pt x="154" y="0"/>
                    </a:cubicBezTo>
                    <a:cubicBezTo>
                      <a:pt x="155" y="6"/>
                      <a:pt x="164" y="13"/>
                      <a:pt x="168" y="17"/>
                    </a:cubicBezTo>
                    <a:cubicBezTo>
                      <a:pt x="177" y="26"/>
                      <a:pt x="186" y="33"/>
                      <a:pt x="191" y="46"/>
                    </a:cubicBezTo>
                    <a:cubicBezTo>
                      <a:pt x="199" y="66"/>
                      <a:pt x="180" y="96"/>
                      <a:pt x="166" y="110"/>
                    </a:cubicBezTo>
                    <a:cubicBezTo>
                      <a:pt x="153" y="123"/>
                      <a:pt x="138" y="133"/>
                      <a:pt x="120" y="139"/>
                    </a:cubicBezTo>
                    <a:cubicBezTo>
                      <a:pt x="104" y="143"/>
                      <a:pt x="85" y="147"/>
                      <a:pt x="68" y="149"/>
                    </a:cubicBezTo>
                    <a:cubicBezTo>
                      <a:pt x="46" y="152"/>
                      <a:pt x="29" y="146"/>
                      <a:pt x="8" y="142"/>
                    </a:cubicBezTo>
                  </a:path>
                </a:pathLst>
              </a:custGeom>
              <a:solidFill>
                <a:srgbClr val="D6D6D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3" name="Freeform 70"/>
              <p:cNvSpPr/>
              <p:nvPr/>
            </p:nvSpPr>
            <p:spPr>
              <a:xfrm>
                <a:off x="2544" y="2441"/>
                <a:ext cx="238" cy="11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08" y="215"/>
                  </a:cxn>
                  <a:cxn ang="0">
                    <a:pos x="1180" y="735"/>
                  </a:cxn>
                  <a:cxn ang="0">
                    <a:pos x="1576" y="1505"/>
                  </a:cxn>
                  <a:cxn ang="0">
                    <a:pos x="1651" y="1604"/>
                  </a:cxn>
                  <a:cxn ang="0">
                    <a:pos x="1701" y="1757"/>
                  </a:cxn>
                  <a:cxn ang="0">
                    <a:pos x="1731" y="1663"/>
                  </a:cxn>
                  <a:cxn ang="0">
                    <a:pos x="1776" y="1446"/>
                  </a:cxn>
                  <a:cxn ang="0">
                    <a:pos x="1701" y="987"/>
                  </a:cxn>
                  <a:cxn ang="0">
                    <a:pos x="2277" y="1138"/>
                  </a:cxn>
                  <a:cxn ang="0">
                    <a:pos x="2673" y="1757"/>
                  </a:cxn>
                  <a:cxn ang="0">
                    <a:pos x="2874" y="1972"/>
                  </a:cxn>
                  <a:cxn ang="0">
                    <a:pos x="2956" y="2122"/>
                  </a:cxn>
                  <a:cxn ang="0">
                    <a:pos x="2956" y="1972"/>
                  </a:cxn>
                  <a:cxn ang="0">
                    <a:pos x="2906" y="1390"/>
                  </a:cxn>
                  <a:cxn ang="0">
                    <a:pos x="3194" y="1505"/>
                  </a:cxn>
                  <a:cxn ang="0">
                    <a:pos x="3427" y="1604"/>
                  </a:cxn>
                  <a:cxn ang="0">
                    <a:pos x="3507" y="1663"/>
                  </a:cxn>
                  <a:cxn ang="0">
                    <a:pos x="3507" y="1505"/>
                  </a:cxn>
                  <a:cxn ang="0">
                    <a:pos x="3427" y="1296"/>
                  </a:cxn>
                  <a:cxn ang="0">
                    <a:pos x="3615" y="1296"/>
                  </a:cxn>
                  <a:cxn ang="0">
                    <a:pos x="3740" y="1296"/>
                  </a:cxn>
                  <a:cxn ang="0">
                    <a:pos x="3665" y="1194"/>
                  </a:cxn>
                  <a:cxn ang="0">
                    <a:pos x="3352" y="770"/>
                  </a:cxn>
                  <a:cxn ang="0">
                    <a:pos x="2831" y="518"/>
                  </a:cxn>
                  <a:cxn ang="0">
                    <a:pos x="1380" y="461"/>
                  </a:cxn>
                  <a:cxn ang="0">
                    <a:pos x="0" y="0"/>
                  </a:cxn>
                </a:cxnLst>
                <a:pathLst>
                  <a:path w="95" h="41">
                    <a:moveTo>
                      <a:pt x="0" y="0"/>
                    </a:moveTo>
                    <a:cubicBezTo>
                      <a:pt x="1" y="2"/>
                      <a:pt x="3" y="3"/>
                      <a:pt x="5" y="4"/>
                    </a:cubicBezTo>
                    <a:cubicBezTo>
                      <a:pt x="10" y="6"/>
                      <a:pt x="26" y="12"/>
                      <a:pt x="30" y="14"/>
                    </a:cubicBezTo>
                    <a:cubicBezTo>
                      <a:pt x="33" y="16"/>
                      <a:pt x="37" y="24"/>
                      <a:pt x="40" y="29"/>
                    </a:cubicBezTo>
                    <a:cubicBezTo>
                      <a:pt x="40" y="30"/>
                      <a:pt x="41" y="31"/>
                      <a:pt x="42" y="31"/>
                    </a:cubicBezTo>
                    <a:cubicBezTo>
                      <a:pt x="43" y="33"/>
                      <a:pt x="43" y="34"/>
                      <a:pt x="43" y="34"/>
                    </a:cubicBezTo>
                    <a:cubicBezTo>
                      <a:pt x="44" y="34"/>
                      <a:pt x="44" y="33"/>
                      <a:pt x="44" y="32"/>
                    </a:cubicBezTo>
                    <a:cubicBezTo>
                      <a:pt x="44" y="31"/>
                      <a:pt x="45" y="29"/>
                      <a:pt x="45" y="28"/>
                    </a:cubicBezTo>
                    <a:cubicBezTo>
                      <a:pt x="44" y="23"/>
                      <a:pt x="43" y="19"/>
                      <a:pt x="43" y="19"/>
                    </a:cubicBezTo>
                    <a:cubicBezTo>
                      <a:pt x="43" y="19"/>
                      <a:pt x="55" y="19"/>
                      <a:pt x="58" y="22"/>
                    </a:cubicBezTo>
                    <a:cubicBezTo>
                      <a:pt x="61" y="25"/>
                      <a:pt x="67" y="32"/>
                      <a:pt x="68" y="34"/>
                    </a:cubicBezTo>
                    <a:cubicBezTo>
                      <a:pt x="69" y="36"/>
                      <a:pt x="71" y="37"/>
                      <a:pt x="73" y="38"/>
                    </a:cubicBezTo>
                    <a:cubicBezTo>
                      <a:pt x="74" y="39"/>
                      <a:pt x="74" y="41"/>
                      <a:pt x="75" y="41"/>
                    </a:cubicBezTo>
                    <a:cubicBezTo>
                      <a:pt x="76" y="41"/>
                      <a:pt x="75" y="39"/>
                      <a:pt x="75" y="38"/>
                    </a:cubicBezTo>
                    <a:cubicBezTo>
                      <a:pt x="75" y="35"/>
                      <a:pt x="74" y="27"/>
                      <a:pt x="74" y="27"/>
                    </a:cubicBezTo>
                    <a:cubicBezTo>
                      <a:pt x="74" y="27"/>
                      <a:pt x="78" y="28"/>
                      <a:pt x="81" y="29"/>
                    </a:cubicBezTo>
                    <a:cubicBezTo>
                      <a:pt x="83" y="29"/>
                      <a:pt x="86" y="31"/>
                      <a:pt x="87" y="31"/>
                    </a:cubicBezTo>
                    <a:cubicBezTo>
                      <a:pt x="88" y="31"/>
                      <a:pt x="88" y="32"/>
                      <a:pt x="89" y="32"/>
                    </a:cubicBezTo>
                    <a:cubicBezTo>
                      <a:pt x="90" y="31"/>
                      <a:pt x="90" y="31"/>
                      <a:pt x="89" y="29"/>
                    </a:cubicBezTo>
                    <a:cubicBezTo>
                      <a:pt x="88" y="28"/>
                      <a:pt x="88" y="25"/>
                      <a:pt x="87" y="25"/>
                    </a:cubicBezTo>
                    <a:cubicBezTo>
                      <a:pt x="87" y="24"/>
                      <a:pt x="90" y="24"/>
                      <a:pt x="92" y="25"/>
                    </a:cubicBezTo>
                    <a:cubicBezTo>
                      <a:pt x="93" y="26"/>
                      <a:pt x="94" y="27"/>
                      <a:pt x="95" y="25"/>
                    </a:cubicBezTo>
                    <a:cubicBezTo>
                      <a:pt x="95" y="25"/>
                      <a:pt x="94" y="24"/>
                      <a:pt x="93" y="23"/>
                    </a:cubicBezTo>
                    <a:cubicBezTo>
                      <a:pt x="91" y="20"/>
                      <a:pt x="87" y="16"/>
                      <a:pt x="85" y="15"/>
                    </a:cubicBezTo>
                    <a:cubicBezTo>
                      <a:pt x="82" y="13"/>
                      <a:pt x="78" y="11"/>
                      <a:pt x="72" y="10"/>
                    </a:cubicBezTo>
                    <a:cubicBezTo>
                      <a:pt x="57" y="10"/>
                      <a:pt x="42" y="9"/>
                      <a:pt x="35" y="9"/>
                    </a:cubicBezTo>
                    <a:cubicBezTo>
                      <a:pt x="29" y="9"/>
                      <a:pt x="14" y="5"/>
                      <a:pt x="0" y="0"/>
                    </a:cubicBezTo>
                    <a:close/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4" name="Freeform 71"/>
              <p:cNvSpPr/>
              <p:nvPr/>
            </p:nvSpPr>
            <p:spPr>
              <a:xfrm>
                <a:off x="2314" y="2217"/>
                <a:ext cx="1116" cy="390"/>
              </a:xfrm>
              <a:custGeom>
                <a:avLst/>
                <a:gdLst/>
                <a:ahLst/>
                <a:cxnLst>
                  <a:cxn ang="0">
                    <a:pos x="0" y="5393"/>
                  </a:cxn>
                  <a:cxn ang="0">
                    <a:pos x="1021" y="4116"/>
                  </a:cxn>
                  <a:cxn ang="0">
                    <a:pos x="1301" y="3868"/>
                  </a:cxn>
                  <a:cxn ang="0">
                    <a:pos x="2472" y="3718"/>
                  </a:cxn>
                  <a:cxn ang="0">
                    <a:pos x="4984" y="4723"/>
                  </a:cxn>
                  <a:cxn ang="0">
                    <a:pos x="7677" y="4632"/>
                  </a:cxn>
                  <a:cxn ang="0">
                    <a:pos x="10074" y="4538"/>
                  </a:cxn>
                  <a:cxn ang="0">
                    <a:pos x="11253" y="5700"/>
                  </a:cxn>
                  <a:cxn ang="0">
                    <a:pos x="12421" y="6729"/>
                  </a:cxn>
                  <a:cxn ang="0">
                    <a:pos x="12736" y="7220"/>
                  </a:cxn>
                  <a:cxn ang="0">
                    <a:pos x="12942" y="7434"/>
                  </a:cxn>
                  <a:cxn ang="0">
                    <a:pos x="12892" y="7186"/>
                  </a:cxn>
                  <a:cxn ang="0">
                    <a:pos x="12862" y="6673"/>
                  </a:cxn>
                  <a:cxn ang="0">
                    <a:pos x="13254" y="6878"/>
                  </a:cxn>
                  <a:cxn ang="0">
                    <a:pos x="13487" y="6977"/>
                  </a:cxn>
                  <a:cxn ang="0">
                    <a:pos x="13567" y="7071"/>
                  </a:cxn>
                  <a:cxn ang="0">
                    <a:pos x="13487" y="6614"/>
                  </a:cxn>
                  <a:cxn ang="0">
                    <a:pos x="13567" y="6673"/>
                  </a:cxn>
                  <a:cxn ang="0">
                    <a:pos x="13675" y="6729"/>
                  </a:cxn>
                  <a:cxn ang="0">
                    <a:pos x="13600" y="6422"/>
                  </a:cxn>
                  <a:cxn ang="0">
                    <a:pos x="13487" y="6058"/>
                  </a:cxn>
                  <a:cxn ang="0">
                    <a:pos x="13174" y="5909"/>
                  </a:cxn>
                  <a:cxn ang="0">
                    <a:pos x="13099" y="5759"/>
                  </a:cxn>
                  <a:cxn ang="0">
                    <a:pos x="12546" y="5700"/>
                  </a:cxn>
                  <a:cxn ang="0">
                    <a:pos x="11921" y="4936"/>
                  </a:cxn>
                  <a:cxn ang="0">
                    <a:pos x="12033" y="4573"/>
                  </a:cxn>
                  <a:cxn ang="0">
                    <a:pos x="12471" y="4880"/>
                  </a:cxn>
                  <a:cxn ang="0">
                    <a:pos x="12786" y="5302"/>
                  </a:cxn>
                  <a:cxn ang="0">
                    <a:pos x="12892" y="5452"/>
                  </a:cxn>
                  <a:cxn ang="0">
                    <a:pos x="12892" y="5145"/>
                  </a:cxn>
                  <a:cxn ang="0">
                    <a:pos x="13099" y="5145"/>
                  </a:cxn>
                  <a:cxn ang="0">
                    <a:pos x="13329" y="5302"/>
                  </a:cxn>
                  <a:cxn ang="0">
                    <a:pos x="13412" y="5452"/>
                  </a:cxn>
                  <a:cxn ang="0">
                    <a:pos x="13362" y="5030"/>
                  </a:cxn>
                  <a:cxn ang="0">
                    <a:pos x="12736" y="4424"/>
                  </a:cxn>
                  <a:cxn ang="0">
                    <a:pos x="12786" y="4026"/>
                  </a:cxn>
                  <a:cxn ang="0">
                    <a:pos x="12704" y="3967"/>
                  </a:cxn>
                  <a:cxn ang="0">
                    <a:pos x="12266" y="3718"/>
                  </a:cxn>
                  <a:cxn ang="0">
                    <a:pos x="12033" y="3318"/>
                  </a:cxn>
                  <a:cxn ang="0">
                    <a:pos x="12108" y="3010"/>
                  </a:cxn>
                  <a:cxn ang="0">
                    <a:pos x="12033" y="3104"/>
                  </a:cxn>
                  <a:cxn ang="0">
                    <a:pos x="13517" y="2097"/>
                  </a:cxn>
                  <a:cxn ang="0">
                    <a:pos x="14225" y="2097"/>
                  </a:cxn>
                  <a:cxn ang="0">
                    <a:pos x="14508" y="2097"/>
                  </a:cxn>
                  <a:cxn ang="0">
                    <a:pos x="15008" y="2097"/>
                  </a:cxn>
                  <a:cxn ang="0">
                    <a:pos x="15717" y="2498"/>
                  </a:cxn>
                  <a:cxn ang="0">
                    <a:pos x="16467" y="2348"/>
                  </a:cxn>
                  <a:cxn ang="0">
                    <a:pos x="17093" y="914"/>
                  </a:cxn>
                  <a:cxn ang="0">
                    <a:pos x="16185" y="1528"/>
                  </a:cxn>
                  <a:cxn ang="0">
                    <a:pos x="15559" y="1277"/>
                  </a:cxn>
                  <a:cxn ang="0">
                    <a:pos x="14933" y="857"/>
                  </a:cxn>
                  <a:cxn ang="0">
                    <a:pos x="14038" y="857"/>
                  </a:cxn>
                  <a:cxn ang="0">
                    <a:pos x="13412" y="820"/>
                  </a:cxn>
                  <a:cxn ang="0">
                    <a:pos x="12786" y="705"/>
                  </a:cxn>
                  <a:cxn ang="0">
                    <a:pos x="12191" y="248"/>
                  </a:cxn>
                  <a:cxn ang="0">
                    <a:pos x="10857" y="1277"/>
                  </a:cxn>
                  <a:cxn ang="0">
                    <a:pos x="9761" y="2097"/>
                  </a:cxn>
                  <a:cxn ang="0">
                    <a:pos x="8428" y="2898"/>
                  </a:cxn>
                  <a:cxn ang="0">
                    <a:pos x="4827" y="3203"/>
                  </a:cxn>
                  <a:cxn ang="0">
                    <a:pos x="2117" y="2591"/>
                  </a:cxn>
                  <a:cxn ang="0">
                    <a:pos x="988" y="3660"/>
                  </a:cxn>
                  <a:cxn ang="0">
                    <a:pos x="0" y="5393"/>
                  </a:cxn>
                </a:cxnLst>
                <a:pathLst>
                  <a:path w="446" h="146">
                    <a:moveTo>
                      <a:pt x="0" y="106"/>
                    </a:moveTo>
                    <a:cubicBezTo>
                      <a:pt x="4" y="97"/>
                      <a:pt x="17" y="85"/>
                      <a:pt x="26" y="81"/>
                    </a:cubicBezTo>
                    <a:cubicBezTo>
                      <a:pt x="29" y="79"/>
                      <a:pt x="32" y="76"/>
                      <a:pt x="33" y="76"/>
                    </a:cubicBezTo>
                    <a:cubicBezTo>
                      <a:pt x="42" y="69"/>
                      <a:pt x="52" y="68"/>
                      <a:pt x="63" y="73"/>
                    </a:cubicBezTo>
                    <a:cubicBezTo>
                      <a:pt x="81" y="82"/>
                      <a:pt x="116" y="93"/>
                      <a:pt x="127" y="93"/>
                    </a:cubicBezTo>
                    <a:cubicBezTo>
                      <a:pt x="139" y="93"/>
                      <a:pt x="174" y="95"/>
                      <a:pt x="196" y="91"/>
                    </a:cubicBezTo>
                    <a:cubicBezTo>
                      <a:pt x="219" y="86"/>
                      <a:pt x="237" y="73"/>
                      <a:pt x="257" y="89"/>
                    </a:cubicBezTo>
                    <a:cubicBezTo>
                      <a:pt x="265" y="96"/>
                      <a:pt x="278" y="106"/>
                      <a:pt x="287" y="112"/>
                    </a:cubicBezTo>
                    <a:cubicBezTo>
                      <a:pt x="295" y="118"/>
                      <a:pt x="314" y="128"/>
                      <a:pt x="317" y="132"/>
                    </a:cubicBezTo>
                    <a:cubicBezTo>
                      <a:pt x="319" y="136"/>
                      <a:pt x="324" y="140"/>
                      <a:pt x="325" y="142"/>
                    </a:cubicBezTo>
                    <a:cubicBezTo>
                      <a:pt x="327" y="143"/>
                      <a:pt x="327" y="146"/>
                      <a:pt x="330" y="146"/>
                    </a:cubicBezTo>
                    <a:cubicBezTo>
                      <a:pt x="332" y="145"/>
                      <a:pt x="329" y="143"/>
                      <a:pt x="329" y="141"/>
                    </a:cubicBezTo>
                    <a:cubicBezTo>
                      <a:pt x="329" y="139"/>
                      <a:pt x="330" y="134"/>
                      <a:pt x="328" y="131"/>
                    </a:cubicBezTo>
                    <a:cubicBezTo>
                      <a:pt x="330" y="132"/>
                      <a:pt x="335" y="135"/>
                      <a:pt x="338" y="135"/>
                    </a:cubicBezTo>
                    <a:cubicBezTo>
                      <a:pt x="341" y="136"/>
                      <a:pt x="342" y="136"/>
                      <a:pt x="344" y="137"/>
                    </a:cubicBezTo>
                    <a:cubicBezTo>
                      <a:pt x="345" y="138"/>
                      <a:pt x="345" y="140"/>
                      <a:pt x="346" y="139"/>
                    </a:cubicBezTo>
                    <a:cubicBezTo>
                      <a:pt x="348" y="137"/>
                      <a:pt x="347" y="135"/>
                      <a:pt x="344" y="130"/>
                    </a:cubicBezTo>
                    <a:cubicBezTo>
                      <a:pt x="344" y="130"/>
                      <a:pt x="345" y="130"/>
                      <a:pt x="346" y="131"/>
                    </a:cubicBezTo>
                    <a:cubicBezTo>
                      <a:pt x="347" y="133"/>
                      <a:pt x="349" y="132"/>
                      <a:pt x="349" y="132"/>
                    </a:cubicBezTo>
                    <a:cubicBezTo>
                      <a:pt x="349" y="132"/>
                      <a:pt x="348" y="129"/>
                      <a:pt x="347" y="126"/>
                    </a:cubicBezTo>
                    <a:cubicBezTo>
                      <a:pt x="346" y="123"/>
                      <a:pt x="345" y="121"/>
                      <a:pt x="344" y="119"/>
                    </a:cubicBezTo>
                    <a:cubicBezTo>
                      <a:pt x="342" y="117"/>
                      <a:pt x="336" y="116"/>
                      <a:pt x="336" y="116"/>
                    </a:cubicBezTo>
                    <a:cubicBezTo>
                      <a:pt x="336" y="116"/>
                      <a:pt x="335" y="115"/>
                      <a:pt x="334" y="113"/>
                    </a:cubicBezTo>
                    <a:cubicBezTo>
                      <a:pt x="332" y="112"/>
                      <a:pt x="321" y="113"/>
                      <a:pt x="320" y="112"/>
                    </a:cubicBezTo>
                    <a:cubicBezTo>
                      <a:pt x="319" y="112"/>
                      <a:pt x="305" y="100"/>
                      <a:pt x="304" y="97"/>
                    </a:cubicBezTo>
                    <a:cubicBezTo>
                      <a:pt x="302" y="95"/>
                      <a:pt x="305" y="89"/>
                      <a:pt x="307" y="90"/>
                    </a:cubicBezTo>
                    <a:cubicBezTo>
                      <a:pt x="309" y="91"/>
                      <a:pt x="315" y="92"/>
                      <a:pt x="318" y="96"/>
                    </a:cubicBezTo>
                    <a:cubicBezTo>
                      <a:pt x="320" y="98"/>
                      <a:pt x="324" y="102"/>
                      <a:pt x="326" y="104"/>
                    </a:cubicBezTo>
                    <a:cubicBezTo>
                      <a:pt x="329" y="106"/>
                      <a:pt x="327" y="107"/>
                      <a:pt x="329" y="107"/>
                    </a:cubicBezTo>
                    <a:cubicBezTo>
                      <a:pt x="330" y="106"/>
                      <a:pt x="331" y="104"/>
                      <a:pt x="329" y="101"/>
                    </a:cubicBezTo>
                    <a:cubicBezTo>
                      <a:pt x="329" y="101"/>
                      <a:pt x="331" y="101"/>
                      <a:pt x="334" y="101"/>
                    </a:cubicBezTo>
                    <a:cubicBezTo>
                      <a:pt x="336" y="102"/>
                      <a:pt x="339" y="102"/>
                      <a:pt x="340" y="104"/>
                    </a:cubicBezTo>
                    <a:cubicBezTo>
                      <a:pt x="341" y="106"/>
                      <a:pt x="341" y="108"/>
                      <a:pt x="342" y="107"/>
                    </a:cubicBezTo>
                    <a:cubicBezTo>
                      <a:pt x="343" y="106"/>
                      <a:pt x="343" y="103"/>
                      <a:pt x="341" y="99"/>
                    </a:cubicBezTo>
                    <a:cubicBezTo>
                      <a:pt x="335" y="96"/>
                      <a:pt x="327" y="92"/>
                      <a:pt x="325" y="87"/>
                    </a:cubicBezTo>
                    <a:cubicBezTo>
                      <a:pt x="323" y="85"/>
                      <a:pt x="325" y="82"/>
                      <a:pt x="326" y="79"/>
                    </a:cubicBezTo>
                    <a:cubicBezTo>
                      <a:pt x="325" y="78"/>
                      <a:pt x="324" y="78"/>
                      <a:pt x="324" y="78"/>
                    </a:cubicBezTo>
                    <a:cubicBezTo>
                      <a:pt x="321" y="76"/>
                      <a:pt x="318" y="74"/>
                      <a:pt x="313" y="73"/>
                    </a:cubicBezTo>
                    <a:cubicBezTo>
                      <a:pt x="308" y="71"/>
                      <a:pt x="310" y="71"/>
                      <a:pt x="307" y="65"/>
                    </a:cubicBezTo>
                    <a:cubicBezTo>
                      <a:pt x="307" y="63"/>
                      <a:pt x="307" y="61"/>
                      <a:pt x="309" y="59"/>
                    </a:cubicBezTo>
                    <a:cubicBezTo>
                      <a:pt x="307" y="61"/>
                      <a:pt x="307" y="61"/>
                      <a:pt x="307" y="61"/>
                    </a:cubicBezTo>
                    <a:cubicBezTo>
                      <a:pt x="310" y="54"/>
                      <a:pt x="322" y="40"/>
                      <a:pt x="345" y="41"/>
                    </a:cubicBezTo>
                    <a:cubicBezTo>
                      <a:pt x="345" y="41"/>
                      <a:pt x="351" y="43"/>
                      <a:pt x="363" y="41"/>
                    </a:cubicBezTo>
                    <a:cubicBezTo>
                      <a:pt x="365" y="41"/>
                      <a:pt x="368" y="41"/>
                      <a:pt x="370" y="41"/>
                    </a:cubicBezTo>
                    <a:cubicBezTo>
                      <a:pt x="375" y="40"/>
                      <a:pt x="379" y="39"/>
                      <a:pt x="383" y="41"/>
                    </a:cubicBezTo>
                    <a:cubicBezTo>
                      <a:pt x="390" y="44"/>
                      <a:pt x="393" y="48"/>
                      <a:pt x="401" y="49"/>
                    </a:cubicBezTo>
                    <a:cubicBezTo>
                      <a:pt x="408" y="49"/>
                      <a:pt x="414" y="48"/>
                      <a:pt x="420" y="46"/>
                    </a:cubicBezTo>
                    <a:cubicBezTo>
                      <a:pt x="433" y="41"/>
                      <a:pt x="446" y="33"/>
                      <a:pt x="436" y="18"/>
                    </a:cubicBezTo>
                    <a:cubicBezTo>
                      <a:pt x="438" y="34"/>
                      <a:pt x="425" y="33"/>
                      <a:pt x="413" y="30"/>
                    </a:cubicBezTo>
                    <a:cubicBezTo>
                      <a:pt x="408" y="29"/>
                      <a:pt x="402" y="27"/>
                      <a:pt x="397" y="25"/>
                    </a:cubicBezTo>
                    <a:cubicBezTo>
                      <a:pt x="390" y="23"/>
                      <a:pt x="389" y="17"/>
                      <a:pt x="381" y="17"/>
                    </a:cubicBezTo>
                    <a:cubicBezTo>
                      <a:pt x="373" y="16"/>
                      <a:pt x="366" y="17"/>
                      <a:pt x="358" y="17"/>
                    </a:cubicBezTo>
                    <a:cubicBezTo>
                      <a:pt x="352" y="16"/>
                      <a:pt x="347" y="16"/>
                      <a:pt x="342" y="16"/>
                    </a:cubicBezTo>
                    <a:cubicBezTo>
                      <a:pt x="337" y="16"/>
                      <a:pt x="331" y="15"/>
                      <a:pt x="326" y="14"/>
                    </a:cubicBezTo>
                    <a:cubicBezTo>
                      <a:pt x="320" y="13"/>
                      <a:pt x="317" y="6"/>
                      <a:pt x="311" y="5"/>
                    </a:cubicBezTo>
                    <a:cubicBezTo>
                      <a:pt x="293" y="0"/>
                      <a:pt x="290" y="20"/>
                      <a:pt x="277" y="25"/>
                    </a:cubicBezTo>
                    <a:cubicBezTo>
                      <a:pt x="267" y="30"/>
                      <a:pt x="258" y="34"/>
                      <a:pt x="249" y="41"/>
                    </a:cubicBezTo>
                    <a:cubicBezTo>
                      <a:pt x="239" y="48"/>
                      <a:pt x="227" y="54"/>
                      <a:pt x="215" y="57"/>
                    </a:cubicBezTo>
                    <a:cubicBezTo>
                      <a:pt x="186" y="66"/>
                      <a:pt x="153" y="66"/>
                      <a:pt x="123" y="63"/>
                    </a:cubicBezTo>
                    <a:cubicBezTo>
                      <a:pt x="100" y="60"/>
                      <a:pt x="77" y="44"/>
                      <a:pt x="54" y="51"/>
                    </a:cubicBezTo>
                    <a:cubicBezTo>
                      <a:pt x="42" y="54"/>
                      <a:pt x="35" y="64"/>
                      <a:pt x="25" y="72"/>
                    </a:cubicBezTo>
                    <a:cubicBezTo>
                      <a:pt x="15" y="80"/>
                      <a:pt x="1" y="92"/>
                      <a:pt x="0" y="106"/>
                    </a:cubicBezTo>
                    <a:close/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5" name="Freeform 72"/>
              <p:cNvSpPr/>
              <p:nvPr/>
            </p:nvSpPr>
            <p:spPr>
              <a:xfrm>
                <a:off x="2822" y="2092"/>
                <a:ext cx="355" cy="291"/>
              </a:xfrm>
              <a:custGeom>
                <a:avLst/>
                <a:gdLst/>
                <a:ahLst/>
                <a:cxnLst>
                  <a:cxn ang="0">
                    <a:pos x="0" y="5537"/>
                  </a:cxn>
                  <a:cxn ang="0">
                    <a:pos x="2500" y="3043"/>
                  </a:cxn>
                  <a:cxn ang="0">
                    <a:pos x="2863" y="1004"/>
                  </a:cxn>
                  <a:cxn ang="0">
                    <a:pos x="3208" y="93"/>
                  </a:cxn>
                  <a:cxn ang="0">
                    <a:pos x="3875" y="550"/>
                  </a:cxn>
                  <a:cxn ang="0">
                    <a:pos x="4270" y="1276"/>
                  </a:cxn>
                  <a:cxn ang="0">
                    <a:pos x="4500" y="1733"/>
                  </a:cxn>
                  <a:cxn ang="0">
                    <a:pos x="4533" y="2280"/>
                  </a:cxn>
                  <a:cxn ang="0">
                    <a:pos x="5158" y="3158"/>
                  </a:cxn>
                  <a:cxn ang="0">
                    <a:pos x="4613" y="3863"/>
                  </a:cxn>
                  <a:cxn ang="0">
                    <a:pos x="3095" y="4261"/>
                  </a:cxn>
                  <a:cxn ang="0">
                    <a:pos x="2083" y="4776"/>
                  </a:cxn>
                </a:cxnLst>
                <a:pathLst>
                  <a:path w="142" h="109">
                    <a:moveTo>
                      <a:pt x="0" y="109"/>
                    </a:moveTo>
                    <a:cubicBezTo>
                      <a:pt x="26" y="101"/>
                      <a:pt x="49" y="83"/>
                      <a:pt x="64" y="60"/>
                    </a:cubicBezTo>
                    <a:cubicBezTo>
                      <a:pt x="72" y="48"/>
                      <a:pt x="78" y="35"/>
                      <a:pt x="73" y="20"/>
                    </a:cubicBezTo>
                    <a:cubicBezTo>
                      <a:pt x="69" y="11"/>
                      <a:pt x="76" y="0"/>
                      <a:pt x="82" y="2"/>
                    </a:cubicBezTo>
                    <a:cubicBezTo>
                      <a:pt x="88" y="4"/>
                      <a:pt x="94" y="7"/>
                      <a:pt x="99" y="11"/>
                    </a:cubicBezTo>
                    <a:cubicBezTo>
                      <a:pt x="104" y="15"/>
                      <a:pt x="105" y="20"/>
                      <a:pt x="109" y="25"/>
                    </a:cubicBezTo>
                    <a:cubicBezTo>
                      <a:pt x="113" y="28"/>
                      <a:pt x="115" y="28"/>
                      <a:pt x="115" y="34"/>
                    </a:cubicBezTo>
                    <a:cubicBezTo>
                      <a:pt x="116" y="38"/>
                      <a:pt x="114" y="40"/>
                      <a:pt x="116" y="45"/>
                    </a:cubicBezTo>
                    <a:cubicBezTo>
                      <a:pt x="119" y="52"/>
                      <a:pt x="126" y="57"/>
                      <a:pt x="132" y="62"/>
                    </a:cubicBezTo>
                    <a:cubicBezTo>
                      <a:pt x="142" y="71"/>
                      <a:pt x="127" y="74"/>
                      <a:pt x="118" y="76"/>
                    </a:cubicBezTo>
                    <a:cubicBezTo>
                      <a:pt x="105" y="78"/>
                      <a:pt x="92" y="80"/>
                      <a:pt x="79" y="84"/>
                    </a:cubicBezTo>
                    <a:cubicBezTo>
                      <a:pt x="73" y="86"/>
                      <a:pt x="60" y="95"/>
                      <a:pt x="53" y="94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6" name="Freeform 73"/>
              <p:cNvSpPr/>
              <p:nvPr/>
            </p:nvSpPr>
            <p:spPr>
              <a:xfrm>
                <a:off x="3127" y="1775"/>
                <a:ext cx="110" cy="154"/>
              </a:xfrm>
              <a:custGeom>
                <a:avLst/>
                <a:gdLst/>
                <a:ahLst/>
                <a:cxnLst>
                  <a:cxn ang="0">
                    <a:pos x="158" y="149"/>
                  </a:cxn>
                  <a:cxn ang="0">
                    <a:pos x="1250" y="1346"/>
                  </a:cxn>
                  <a:cxn ang="0">
                    <a:pos x="1488" y="2884"/>
                  </a:cxn>
                  <a:cxn ang="0">
                    <a:pos x="938" y="1649"/>
                  </a:cxn>
                  <a:cxn ang="0">
                    <a:pos x="0" y="0"/>
                  </a:cxn>
                </a:cxnLst>
                <a:pathLst>
                  <a:path w="44" h="58">
                    <a:moveTo>
                      <a:pt x="4" y="3"/>
                    </a:moveTo>
                    <a:cubicBezTo>
                      <a:pt x="14" y="1"/>
                      <a:pt x="27" y="20"/>
                      <a:pt x="32" y="27"/>
                    </a:cubicBezTo>
                    <a:cubicBezTo>
                      <a:pt x="37" y="35"/>
                      <a:pt x="44" y="49"/>
                      <a:pt x="38" y="58"/>
                    </a:cubicBezTo>
                    <a:cubicBezTo>
                      <a:pt x="28" y="56"/>
                      <a:pt x="28" y="40"/>
                      <a:pt x="24" y="33"/>
                    </a:cubicBezTo>
                    <a:cubicBezTo>
                      <a:pt x="18" y="22"/>
                      <a:pt x="10" y="7"/>
                      <a:pt x="0" y="0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7" name="Freeform 74"/>
              <p:cNvSpPr/>
              <p:nvPr/>
            </p:nvSpPr>
            <p:spPr>
              <a:xfrm>
                <a:off x="3065" y="1993"/>
                <a:ext cx="40" cy="88"/>
              </a:xfrm>
              <a:custGeom>
                <a:avLst/>
                <a:gdLst/>
                <a:ahLst/>
                <a:cxnLst>
                  <a:cxn ang="0">
                    <a:pos x="550" y="205"/>
                  </a:cxn>
                  <a:cxn ang="0">
                    <a:pos x="238" y="909"/>
                  </a:cxn>
                  <a:cxn ang="0">
                    <a:pos x="395" y="1421"/>
                  </a:cxn>
                  <a:cxn ang="0">
                    <a:pos x="395" y="853"/>
                  </a:cxn>
                  <a:cxn ang="0">
                    <a:pos x="625" y="456"/>
                  </a:cxn>
                </a:cxnLst>
                <a:pathLst>
                  <a:path w="16" h="33">
                    <a:moveTo>
                      <a:pt x="14" y="4"/>
                    </a:moveTo>
                    <a:cubicBezTo>
                      <a:pt x="0" y="0"/>
                      <a:pt x="6" y="10"/>
                      <a:pt x="6" y="18"/>
                    </a:cubicBezTo>
                    <a:cubicBezTo>
                      <a:pt x="6" y="20"/>
                      <a:pt x="2" y="33"/>
                      <a:pt x="10" y="28"/>
                    </a:cubicBezTo>
                    <a:cubicBezTo>
                      <a:pt x="12" y="26"/>
                      <a:pt x="9" y="20"/>
                      <a:pt x="10" y="17"/>
                    </a:cubicBezTo>
                    <a:cubicBezTo>
                      <a:pt x="11" y="13"/>
                      <a:pt x="13" y="12"/>
                      <a:pt x="16" y="9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8" name="Freeform 75"/>
              <p:cNvSpPr/>
              <p:nvPr/>
            </p:nvSpPr>
            <p:spPr>
              <a:xfrm>
                <a:off x="2962" y="1911"/>
                <a:ext cx="143" cy="85"/>
              </a:xfrm>
              <a:custGeom>
                <a:avLst/>
                <a:gdLst/>
                <a:ahLst/>
                <a:cxnLst>
                  <a:cxn ang="0">
                    <a:pos x="2102" y="1052"/>
                  </a:cxn>
                  <a:cxn ang="0">
                    <a:pos x="993" y="56"/>
                  </a:cxn>
                  <a:cxn ang="0">
                    <a:pos x="0" y="805"/>
                  </a:cxn>
                  <a:cxn ang="0">
                    <a:pos x="868" y="396"/>
                  </a:cxn>
                  <a:cxn ang="0">
                    <a:pos x="1581" y="691"/>
                  </a:cxn>
                  <a:cxn ang="0">
                    <a:pos x="1864" y="1235"/>
                  </a:cxn>
                  <a:cxn ang="0">
                    <a:pos x="2260" y="1389"/>
                  </a:cxn>
                  <a:cxn ang="0">
                    <a:pos x="2178" y="1086"/>
                  </a:cxn>
                </a:cxnLst>
                <a:pathLst>
                  <a:path w="57" h="32">
                    <a:moveTo>
                      <a:pt x="53" y="21"/>
                    </a:moveTo>
                    <a:cubicBezTo>
                      <a:pt x="47" y="8"/>
                      <a:pt x="39" y="3"/>
                      <a:pt x="25" y="1"/>
                    </a:cubicBezTo>
                    <a:cubicBezTo>
                      <a:pt x="13" y="0"/>
                      <a:pt x="0" y="0"/>
                      <a:pt x="0" y="16"/>
                    </a:cubicBezTo>
                    <a:cubicBezTo>
                      <a:pt x="7" y="14"/>
                      <a:pt x="14" y="8"/>
                      <a:pt x="22" y="8"/>
                    </a:cubicBezTo>
                    <a:cubicBezTo>
                      <a:pt x="27" y="8"/>
                      <a:pt x="35" y="12"/>
                      <a:pt x="40" y="14"/>
                    </a:cubicBezTo>
                    <a:cubicBezTo>
                      <a:pt x="47" y="17"/>
                      <a:pt x="44" y="20"/>
                      <a:pt x="47" y="25"/>
                    </a:cubicBezTo>
                    <a:cubicBezTo>
                      <a:pt x="49" y="32"/>
                      <a:pt x="51" y="27"/>
                      <a:pt x="57" y="28"/>
                    </a:cubicBezTo>
                    <a:cubicBezTo>
                      <a:pt x="56" y="26"/>
                      <a:pt x="56" y="24"/>
                      <a:pt x="55" y="22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59" name="Freeform 76"/>
              <p:cNvSpPr/>
              <p:nvPr/>
            </p:nvSpPr>
            <p:spPr>
              <a:xfrm>
                <a:off x="3115" y="2441"/>
                <a:ext cx="42" cy="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410" y="280"/>
                  </a:cxn>
                  <a:cxn ang="0">
                    <a:pos x="635" y="760"/>
                  </a:cxn>
                  <a:cxn ang="0">
                    <a:pos x="183" y="537"/>
                  </a:cxn>
                </a:cxnLst>
                <a:pathLst>
                  <a:path w="17" h="14">
                    <a:moveTo>
                      <a:pt x="0" y="0"/>
                    </a:moveTo>
                    <a:cubicBezTo>
                      <a:pt x="6" y="2"/>
                      <a:pt x="6" y="0"/>
                      <a:pt x="11" y="5"/>
                    </a:cubicBezTo>
                    <a:cubicBezTo>
                      <a:pt x="13" y="7"/>
                      <a:pt x="17" y="10"/>
                      <a:pt x="17" y="14"/>
                    </a:cubicBezTo>
                    <a:cubicBezTo>
                      <a:pt x="13" y="12"/>
                      <a:pt x="9" y="11"/>
                      <a:pt x="5" y="10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0" name="Freeform 77"/>
              <p:cNvSpPr/>
              <p:nvPr/>
            </p:nvSpPr>
            <p:spPr>
              <a:xfrm>
                <a:off x="3217" y="2143"/>
                <a:ext cx="68" cy="69"/>
              </a:xfrm>
              <a:custGeom>
                <a:avLst/>
                <a:gdLst/>
                <a:ahLst/>
                <a:cxnLst>
                  <a:cxn ang="0">
                    <a:pos x="1007" y="1085"/>
                  </a:cxn>
                  <a:cxn ang="0">
                    <a:pos x="685" y="295"/>
                  </a:cxn>
                  <a:cxn ang="0">
                    <a:pos x="50" y="507"/>
                  </a:cxn>
                  <a:cxn ang="0">
                    <a:pos x="368" y="1197"/>
                  </a:cxn>
                  <a:cxn ang="0">
                    <a:pos x="881" y="1085"/>
                  </a:cxn>
                  <a:cxn ang="0">
                    <a:pos x="1007" y="1085"/>
                  </a:cxn>
                </a:cxnLst>
                <a:pathLst>
                  <a:path w="27" h="26">
                    <a:moveTo>
                      <a:pt x="25" y="22"/>
                    </a:moveTo>
                    <a:cubicBezTo>
                      <a:pt x="23" y="20"/>
                      <a:pt x="27" y="11"/>
                      <a:pt x="17" y="6"/>
                    </a:cubicBezTo>
                    <a:cubicBezTo>
                      <a:pt x="8" y="0"/>
                      <a:pt x="1" y="10"/>
                      <a:pt x="1" y="10"/>
                    </a:cubicBezTo>
                    <a:cubicBezTo>
                      <a:pt x="0" y="17"/>
                      <a:pt x="4" y="22"/>
                      <a:pt x="9" y="24"/>
                    </a:cubicBezTo>
                    <a:cubicBezTo>
                      <a:pt x="13" y="26"/>
                      <a:pt x="22" y="22"/>
                      <a:pt x="22" y="22"/>
                    </a:cubicBezTo>
                    <a:lnTo>
                      <a:pt x="25" y="22"/>
                    </a:ln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1" name="Freeform 78"/>
              <p:cNvSpPr/>
              <p:nvPr/>
            </p:nvSpPr>
            <p:spPr>
              <a:xfrm>
                <a:off x="3222" y="2153"/>
                <a:ext cx="55" cy="56"/>
              </a:xfrm>
              <a:custGeom>
                <a:avLst/>
                <a:gdLst/>
                <a:ahLst/>
                <a:cxnLst>
                  <a:cxn ang="0">
                    <a:pos x="125" y="248"/>
                  </a:cxn>
                  <a:cxn ang="0">
                    <a:pos x="625" y="149"/>
                  </a:cxn>
                  <a:cxn ang="0">
                    <a:pos x="708" y="819"/>
                  </a:cxn>
                  <a:cxn ang="0">
                    <a:pos x="208" y="909"/>
                  </a:cxn>
                  <a:cxn ang="0">
                    <a:pos x="125" y="248"/>
                  </a:cxn>
                </a:cxnLst>
                <a:pathLst>
                  <a:path w="22" h="21">
                    <a:moveTo>
                      <a:pt x="3" y="5"/>
                    </a:moveTo>
                    <a:cubicBezTo>
                      <a:pt x="6" y="0"/>
                      <a:pt x="12" y="0"/>
                      <a:pt x="16" y="3"/>
                    </a:cubicBezTo>
                    <a:cubicBezTo>
                      <a:pt x="21" y="6"/>
                      <a:pt x="22" y="12"/>
                      <a:pt x="18" y="16"/>
                    </a:cubicBezTo>
                    <a:cubicBezTo>
                      <a:pt x="15" y="20"/>
                      <a:pt x="9" y="21"/>
                      <a:pt x="5" y="18"/>
                    </a:cubicBezTo>
                    <a:cubicBezTo>
                      <a:pt x="1" y="15"/>
                      <a:pt x="0" y="9"/>
                      <a:pt x="3" y="5"/>
                    </a:cubicBezTo>
                    <a:close/>
                  </a:path>
                </a:pathLst>
              </a:custGeom>
              <a:solidFill>
                <a:srgbClr val="949494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2" name="Freeform 79"/>
              <p:cNvSpPr/>
              <p:nvPr/>
            </p:nvSpPr>
            <p:spPr>
              <a:xfrm>
                <a:off x="3237" y="2169"/>
                <a:ext cx="23" cy="24"/>
              </a:xfrm>
              <a:custGeom>
                <a:avLst/>
                <a:gdLst/>
                <a:ahLst/>
                <a:cxnLst>
                  <a:cxn ang="0">
                    <a:pos x="84" y="93"/>
                  </a:cxn>
                  <a:cxn ang="0">
                    <a:pos x="302" y="56"/>
                  </a:cxn>
                  <a:cxn ang="0">
                    <a:pos x="332" y="363"/>
                  </a:cxn>
                  <a:cxn ang="0">
                    <a:pos x="130" y="363"/>
                  </a:cxn>
                  <a:cxn ang="0">
                    <a:pos x="84" y="93"/>
                  </a:cxn>
                </a:cxnLst>
                <a:pathLst>
                  <a:path w="9" h="9">
                    <a:moveTo>
                      <a:pt x="2" y="2"/>
                    </a:moveTo>
                    <a:cubicBezTo>
                      <a:pt x="3" y="0"/>
                      <a:pt x="5" y="0"/>
                      <a:pt x="7" y="1"/>
                    </a:cubicBezTo>
                    <a:cubicBezTo>
                      <a:pt x="9" y="3"/>
                      <a:pt x="9" y="5"/>
                      <a:pt x="8" y="7"/>
                    </a:cubicBezTo>
                    <a:cubicBezTo>
                      <a:pt x="7" y="8"/>
                      <a:pt x="4" y="9"/>
                      <a:pt x="3" y="7"/>
                    </a:cubicBezTo>
                    <a:cubicBezTo>
                      <a:pt x="1" y="6"/>
                      <a:pt x="0" y="4"/>
                      <a:pt x="2" y="2"/>
                    </a:cubicBezTo>
                    <a:close/>
                  </a:path>
                </a:pathLst>
              </a:custGeom>
              <a:solidFill>
                <a:srgbClr val="30303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3" name="Freeform 80"/>
              <p:cNvSpPr/>
              <p:nvPr/>
            </p:nvSpPr>
            <p:spPr>
              <a:xfrm>
                <a:off x="3327" y="2073"/>
                <a:ext cx="33" cy="75"/>
              </a:xfrm>
              <a:custGeom>
                <a:avLst/>
                <a:gdLst/>
                <a:ahLst/>
                <a:cxnLst>
                  <a:cxn ang="0">
                    <a:pos x="373" y="927"/>
                  </a:cxn>
                  <a:cxn ang="0">
                    <a:pos x="541" y="1441"/>
                  </a:cxn>
                  <a:cxn ang="0">
                    <a:pos x="490" y="1350"/>
                  </a:cxn>
                  <a:cxn ang="0">
                    <a:pos x="51" y="56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160" y="402"/>
                  </a:cxn>
                  <a:cxn ang="0">
                    <a:pos x="373" y="927"/>
                  </a:cxn>
                </a:cxnLst>
                <a:pathLst>
                  <a:path w="13" h="28">
                    <a:moveTo>
                      <a:pt x="9" y="18"/>
                    </a:moveTo>
                    <a:cubicBezTo>
                      <a:pt x="10" y="20"/>
                      <a:pt x="10" y="26"/>
                      <a:pt x="13" y="28"/>
                    </a:cubicBezTo>
                    <a:cubicBezTo>
                      <a:pt x="12" y="27"/>
                      <a:pt x="12" y="27"/>
                      <a:pt x="12" y="26"/>
                    </a:cubicBezTo>
                    <a:cubicBezTo>
                      <a:pt x="13" y="4"/>
                      <a:pt x="1" y="1"/>
                      <a:pt x="1" y="1"/>
                    </a:cubicBezTo>
                    <a:cubicBezTo>
                      <a:pt x="1" y="1"/>
                      <a:pt x="1" y="1"/>
                      <a:pt x="0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1" y="3"/>
                      <a:pt x="2" y="6"/>
                      <a:pt x="4" y="8"/>
                    </a:cubicBezTo>
                    <a:cubicBezTo>
                      <a:pt x="6" y="11"/>
                      <a:pt x="8" y="14"/>
                      <a:pt x="9" y="18"/>
                    </a:cubicBezTo>
                    <a:close/>
                  </a:path>
                </a:pathLst>
              </a:custGeom>
              <a:solidFill>
                <a:srgbClr val="949494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4" name="Freeform 81"/>
              <p:cNvSpPr/>
              <p:nvPr/>
            </p:nvSpPr>
            <p:spPr>
              <a:xfrm>
                <a:off x="2774" y="2335"/>
                <a:ext cx="208" cy="128"/>
              </a:xfrm>
              <a:custGeom>
                <a:avLst/>
                <a:gdLst/>
                <a:ahLst/>
                <a:cxnLst>
                  <a:cxn ang="0">
                    <a:pos x="0" y="2275"/>
                  </a:cxn>
                  <a:cxn ang="0">
                    <a:pos x="1418" y="1672"/>
                  </a:cxn>
                  <a:cxn ang="0">
                    <a:pos x="2015" y="1421"/>
                  </a:cxn>
                  <a:cxn ang="0">
                    <a:pos x="2727" y="605"/>
                  </a:cxn>
                  <a:cxn ang="0">
                    <a:pos x="3198" y="307"/>
                  </a:cxn>
                  <a:cxn ang="0">
                    <a:pos x="3040" y="1003"/>
                  </a:cxn>
                  <a:cxn ang="0">
                    <a:pos x="3040" y="1877"/>
                  </a:cxn>
                  <a:cxn ang="0">
                    <a:pos x="3273" y="2424"/>
                  </a:cxn>
                  <a:cxn ang="0">
                    <a:pos x="2802" y="1912"/>
                  </a:cxn>
                  <a:cxn ang="0">
                    <a:pos x="2331" y="1672"/>
                  </a:cxn>
                  <a:cxn ang="0">
                    <a:pos x="1100" y="1912"/>
                  </a:cxn>
                </a:cxnLst>
                <a:pathLst>
                  <a:path w="83" h="48">
                    <a:moveTo>
                      <a:pt x="0" y="45"/>
                    </a:moveTo>
                    <a:cubicBezTo>
                      <a:pt x="12" y="43"/>
                      <a:pt x="25" y="38"/>
                      <a:pt x="36" y="33"/>
                    </a:cubicBezTo>
                    <a:cubicBezTo>
                      <a:pt x="41" y="31"/>
                      <a:pt x="46" y="31"/>
                      <a:pt x="51" y="28"/>
                    </a:cubicBezTo>
                    <a:cubicBezTo>
                      <a:pt x="59" y="25"/>
                      <a:pt x="64" y="19"/>
                      <a:pt x="69" y="12"/>
                    </a:cubicBezTo>
                    <a:cubicBezTo>
                      <a:pt x="72" y="10"/>
                      <a:pt x="79" y="0"/>
                      <a:pt x="81" y="6"/>
                    </a:cubicBezTo>
                    <a:cubicBezTo>
                      <a:pt x="83" y="10"/>
                      <a:pt x="78" y="16"/>
                      <a:pt x="77" y="20"/>
                    </a:cubicBezTo>
                    <a:cubicBezTo>
                      <a:pt x="75" y="25"/>
                      <a:pt x="75" y="32"/>
                      <a:pt x="77" y="37"/>
                    </a:cubicBezTo>
                    <a:cubicBezTo>
                      <a:pt x="78" y="41"/>
                      <a:pt x="81" y="44"/>
                      <a:pt x="83" y="48"/>
                    </a:cubicBezTo>
                    <a:cubicBezTo>
                      <a:pt x="78" y="47"/>
                      <a:pt x="75" y="41"/>
                      <a:pt x="71" y="38"/>
                    </a:cubicBezTo>
                    <a:cubicBezTo>
                      <a:pt x="67" y="36"/>
                      <a:pt x="63" y="34"/>
                      <a:pt x="59" y="33"/>
                    </a:cubicBezTo>
                    <a:cubicBezTo>
                      <a:pt x="49" y="31"/>
                      <a:pt x="38" y="36"/>
                      <a:pt x="28" y="38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5" name="Freeform 82"/>
              <p:cNvSpPr/>
              <p:nvPr/>
            </p:nvSpPr>
            <p:spPr>
              <a:xfrm>
                <a:off x="3067" y="2401"/>
                <a:ext cx="38" cy="64"/>
              </a:xfrm>
              <a:custGeom>
                <a:avLst/>
                <a:gdLst/>
                <a:ahLst/>
                <a:cxnLst>
                  <a:cxn ang="0">
                    <a:pos x="213" y="56"/>
                  </a:cxn>
                  <a:cxn ang="0">
                    <a:pos x="0" y="1216"/>
                  </a:cxn>
                  <a:cxn ang="0">
                    <a:pos x="616" y="1059"/>
                  </a:cxn>
                  <a:cxn ang="0">
                    <a:pos x="327" y="0"/>
                  </a:cxn>
                </a:cxnLst>
                <a:pathLst>
                  <a:path w="15" h="24">
                    <a:moveTo>
                      <a:pt x="5" y="1"/>
                    </a:moveTo>
                    <a:cubicBezTo>
                      <a:pt x="0" y="5"/>
                      <a:pt x="0" y="18"/>
                      <a:pt x="0" y="24"/>
                    </a:cubicBezTo>
                    <a:cubicBezTo>
                      <a:pt x="5" y="17"/>
                      <a:pt x="9" y="19"/>
                      <a:pt x="15" y="21"/>
                    </a:cubicBezTo>
                    <a:cubicBezTo>
                      <a:pt x="12" y="17"/>
                      <a:pt x="5" y="6"/>
                      <a:pt x="8" y="0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6" name="Freeform 83"/>
              <p:cNvSpPr/>
              <p:nvPr/>
            </p:nvSpPr>
            <p:spPr>
              <a:xfrm>
                <a:off x="2607" y="2463"/>
                <a:ext cx="115" cy="32"/>
              </a:xfrm>
              <a:custGeom>
                <a:avLst/>
                <a:gdLst/>
                <a:ahLst/>
                <a:cxnLst>
                  <a:cxn ang="0">
                    <a:pos x="0" y="93"/>
                  </a:cxn>
                  <a:cxn ang="0">
                    <a:pos x="550" y="605"/>
                  </a:cxn>
                  <a:cxn ang="0">
                    <a:pos x="1800" y="0"/>
                  </a:cxn>
                  <a:cxn ang="0">
                    <a:pos x="313" y="93"/>
                  </a:cxn>
                </a:cxnLst>
                <a:pathLst>
                  <a:path w="46" h="12">
                    <a:moveTo>
                      <a:pt x="0" y="2"/>
                    </a:moveTo>
                    <a:cubicBezTo>
                      <a:pt x="6" y="4"/>
                      <a:pt x="10" y="8"/>
                      <a:pt x="14" y="12"/>
                    </a:cubicBezTo>
                    <a:cubicBezTo>
                      <a:pt x="19" y="2"/>
                      <a:pt x="41" y="12"/>
                      <a:pt x="46" y="0"/>
                    </a:cubicBezTo>
                    <a:cubicBezTo>
                      <a:pt x="34" y="5"/>
                      <a:pt x="19" y="0"/>
                      <a:pt x="8" y="2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7" name="Freeform 84"/>
              <p:cNvSpPr/>
              <p:nvPr/>
            </p:nvSpPr>
            <p:spPr>
              <a:xfrm>
                <a:off x="2414" y="2377"/>
                <a:ext cx="85" cy="35"/>
              </a:xfrm>
              <a:custGeom>
                <a:avLst/>
                <a:gdLst/>
                <a:ahLst/>
                <a:cxnLst>
                  <a:cxn ang="0">
                    <a:pos x="0" y="369"/>
                  </a:cxn>
                  <a:cxn ang="0">
                    <a:pos x="1333" y="681"/>
                  </a:cxn>
                  <a:cxn ang="0">
                    <a:pos x="750" y="59"/>
                  </a:cxn>
                  <a:cxn ang="0">
                    <a:pos x="83" y="312"/>
                  </a:cxn>
                </a:cxnLst>
                <a:pathLst>
                  <a:path w="34" h="13">
                    <a:moveTo>
                      <a:pt x="0" y="7"/>
                    </a:moveTo>
                    <a:cubicBezTo>
                      <a:pt x="12" y="1"/>
                      <a:pt x="22" y="10"/>
                      <a:pt x="34" y="13"/>
                    </a:cubicBezTo>
                    <a:cubicBezTo>
                      <a:pt x="27" y="11"/>
                      <a:pt x="25" y="3"/>
                      <a:pt x="19" y="1"/>
                    </a:cubicBezTo>
                    <a:cubicBezTo>
                      <a:pt x="14" y="0"/>
                      <a:pt x="6" y="2"/>
                      <a:pt x="2" y="6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8" name="Freeform 85"/>
              <p:cNvSpPr/>
              <p:nvPr/>
            </p:nvSpPr>
            <p:spPr>
              <a:xfrm>
                <a:off x="3300" y="2295"/>
                <a:ext cx="40" cy="42"/>
              </a:xfrm>
              <a:custGeom>
                <a:avLst/>
                <a:gdLst/>
                <a:ahLst/>
                <a:cxnLst>
                  <a:cxn ang="0">
                    <a:pos x="0" y="89"/>
                  </a:cxn>
                  <a:cxn ang="0">
                    <a:pos x="238" y="669"/>
                  </a:cxn>
                  <a:cxn ang="0">
                    <a:pos x="625" y="614"/>
                  </a:cxn>
                  <a:cxn ang="0">
                    <a:pos x="0" y="0"/>
                  </a:cxn>
                </a:cxnLst>
                <a:pathLst>
                  <a:path w="16" h="16">
                    <a:moveTo>
                      <a:pt x="0" y="2"/>
                    </a:moveTo>
                    <a:cubicBezTo>
                      <a:pt x="0" y="7"/>
                      <a:pt x="2" y="12"/>
                      <a:pt x="6" y="14"/>
                    </a:cubicBezTo>
                    <a:cubicBezTo>
                      <a:pt x="9" y="15"/>
                      <a:pt x="16" y="16"/>
                      <a:pt x="16" y="13"/>
                    </a:cubicBezTo>
                    <a:cubicBezTo>
                      <a:pt x="8" y="13"/>
                      <a:pt x="10" y="0"/>
                      <a:pt x="0" y="0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69" name="Freeform 86"/>
              <p:cNvSpPr/>
              <p:nvPr/>
            </p:nvSpPr>
            <p:spPr>
              <a:xfrm>
                <a:off x="3370" y="2300"/>
                <a:ext cx="40" cy="24"/>
              </a:xfrm>
              <a:custGeom>
                <a:avLst/>
                <a:gdLst/>
                <a:ahLst/>
                <a:cxnLst>
                  <a:cxn ang="0">
                    <a:pos x="0" y="149"/>
                  </a:cxn>
                  <a:cxn ang="0">
                    <a:pos x="313" y="397"/>
                  </a:cxn>
                  <a:cxn ang="0">
                    <a:pos x="625" y="0"/>
                  </a:cxn>
                  <a:cxn ang="0">
                    <a:pos x="313" y="149"/>
                  </a:cxn>
                  <a:cxn ang="0">
                    <a:pos x="0" y="149"/>
                  </a:cxn>
                </a:cxnLst>
                <a:pathLst>
                  <a:path w="16" h="9">
                    <a:moveTo>
                      <a:pt x="0" y="3"/>
                    </a:moveTo>
                    <a:cubicBezTo>
                      <a:pt x="5" y="4"/>
                      <a:pt x="1" y="9"/>
                      <a:pt x="8" y="8"/>
                    </a:cubicBezTo>
                    <a:cubicBezTo>
                      <a:pt x="12" y="7"/>
                      <a:pt x="14" y="4"/>
                      <a:pt x="16" y="0"/>
                    </a:cubicBezTo>
                    <a:cubicBezTo>
                      <a:pt x="13" y="1"/>
                      <a:pt x="12" y="3"/>
                      <a:pt x="8" y="3"/>
                    </a:cubicBezTo>
                    <a:cubicBezTo>
                      <a:pt x="5" y="3"/>
                      <a:pt x="2" y="2"/>
                      <a:pt x="0" y="3"/>
                    </a:cubicBezTo>
                  </a:path>
                </a:pathLst>
              </a:custGeom>
              <a:solidFill>
                <a:srgbClr val="878787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0" name="Freeform 87"/>
              <p:cNvSpPr/>
              <p:nvPr/>
            </p:nvSpPr>
            <p:spPr>
              <a:xfrm>
                <a:off x="3070" y="2004"/>
                <a:ext cx="27" cy="29"/>
              </a:xfrm>
              <a:custGeom>
                <a:avLst/>
                <a:gdLst/>
                <a:ahLst/>
                <a:cxnLst>
                  <a:cxn ang="0">
                    <a:pos x="253" y="0"/>
                  </a:cxn>
                  <a:cxn ang="0">
                    <a:pos x="223" y="527"/>
                  </a:cxn>
                  <a:cxn ang="0">
                    <a:pos x="398" y="55"/>
                  </a:cxn>
                </a:cxnLst>
                <a:pathLst>
                  <a:path w="11" h="11">
                    <a:moveTo>
                      <a:pt x="7" y="0"/>
                    </a:moveTo>
                    <a:cubicBezTo>
                      <a:pt x="0" y="1"/>
                      <a:pt x="3" y="7"/>
                      <a:pt x="6" y="11"/>
                    </a:cubicBezTo>
                    <a:cubicBezTo>
                      <a:pt x="7" y="7"/>
                      <a:pt x="8" y="4"/>
                      <a:pt x="11" y="1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1" name="Freeform 88"/>
              <p:cNvSpPr/>
              <p:nvPr/>
            </p:nvSpPr>
            <p:spPr>
              <a:xfrm>
                <a:off x="2970" y="1916"/>
                <a:ext cx="107" cy="32"/>
              </a:xfrm>
              <a:custGeom>
                <a:avLst/>
                <a:gdLst/>
                <a:ahLst/>
                <a:cxnLst>
                  <a:cxn ang="0">
                    <a:pos x="105" y="149"/>
                  </a:cxn>
                  <a:cxn ang="0">
                    <a:pos x="537" y="56"/>
                  </a:cxn>
                  <a:cxn ang="0">
                    <a:pos x="953" y="56"/>
                  </a:cxn>
                  <a:cxn ang="0">
                    <a:pos x="1647" y="605"/>
                  </a:cxn>
                  <a:cxn ang="0">
                    <a:pos x="799" y="149"/>
                  </a:cxn>
                  <a:cxn ang="0">
                    <a:pos x="341" y="149"/>
                  </a:cxn>
                  <a:cxn ang="0">
                    <a:pos x="0" y="205"/>
                  </a:cxn>
                </a:cxnLst>
                <a:pathLst>
                  <a:path w="43" h="12">
                    <a:moveTo>
                      <a:pt x="3" y="3"/>
                    </a:moveTo>
                    <a:cubicBezTo>
                      <a:pt x="6" y="0"/>
                      <a:pt x="9" y="0"/>
                      <a:pt x="14" y="1"/>
                    </a:cubicBezTo>
                    <a:cubicBezTo>
                      <a:pt x="18" y="1"/>
                      <a:pt x="21" y="1"/>
                      <a:pt x="25" y="1"/>
                    </a:cubicBezTo>
                    <a:cubicBezTo>
                      <a:pt x="33" y="1"/>
                      <a:pt x="41" y="4"/>
                      <a:pt x="43" y="12"/>
                    </a:cubicBezTo>
                    <a:cubicBezTo>
                      <a:pt x="39" y="3"/>
                      <a:pt x="28" y="4"/>
                      <a:pt x="21" y="3"/>
                    </a:cubicBezTo>
                    <a:cubicBezTo>
                      <a:pt x="17" y="3"/>
                      <a:pt x="13" y="4"/>
                      <a:pt x="9" y="3"/>
                    </a:cubicBezTo>
                    <a:cubicBezTo>
                      <a:pt x="6" y="3"/>
                      <a:pt x="3" y="1"/>
                      <a:pt x="0" y="4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2" name="Freeform 89"/>
              <p:cNvSpPr/>
              <p:nvPr/>
            </p:nvSpPr>
            <p:spPr>
              <a:xfrm>
                <a:off x="3105" y="1889"/>
                <a:ext cx="20" cy="1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313" y="0"/>
                  </a:cxn>
                  <a:cxn ang="0">
                    <a:pos x="283" y="305"/>
                  </a:cxn>
                </a:cxnLst>
                <a:pathLst>
                  <a:path w="8" h="5">
                    <a:moveTo>
                      <a:pt x="0" y="0"/>
                    </a:moveTo>
                    <a:cubicBezTo>
                      <a:pt x="2" y="1"/>
                      <a:pt x="5" y="1"/>
                      <a:pt x="8" y="0"/>
                    </a:cubicBezTo>
                    <a:cubicBezTo>
                      <a:pt x="7" y="1"/>
                      <a:pt x="7" y="3"/>
                      <a:pt x="7" y="5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3" name="Freeform 90"/>
              <p:cNvSpPr/>
              <p:nvPr/>
            </p:nvSpPr>
            <p:spPr>
              <a:xfrm>
                <a:off x="3115" y="1991"/>
                <a:ext cx="42" cy="170"/>
              </a:xfrm>
              <a:custGeom>
                <a:avLst/>
                <a:gdLst/>
                <a:ahLst/>
                <a:cxnLst>
                  <a:cxn ang="0">
                    <a:pos x="635" y="0"/>
                  </a:cxn>
                  <a:cxn ang="0">
                    <a:pos x="452" y="3190"/>
                  </a:cxn>
                  <a:cxn ang="0">
                    <a:pos x="378" y="1835"/>
                  </a:cxn>
                  <a:cxn ang="0">
                    <a:pos x="410" y="1052"/>
                  </a:cxn>
                  <a:cxn ang="0">
                    <a:pos x="635" y="0"/>
                  </a:cxn>
                </a:cxnLst>
                <a:pathLst>
                  <a:path w="17" h="64">
                    <a:moveTo>
                      <a:pt x="17" y="0"/>
                    </a:moveTo>
                    <a:cubicBezTo>
                      <a:pt x="3" y="12"/>
                      <a:pt x="0" y="51"/>
                      <a:pt x="12" y="64"/>
                    </a:cubicBezTo>
                    <a:cubicBezTo>
                      <a:pt x="9" y="56"/>
                      <a:pt x="10" y="46"/>
                      <a:pt x="10" y="37"/>
                    </a:cubicBezTo>
                    <a:cubicBezTo>
                      <a:pt x="11" y="32"/>
                      <a:pt x="9" y="29"/>
                      <a:pt x="11" y="21"/>
                    </a:cubicBezTo>
                    <a:cubicBezTo>
                      <a:pt x="12" y="15"/>
                      <a:pt x="13" y="6"/>
                      <a:pt x="17" y="0"/>
                    </a:cubicBezTo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4" name="Freeform 91"/>
              <p:cNvSpPr/>
              <p:nvPr/>
            </p:nvSpPr>
            <p:spPr>
              <a:xfrm>
                <a:off x="2962" y="1977"/>
                <a:ext cx="88" cy="9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475" y="1188"/>
                  </a:cxn>
                  <a:cxn ang="0">
                    <a:pos x="1398" y="1897"/>
                  </a:cxn>
                  <a:cxn ang="0">
                    <a:pos x="606" y="974"/>
                  </a:cxn>
                  <a:cxn ang="0">
                    <a:pos x="0" y="56"/>
                  </a:cxn>
                </a:cxnLst>
                <a:pathLst>
                  <a:path w="35" h="37">
                    <a:moveTo>
                      <a:pt x="0" y="0"/>
                    </a:moveTo>
                    <a:cubicBezTo>
                      <a:pt x="0" y="6"/>
                      <a:pt x="8" y="19"/>
                      <a:pt x="12" y="23"/>
                    </a:cubicBezTo>
                    <a:cubicBezTo>
                      <a:pt x="18" y="31"/>
                      <a:pt x="27" y="33"/>
                      <a:pt x="35" y="37"/>
                    </a:cubicBezTo>
                    <a:cubicBezTo>
                      <a:pt x="27" y="31"/>
                      <a:pt x="20" y="26"/>
                      <a:pt x="15" y="19"/>
                    </a:cubicBezTo>
                    <a:cubicBezTo>
                      <a:pt x="11" y="13"/>
                      <a:pt x="3" y="7"/>
                      <a:pt x="0" y="1"/>
                    </a:cubicBezTo>
                  </a:path>
                </a:pathLst>
              </a:custGeom>
              <a:solidFill>
                <a:srgbClr val="F5F5F5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5" name="Freeform 92"/>
              <p:cNvSpPr/>
              <p:nvPr/>
            </p:nvSpPr>
            <p:spPr>
              <a:xfrm>
                <a:off x="2927" y="1956"/>
                <a:ext cx="123" cy="211"/>
              </a:xfrm>
              <a:custGeom>
                <a:avLst/>
                <a:gdLst/>
                <a:ahLst/>
                <a:cxnLst>
                  <a:cxn ang="0">
                    <a:pos x="238" y="0"/>
                  </a:cxn>
                  <a:cxn ang="0">
                    <a:pos x="522" y="2134"/>
                  </a:cxn>
                  <a:cxn ang="0">
                    <a:pos x="1027" y="3045"/>
                  </a:cxn>
                  <a:cxn ang="0">
                    <a:pos x="1343" y="4022"/>
                  </a:cxn>
                  <a:cxn ang="0">
                    <a:pos x="1632" y="3411"/>
                  </a:cxn>
                  <a:cxn ang="0">
                    <a:pos x="1898" y="2954"/>
                  </a:cxn>
                  <a:cxn ang="0">
                    <a:pos x="1185" y="2246"/>
                  </a:cxn>
                  <a:cxn ang="0">
                    <a:pos x="238" y="662"/>
                  </a:cxn>
                </a:cxnLst>
                <a:pathLst>
                  <a:path w="49" h="79">
                    <a:moveTo>
                      <a:pt x="6" y="0"/>
                    </a:moveTo>
                    <a:cubicBezTo>
                      <a:pt x="0" y="10"/>
                      <a:pt x="7" y="33"/>
                      <a:pt x="13" y="42"/>
                    </a:cubicBezTo>
                    <a:cubicBezTo>
                      <a:pt x="18" y="48"/>
                      <a:pt x="23" y="53"/>
                      <a:pt x="26" y="60"/>
                    </a:cubicBezTo>
                    <a:cubicBezTo>
                      <a:pt x="29" y="65"/>
                      <a:pt x="30" y="74"/>
                      <a:pt x="34" y="79"/>
                    </a:cubicBezTo>
                    <a:cubicBezTo>
                      <a:pt x="38" y="76"/>
                      <a:pt x="38" y="71"/>
                      <a:pt x="41" y="67"/>
                    </a:cubicBezTo>
                    <a:cubicBezTo>
                      <a:pt x="43" y="64"/>
                      <a:pt x="47" y="62"/>
                      <a:pt x="48" y="58"/>
                    </a:cubicBezTo>
                    <a:cubicBezTo>
                      <a:pt x="49" y="50"/>
                      <a:pt x="35" y="47"/>
                      <a:pt x="30" y="44"/>
                    </a:cubicBezTo>
                    <a:cubicBezTo>
                      <a:pt x="20" y="36"/>
                      <a:pt x="8" y="27"/>
                      <a:pt x="6" y="13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6" name="Freeform 93"/>
              <p:cNvSpPr/>
              <p:nvPr/>
            </p:nvSpPr>
            <p:spPr>
              <a:xfrm>
                <a:off x="3030" y="2092"/>
                <a:ext cx="52" cy="7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565" y="451"/>
                  </a:cxn>
                  <a:cxn ang="0">
                    <a:pos x="485" y="1439"/>
                  </a:cxn>
                </a:cxnLst>
                <a:pathLst>
                  <a:path w="21" h="29">
                    <a:moveTo>
                      <a:pt x="0" y="0"/>
                    </a:moveTo>
                    <a:cubicBezTo>
                      <a:pt x="6" y="3"/>
                      <a:pt x="10" y="3"/>
                      <a:pt x="15" y="9"/>
                    </a:cubicBezTo>
                    <a:cubicBezTo>
                      <a:pt x="18" y="14"/>
                      <a:pt x="21" y="25"/>
                      <a:pt x="13" y="29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7" name="Freeform 94"/>
              <p:cNvSpPr/>
              <p:nvPr/>
            </p:nvSpPr>
            <p:spPr>
              <a:xfrm>
                <a:off x="2985" y="1844"/>
                <a:ext cx="142" cy="120"/>
              </a:xfrm>
              <a:custGeom>
                <a:avLst/>
                <a:gdLst/>
                <a:ahLst/>
                <a:cxnLst>
                  <a:cxn ang="0">
                    <a:pos x="725" y="456"/>
                  </a:cxn>
                  <a:cxn ang="0">
                    <a:pos x="1702" y="1515"/>
                  </a:cxn>
                  <a:cxn ang="0">
                    <a:pos x="1931" y="2125"/>
                  </a:cxn>
                  <a:cxn ang="0">
                    <a:pos x="2043" y="1421"/>
                  </a:cxn>
                  <a:cxn ang="0">
                    <a:pos x="1806" y="968"/>
                  </a:cxn>
                  <a:cxn ang="0">
                    <a:pos x="1111" y="547"/>
                  </a:cxn>
                  <a:cxn ang="0">
                    <a:pos x="0" y="0"/>
                  </a:cxn>
                  <a:cxn ang="0">
                    <a:pos x="924" y="704"/>
                  </a:cxn>
                </a:cxnLst>
                <a:pathLst>
                  <a:path w="57" h="45">
                    <a:moveTo>
                      <a:pt x="19" y="9"/>
                    </a:moveTo>
                    <a:cubicBezTo>
                      <a:pt x="26" y="17"/>
                      <a:pt x="37" y="21"/>
                      <a:pt x="44" y="30"/>
                    </a:cubicBezTo>
                    <a:cubicBezTo>
                      <a:pt x="46" y="32"/>
                      <a:pt x="49" y="42"/>
                      <a:pt x="50" y="42"/>
                    </a:cubicBezTo>
                    <a:cubicBezTo>
                      <a:pt x="57" y="45"/>
                      <a:pt x="54" y="31"/>
                      <a:pt x="53" y="28"/>
                    </a:cubicBezTo>
                    <a:cubicBezTo>
                      <a:pt x="52" y="21"/>
                      <a:pt x="52" y="21"/>
                      <a:pt x="47" y="19"/>
                    </a:cubicBezTo>
                    <a:cubicBezTo>
                      <a:pt x="41" y="16"/>
                      <a:pt x="35" y="13"/>
                      <a:pt x="29" y="11"/>
                    </a:cubicBezTo>
                    <a:cubicBezTo>
                      <a:pt x="19" y="7"/>
                      <a:pt x="10" y="2"/>
                      <a:pt x="0" y="0"/>
                    </a:cubicBezTo>
                    <a:cubicBezTo>
                      <a:pt x="4" y="5"/>
                      <a:pt x="18" y="11"/>
                      <a:pt x="24" y="14"/>
                    </a:cubicBezTo>
                  </a:path>
                </a:pathLst>
              </a:custGeom>
              <a:solidFill>
                <a:srgbClr val="CCCCCC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8" name="Freeform 95"/>
              <p:cNvSpPr/>
              <p:nvPr/>
            </p:nvSpPr>
            <p:spPr>
              <a:xfrm>
                <a:off x="2417" y="1812"/>
                <a:ext cx="365" cy="312"/>
              </a:xfrm>
              <a:custGeom>
                <a:avLst/>
                <a:gdLst/>
                <a:ahLst/>
                <a:cxnLst>
                  <a:cxn ang="0">
                    <a:pos x="0" y="5917"/>
                  </a:cxn>
                  <a:cxn ang="0">
                    <a:pos x="3208" y="909"/>
                  </a:cxn>
                  <a:cxn ang="0">
                    <a:pos x="5708" y="307"/>
                  </a:cxn>
                  <a:cxn ang="0">
                    <a:pos x="0" y="5917"/>
                  </a:cxn>
                </a:cxnLst>
                <a:pathLst>
                  <a:path w="146" h="117">
                    <a:moveTo>
                      <a:pt x="0" y="117"/>
                    </a:moveTo>
                    <a:cubicBezTo>
                      <a:pt x="10" y="73"/>
                      <a:pt x="30" y="36"/>
                      <a:pt x="82" y="18"/>
                    </a:cubicBezTo>
                    <a:cubicBezTo>
                      <a:pt x="135" y="0"/>
                      <a:pt x="146" y="6"/>
                      <a:pt x="146" y="6"/>
                    </a:cubicBezTo>
                    <a:cubicBezTo>
                      <a:pt x="121" y="11"/>
                      <a:pt x="33" y="18"/>
                      <a:pt x="0" y="117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79" name="Freeform 96"/>
              <p:cNvSpPr/>
              <p:nvPr/>
            </p:nvSpPr>
            <p:spPr>
              <a:xfrm>
                <a:off x="2189" y="2452"/>
                <a:ext cx="143" cy="248"/>
              </a:xfrm>
              <a:custGeom>
                <a:avLst/>
                <a:gdLst/>
                <a:ahLst/>
                <a:cxnLst>
                  <a:cxn ang="0">
                    <a:pos x="1422" y="0"/>
                  </a:cxn>
                  <a:cxn ang="0">
                    <a:pos x="2260" y="4701"/>
                  </a:cxn>
                  <a:cxn ang="0">
                    <a:pos x="1422" y="0"/>
                  </a:cxn>
                </a:cxnLst>
                <a:pathLst>
                  <a:path w="57" h="93">
                    <a:moveTo>
                      <a:pt x="36" y="0"/>
                    </a:moveTo>
                    <a:cubicBezTo>
                      <a:pt x="29" y="15"/>
                      <a:pt x="0" y="61"/>
                      <a:pt x="57" y="93"/>
                    </a:cubicBezTo>
                    <a:cubicBezTo>
                      <a:pt x="42" y="84"/>
                      <a:pt x="16" y="58"/>
                      <a:pt x="36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0" name="Freeform 97"/>
              <p:cNvSpPr/>
              <p:nvPr/>
            </p:nvSpPr>
            <p:spPr>
              <a:xfrm>
                <a:off x="3057" y="2297"/>
                <a:ext cx="188" cy="131"/>
              </a:xfrm>
              <a:custGeom>
                <a:avLst/>
                <a:gdLst/>
                <a:ahLst/>
                <a:cxnLst>
                  <a:cxn ang="0">
                    <a:pos x="283" y="1436"/>
                  </a:cxn>
                  <a:cxn ang="0">
                    <a:pos x="1547" y="401"/>
                  </a:cxn>
                  <a:cxn ang="0">
                    <a:pos x="2248" y="401"/>
                  </a:cxn>
                  <a:cxn ang="0">
                    <a:pos x="2960" y="457"/>
                  </a:cxn>
                  <a:cxn ang="0">
                    <a:pos x="867" y="307"/>
                  </a:cxn>
                  <a:cxn ang="0">
                    <a:pos x="238" y="914"/>
                  </a:cxn>
                  <a:cxn ang="0">
                    <a:pos x="0" y="2502"/>
                  </a:cxn>
                  <a:cxn ang="0">
                    <a:pos x="125" y="2101"/>
                  </a:cxn>
                  <a:cxn ang="0">
                    <a:pos x="396" y="1436"/>
                  </a:cxn>
                </a:cxnLst>
                <a:pathLst>
                  <a:path w="75" h="49">
                    <a:moveTo>
                      <a:pt x="7" y="28"/>
                    </a:moveTo>
                    <a:cubicBezTo>
                      <a:pt x="14" y="17"/>
                      <a:pt x="26" y="7"/>
                      <a:pt x="39" y="8"/>
                    </a:cubicBezTo>
                    <a:cubicBezTo>
                      <a:pt x="45" y="8"/>
                      <a:pt x="51" y="9"/>
                      <a:pt x="57" y="8"/>
                    </a:cubicBezTo>
                    <a:cubicBezTo>
                      <a:pt x="63" y="8"/>
                      <a:pt x="69" y="10"/>
                      <a:pt x="75" y="9"/>
                    </a:cubicBezTo>
                    <a:cubicBezTo>
                      <a:pt x="58" y="7"/>
                      <a:pt x="40" y="0"/>
                      <a:pt x="22" y="6"/>
                    </a:cubicBezTo>
                    <a:cubicBezTo>
                      <a:pt x="16" y="8"/>
                      <a:pt x="9" y="12"/>
                      <a:pt x="6" y="18"/>
                    </a:cubicBezTo>
                    <a:cubicBezTo>
                      <a:pt x="2" y="27"/>
                      <a:pt x="1" y="39"/>
                      <a:pt x="0" y="49"/>
                    </a:cubicBezTo>
                    <a:cubicBezTo>
                      <a:pt x="1" y="46"/>
                      <a:pt x="2" y="43"/>
                      <a:pt x="3" y="41"/>
                    </a:cubicBezTo>
                    <a:cubicBezTo>
                      <a:pt x="4" y="36"/>
                      <a:pt x="7" y="32"/>
                      <a:pt x="10" y="28"/>
                    </a:cubicBezTo>
                  </a:path>
                </a:pathLst>
              </a:custGeom>
              <a:solidFill>
                <a:srgbClr val="B8B8B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1" name="Freeform 98"/>
              <p:cNvSpPr/>
              <p:nvPr/>
            </p:nvSpPr>
            <p:spPr>
              <a:xfrm>
                <a:off x="2214" y="1681"/>
                <a:ext cx="1313" cy="1270"/>
              </a:xfrm>
              <a:custGeom>
                <a:avLst/>
                <a:gdLst/>
                <a:ahLst/>
                <a:cxnLst>
                  <a:cxn ang="0">
                    <a:pos x="3096" y="6897"/>
                  </a:cxn>
                  <a:cxn ang="0">
                    <a:pos x="2471" y="11659"/>
                  </a:cxn>
                  <a:cxn ang="0">
                    <a:pos x="313" y="16374"/>
                  </a:cxn>
                  <a:cxn ang="0">
                    <a:pos x="4897" y="21027"/>
                  </a:cxn>
                  <a:cxn ang="0">
                    <a:pos x="13060" y="21542"/>
                  </a:cxn>
                  <a:cxn ang="0">
                    <a:pos x="20540" y="24117"/>
                  </a:cxn>
                  <a:cxn ang="0">
                    <a:pos x="13498" y="21027"/>
                  </a:cxn>
                  <a:cxn ang="0">
                    <a:pos x="5630" y="20267"/>
                  </a:cxn>
                  <a:cxn ang="0">
                    <a:pos x="1376" y="16465"/>
                  </a:cxn>
                  <a:cxn ang="0">
                    <a:pos x="2864" y="14037"/>
                  </a:cxn>
                  <a:cxn ang="0">
                    <a:pos x="4034" y="13882"/>
                  </a:cxn>
                  <a:cxn ang="0">
                    <a:pos x="6535" y="14893"/>
                  </a:cxn>
                  <a:cxn ang="0">
                    <a:pos x="9231" y="14792"/>
                  </a:cxn>
                  <a:cxn ang="0">
                    <a:pos x="11622" y="14701"/>
                  </a:cxn>
                  <a:cxn ang="0">
                    <a:pos x="12797" y="15859"/>
                  </a:cxn>
                  <a:cxn ang="0">
                    <a:pos x="13968" y="16865"/>
                  </a:cxn>
                  <a:cxn ang="0">
                    <a:pos x="14280" y="17377"/>
                  </a:cxn>
                  <a:cxn ang="0">
                    <a:pos x="14468" y="17591"/>
                  </a:cxn>
                  <a:cxn ang="0">
                    <a:pos x="14435" y="17318"/>
                  </a:cxn>
                  <a:cxn ang="0">
                    <a:pos x="14393" y="16828"/>
                  </a:cxn>
                  <a:cxn ang="0">
                    <a:pos x="14781" y="17020"/>
                  </a:cxn>
                  <a:cxn ang="0">
                    <a:pos x="15018" y="17134"/>
                  </a:cxn>
                  <a:cxn ang="0">
                    <a:pos x="15093" y="17228"/>
                  </a:cxn>
                  <a:cxn ang="0">
                    <a:pos x="15018" y="16771"/>
                  </a:cxn>
                  <a:cxn ang="0">
                    <a:pos x="15093" y="16828"/>
                  </a:cxn>
                  <a:cxn ang="0">
                    <a:pos x="15218" y="16865"/>
                  </a:cxn>
                  <a:cxn ang="0">
                    <a:pos x="15143" y="16566"/>
                  </a:cxn>
                  <a:cxn ang="0">
                    <a:pos x="15018" y="16225"/>
                  </a:cxn>
                  <a:cxn ang="0">
                    <a:pos x="14706" y="16067"/>
                  </a:cxn>
                  <a:cxn ang="0">
                    <a:pos x="14623" y="15918"/>
                  </a:cxn>
                  <a:cxn ang="0">
                    <a:pos x="14080" y="15859"/>
                  </a:cxn>
                  <a:cxn ang="0">
                    <a:pos x="13455" y="15099"/>
                  </a:cxn>
                  <a:cxn ang="0">
                    <a:pos x="13580" y="14736"/>
                  </a:cxn>
                  <a:cxn ang="0">
                    <a:pos x="13998" y="15043"/>
                  </a:cxn>
                  <a:cxn ang="0">
                    <a:pos x="14310" y="15461"/>
                  </a:cxn>
                  <a:cxn ang="0">
                    <a:pos x="14435" y="15611"/>
                  </a:cxn>
                  <a:cxn ang="0">
                    <a:pos x="14435" y="15304"/>
                  </a:cxn>
                  <a:cxn ang="0">
                    <a:pos x="14623" y="15304"/>
                  </a:cxn>
                  <a:cxn ang="0">
                    <a:pos x="14861" y="15461"/>
                  </a:cxn>
                  <a:cxn ang="0">
                    <a:pos x="14936" y="15611"/>
                  </a:cxn>
                  <a:cxn ang="0">
                    <a:pos x="14781" y="14893"/>
                  </a:cxn>
                  <a:cxn ang="0">
                    <a:pos x="15018" y="15005"/>
                  </a:cxn>
                  <a:cxn ang="0">
                    <a:pos x="14706" y="14336"/>
                  </a:cxn>
                  <a:cxn ang="0">
                    <a:pos x="14235" y="14130"/>
                  </a:cxn>
                  <a:cxn ang="0">
                    <a:pos x="13810" y="13882"/>
                  </a:cxn>
                  <a:cxn ang="0">
                    <a:pos x="13580" y="13482"/>
                  </a:cxn>
                  <a:cxn ang="0">
                    <a:pos x="13655" y="13183"/>
                  </a:cxn>
                  <a:cxn ang="0">
                    <a:pos x="13580" y="13276"/>
                  </a:cxn>
                  <a:cxn ang="0">
                    <a:pos x="15061" y="12273"/>
                  </a:cxn>
                  <a:cxn ang="0">
                    <a:pos x="15769" y="12273"/>
                  </a:cxn>
                  <a:cxn ang="0">
                    <a:pos x="17102" y="12820"/>
                  </a:cxn>
                  <a:cxn ang="0">
                    <a:pos x="18194" y="12572"/>
                  </a:cxn>
                  <a:cxn ang="0">
                    <a:pos x="18852" y="12001"/>
                  </a:cxn>
                  <a:cxn ang="0">
                    <a:pos x="18457" y="10387"/>
                  </a:cxn>
                  <a:cxn ang="0">
                    <a:pos x="17882" y="8778"/>
                  </a:cxn>
                  <a:cxn ang="0">
                    <a:pos x="17444" y="7503"/>
                  </a:cxn>
                  <a:cxn ang="0">
                    <a:pos x="16739" y="6230"/>
                  </a:cxn>
                  <a:cxn ang="0">
                    <a:pos x="15999" y="4771"/>
                  </a:cxn>
                  <a:cxn ang="0">
                    <a:pos x="15143" y="2185"/>
                  </a:cxn>
                  <a:cxn ang="0">
                    <a:pos x="14123" y="2377"/>
                  </a:cxn>
                  <a:cxn ang="0">
                    <a:pos x="14280" y="3858"/>
                  </a:cxn>
                  <a:cxn ang="0">
                    <a:pos x="13685" y="3701"/>
                  </a:cxn>
                  <a:cxn ang="0">
                    <a:pos x="3096" y="6897"/>
                  </a:cxn>
                </a:cxnLst>
                <a:pathLst>
                  <a:path w="525" h="476">
                    <a:moveTo>
                      <a:pt x="79" y="136"/>
                    </a:moveTo>
                    <a:cubicBezTo>
                      <a:pt x="63" y="190"/>
                      <a:pt x="69" y="212"/>
                      <a:pt x="63" y="230"/>
                    </a:cubicBezTo>
                    <a:cubicBezTo>
                      <a:pt x="56" y="247"/>
                      <a:pt x="19" y="271"/>
                      <a:pt x="8" y="323"/>
                    </a:cubicBezTo>
                    <a:cubicBezTo>
                      <a:pt x="0" y="357"/>
                      <a:pt x="24" y="394"/>
                      <a:pt x="125" y="415"/>
                    </a:cubicBezTo>
                    <a:cubicBezTo>
                      <a:pt x="227" y="436"/>
                      <a:pt x="284" y="423"/>
                      <a:pt x="334" y="425"/>
                    </a:cubicBezTo>
                    <a:cubicBezTo>
                      <a:pt x="385" y="427"/>
                      <a:pt x="490" y="426"/>
                      <a:pt x="525" y="476"/>
                    </a:cubicBezTo>
                    <a:cubicBezTo>
                      <a:pt x="490" y="426"/>
                      <a:pt x="396" y="417"/>
                      <a:pt x="345" y="415"/>
                    </a:cubicBezTo>
                    <a:cubicBezTo>
                      <a:pt x="295" y="412"/>
                      <a:pt x="246" y="421"/>
                      <a:pt x="144" y="400"/>
                    </a:cubicBezTo>
                    <a:cubicBezTo>
                      <a:pt x="60" y="379"/>
                      <a:pt x="28" y="359"/>
                      <a:pt x="35" y="325"/>
                    </a:cubicBezTo>
                    <a:cubicBezTo>
                      <a:pt x="40" y="303"/>
                      <a:pt x="68" y="280"/>
                      <a:pt x="73" y="277"/>
                    </a:cubicBezTo>
                    <a:cubicBezTo>
                      <a:pt x="82" y="270"/>
                      <a:pt x="92" y="269"/>
                      <a:pt x="103" y="274"/>
                    </a:cubicBezTo>
                    <a:cubicBezTo>
                      <a:pt x="121" y="283"/>
                      <a:pt x="156" y="294"/>
                      <a:pt x="167" y="294"/>
                    </a:cubicBezTo>
                    <a:cubicBezTo>
                      <a:pt x="179" y="294"/>
                      <a:pt x="214" y="296"/>
                      <a:pt x="236" y="292"/>
                    </a:cubicBezTo>
                    <a:cubicBezTo>
                      <a:pt x="259" y="287"/>
                      <a:pt x="277" y="274"/>
                      <a:pt x="297" y="290"/>
                    </a:cubicBezTo>
                    <a:cubicBezTo>
                      <a:pt x="305" y="297"/>
                      <a:pt x="318" y="307"/>
                      <a:pt x="327" y="313"/>
                    </a:cubicBezTo>
                    <a:cubicBezTo>
                      <a:pt x="335" y="319"/>
                      <a:pt x="354" y="329"/>
                      <a:pt x="357" y="333"/>
                    </a:cubicBezTo>
                    <a:cubicBezTo>
                      <a:pt x="359" y="337"/>
                      <a:pt x="364" y="341"/>
                      <a:pt x="365" y="343"/>
                    </a:cubicBezTo>
                    <a:cubicBezTo>
                      <a:pt x="367" y="344"/>
                      <a:pt x="367" y="347"/>
                      <a:pt x="370" y="347"/>
                    </a:cubicBezTo>
                    <a:cubicBezTo>
                      <a:pt x="372" y="346"/>
                      <a:pt x="369" y="344"/>
                      <a:pt x="369" y="342"/>
                    </a:cubicBezTo>
                    <a:cubicBezTo>
                      <a:pt x="369" y="340"/>
                      <a:pt x="370" y="335"/>
                      <a:pt x="368" y="332"/>
                    </a:cubicBezTo>
                    <a:cubicBezTo>
                      <a:pt x="370" y="333"/>
                      <a:pt x="375" y="336"/>
                      <a:pt x="378" y="336"/>
                    </a:cubicBezTo>
                    <a:cubicBezTo>
                      <a:pt x="381" y="337"/>
                      <a:pt x="382" y="337"/>
                      <a:pt x="384" y="338"/>
                    </a:cubicBezTo>
                    <a:cubicBezTo>
                      <a:pt x="385" y="339"/>
                      <a:pt x="385" y="341"/>
                      <a:pt x="386" y="340"/>
                    </a:cubicBezTo>
                    <a:cubicBezTo>
                      <a:pt x="388" y="338"/>
                      <a:pt x="387" y="336"/>
                      <a:pt x="384" y="331"/>
                    </a:cubicBezTo>
                    <a:cubicBezTo>
                      <a:pt x="384" y="331"/>
                      <a:pt x="385" y="331"/>
                      <a:pt x="386" y="332"/>
                    </a:cubicBezTo>
                    <a:cubicBezTo>
                      <a:pt x="387" y="334"/>
                      <a:pt x="389" y="333"/>
                      <a:pt x="389" y="333"/>
                    </a:cubicBezTo>
                    <a:cubicBezTo>
                      <a:pt x="389" y="333"/>
                      <a:pt x="388" y="330"/>
                      <a:pt x="387" y="327"/>
                    </a:cubicBezTo>
                    <a:cubicBezTo>
                      <a:pt x="386" y="324"/>
                      <a:pt x="385" y="322"/>
                      <a:pt x="384" y="320"/>
                    </a:cubicBezTo>
                    <a:cubicBezTo>
                      <a:pt x="382" y="318"/>
                      <a:pt x="376" y="317"/>
                      <a:pt x="376" y="317"/>
                    </a:cubicBezTo>
                    <a:cubicBezTo>
                      <a:pt x="376" y="317"/>
                      <a:pt x="375" y="316"/>
                      <a:pt x="374" y="314"/>
                    </a:cubicBezTo>
                    <a:cubicBezTo>
                      <a:pt x="372" y="313"/>
                      <a:pt x="361" y="314"/>
                      <a:pt x="360" y="313"/>
                    </a:cubicBezTo>
                    <a:cubicBezTo>
                      <a:pt x="359" y="313"/>
                      <a:pt x="345" y="301"/>
                      <a:pt x="344" y="298"/>
                    </a:cubicBezTo>
                    <a:cubicBezTo>
                      <a:pt x="342" y="296"/>
                      <a:pt x="345" y="290"/>
                      <a:pt x="347" y="291"/>
                    </a:cubicBezTo>
                    <a:cubicBezTo>
                      <a:pt x="349" y="292"/>
                      <a:pt x="355" y="293"/>
                      <a:pt x="358" y="297"/>
                    </a:cubicBezTo>
                    <a:cubicBezTo>
                      <a:pt x="360" y="299"/>
                      <a:pt x="364" y="303"/>
                      <a:pt x="366" y="305"/>
                    </a:cubicBezTo>
                    <a:cubicBezTo>
                      <a:pt x="369" y="307"/>
                      <a:pt x="367" y="308"/>
                      <a:pt x="369" y="308"/>
                    </a:cubicBezTo>
                    <a:cubicBezTo>
                      <a:pt x="370" y="307"/>
                      <a:pt x="371" y="305"/>
                      <a:pt x="369" y="302"/>
                    </a:cubicBezTo>
                    <a:cubicBezTo>
                      <a:pt x="369" y="302"/>
                      <a:pt x="371" y="302"/>
                      <a:pt x="374" y="302"/>
                    </a:cubicBezTo>
                    <a:cubicBezTo>
                      <a:pt x="376" y="303"/>
                      <a:pt x="379" y="303"/>
                      <a:pt x="380" y="305"/>
                    </a:cubicBezTo>
                    <a:cubicBezTo>
                      <a:pt x="381" y="307"/>
                      <a:pt x="381" y="309"/>
                      <a:pt x="382" y="308"/>
                    </a:cubicBezTo>
                    <a:cubicBezTo>
                      <a:pt x="383" y="306"/>
                      <a:pt x="383" y="301"/>
                      <a:pt x="378" y="294"/>
                    </a:cubicBezTo>
                    <a:cubicBezTo>
                      <a:pt x="378" y="294"/>
                      <a:pt x="382" y="294"/>
                      <a:pt x="384" y="296"/>
                    </a:cubicBezTo>
                    <a:cubicBezTo>
                      <a:pt x="385" y="294"/>
                      <a:pt x="380" y="286"/>
                      <a:pt x="376" y="283"/>
                    </a:cubicBezTo>
                    <a:cubicBezTo>
                      <a:pt x="373" y="281"/>
                      <a:pt x="366" y="280"/>
                      <a:pt x="364" y="279"/>
                    </a:cubicBezTo>
                    <a:cubicBezTo>
                      <a:pt x="361" y="277"/>
                      <a:pt x="358" y="275"/>
                      <a:pt x="353" y="274"/>
                    </a:cubicBezTo>
                    <a:cubicBezTo>
                      <a:pt x="348" y="272"/>
                      <a:pt x="350" y="272"/>
                      <a:pt x="347" y="266"/>
                    </a:cubicBezTo>
                    <a:cubicBezTo>
                      <a:pt x="347" y="264"/>
                      <a:pt x="347" y="262"/>
                      <a:pt x="349" y="260"/>
                    </a:cubicBezTo>
                    <a:cubicBezTo>
                      <a:pt x="347" y="262"/>
                      <a:pt x="347" y="262"/>
                      <a:pt x="347" y="262"/>
                    </a:cubicBezTo>
                    <a:cubicBezTo>
                      <a:pt x="350" y="255"/>
                      <a:pt x="362" y="241"/>
                      <a:pt x="385" y="242"/>
                    </a:cubicBezTo>
                    <a:cubicBezTo>
                      <a:pt x="385" y="242"/>
                      <a:pt x="391" y="244"/>
                      <a:pt x="403" y="242"/>
                    </a:cubicBezTo>
                    <a:cubicBezTo>
                      <a:pt x="416" y="240"/>
                      <a:pt x="430" y="250"/>
                      <a:pt x="437" y="253"/>
                    </a:cubicBezTo>
                    <a:cubicBezTo>
                      <a:pt x="445" y="256"/>
                      <a:pt x="459" y="249"/>
                      <a:pt x="465" y="248"/>
                    </a:cubicBezTo>
                    <a:cubicBezTo>
                      <a:pt x="470" y="246"/>
                      <a:pt x="478" y="244"/>
                      <a:pt x="482" y="237"/>
                    </a:cubicBezTo>
                    <a:cubicBezTo>
                      <a:pt x="487" y="229"/>
                      <a:pt x="478" y="218"/>
                      <a:pt x="472" y="205"/>
                    </a:cubicBezTo>
                    <a:cubicBezTo>
                      <a:pt x="467" y="192"/>
                      <a:pt x="459" y="182"/>
                      <a:pt x="457" y="173"/>
                    </a:cubicBezTo>
                    <a:cubicBezTo>
                      <a:pt x="458" y="151"/>
                      <a:pt x="446" y="148"/>
                      <a:pt x="446" y="148"/>
                    </a:cubicBezTo>
                    <a:cubicBezTo>
                      <a:pt x="446" y="148"/>
                      <a:pt x="434" y="137"/>
                      <a:pt x="428" y="123"/>
                    </a:cubicBezTo>
                    <a:cubicBezTo>
                      <a:pt x="421" y="109"/>
                      <a:pt x="417" y="104"/>
                      <a:pt x="409" y="94"/>
                    </a:cubicBezTo>
                    <a:cubicBezTo>
                      <a:pt x="409" y="94"/>
                      <a:pt x="411" y="63"/>
                      <a:pt x="387" y="43"/>
                    </a:cubicBezTo>
                    <a:cubicBezTo>
                      <a:pt x="363" y="23"/>
                      <a:pt x="357" y="32"/>
                      <a:pt x="361" y="47"/>
                    </a:cubicBezTo>
                    <a:cubicBezTo>
                      <a:pt x="364" y="63"/>
                      <a:pt x="365" y="76"/>
                      <a:pt x="365" y="76"/>
                    </a:cubicBezTo>
                    <a:cubicBezTo>
                      <a:pt x="365" y="76"/>
                      <a:pt x="361" y="79"/>
                      <a:pt x="350" y="73"/>
                    </a:cubicBezTo>
                    <a:cubicBezTo>
                      <a:pt x="183" y="0"/>
                      <a:pt x="92" y="92"/>
                      <a:pt x="79" y="136"/>
                    </a:cubicBezTo>
                    <a:close/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2" name="Freeform 99"/>
              <p:cNvSpPr/>
              <p:nvPr/>
            </p:nvSpPr>
            <p:spPr>
              <a:xfrm>
                <a:off x="2894" y="1839"/>
                <a:ext cx="236" cy="290"/>
              </a:xfrm>
              <a:custGeom>
                <a:avLst/>
                <a:gdLst/>
                <a:ahLst/>
                <a:cxnLst>
                  <a:cxn ang="0">
                    <a:pos x="3738" y="2711"/>
                  </a:cxn>
                  <a:cxn ang="0">
                    <a:pos x="1152" y="1203"/>
                  </a:cxn>
                  <a:cxn ang="0">
                    <a:pos x="1948" y="4558"/>
                  </a:cxn>
                  <a:cxn ang="0">
                    <a:pos x="2975" y="5465"/>
                  </a:cxn>
                </a:cxnLst>
                <a:pathLst>
                  <a:path w="94" h="109">
                    <a:moveTo>
                      <a:pt x="94" y="54"/>
                    </a:moveTo>
                    <a:cubicBezTo>
                      <a:pt x="88" y="34"/>
                      <a:pt x="57" y="0"/>
                      <a:pt x="29" y="24"/>
                    </a:cubicBezTo>
                    <a:cubicBezTo>
                      <a:pt x="0" y="48"/>
                      <a:pt x="38" y="87"/>
                      <a:pt x="49" y="91"/>
                    </a:cubicBezTo>
                    <a:cubicBezTo>
                      <a:pt x="60" y="96"/>
                      <a:pt x="72" y="101"/>
                      <a:pt x="75" y="109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3" name="Freeform 100"/>
              <p:cNvSpPr/>
              <p:nvPr/>
            </p:nvSpPr>
            <p:spPr>
              <a:xfrm>
                <a:off x="3067" y="2004"/>
                <a:ext cx="33" cy="72"/>
              </a:xfrm>
              <a:custGeom>
                <a:avLst/>
                <a:gdLst/>
                <a:ahLst/>
                <a:cxnLst>
                  <a:cxn ang="0">
                    <a:pos x="541" y="0"/>
                  </a:cxn>
                  <a:cxn ang="0">
                    <a:pos x="160" y="456"/>
                  </a:cxn>
                  <a:cxn ang="0">
                    <a:pos x="327" y="1365"/>
                  </a:cxn>
                </a:cxnLst>
                <a:pathLst>
                  <a:path w="13" h="27">
                    <a:moveTo>
                      <a:pt x="13" y="0"/>
                    </a:moveTo>
                    <a:cubicBezTo>
                      <a:pt x="2" y="0"/>
                      <a:pt x="0" y="3"/>
                      <a:pt x="4" y="9"/>
                    </a:cubicBezTo>
                    <a:cubicBezTo>
                      <a:pt x="9" y="16"/>
                      <a:pt x="1" y="23"/>
                      <a:pt x="8" y="27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4" name="Freeform 101"/>
              <p:cNvSpPr/>
              <p:nvPr/>
            </p:nvSpPr>
            <p:spPr>
              <a:xfrm>
                <a:off x="3260" y="2321"/>
                <a:ext cx="65" cy="155"/>
              </a:xfrm>
              <a:custGeom>
                <a:avLst/>
                <a:gdLst/>
                <a:ahLst/>
                <a:cxnLst>
                  <a:cxn ang="0">
                    <a:pos x="1020" y="0"/>
                  </a:cxn>
                  <a:cxn ang="0">
                    <a:pos x="238" y="2956"/>
                  </a:cxn>
                </a:cxnLst>
                <a:pathLst>
                  <a:path w="26" h="58">
                    <a:moveTo>
                      <a:pt x="26" y="0"/>
                    </a:moveTo>
                    <a:cubicBezTo>
                      <a:pt x="19" y="8"/>
                      <a:pt x="0" y="39"/>
                      <a:pt x="6" y="58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5" name="Freeform 102"/>
              <p:cNvSpPr/>
              <p:nvPr/>
            </p:nvSpPr>
            <p:spPr>
              <a:xfrm>
                <a:off x="3242" y="2319"/>
                <a:ext cx="75" cy="141"/>
              </a:xfrm>
              <a:custGeom>
                <a:avLst/>
                <a:gdLst/>
                <a:ahLst/>
                <a:cxnLst>
                  <a:cxn ang="0">
                    <a:pos x="1175" y="0"/>
                  </a:cxn>
                  <a:cxn ang="0">
                    <a:pos x="0" y="2655"/>
                  </a:cxn>
                </a:cxnLst>
                <a:pathLst>
                  <a:path w="30" h="53">
                    <a:moveTo>
                      <a:pt x="30" y="0"/>
                    </a:moveTo>
                    <a:cubicBezTo>
                      <a:pt x="24" y="5"/>
                      <a:pt x="1" y="44"/>
                      <a:pt x="0" y="53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6" name="Freeform 103"/>
              <p:cNvSpPr/>
              <p:nvPr/>
            </p:nvSpPr>
            <p:spPr>
              <a:xfrm>
                <a:off x="3215" y="2313"/>
                <a:ext cx="97" cy="115"/>
              </a:xfrm>
              <a:custGeom>
                <a:avLst/>
                <a:gdLst/>
                <a:ahLst/>
                <a:cxnLst>
                  <a:cxn ang="0">
                    <a:pos x="1490" y="0"/>
                  </a:cxn>
                  <a:cxn ang="0">
                    <a:pos x="0" y="2204"/>
                  </a:cxn>
                </a:cxnLst>
                <a:pathLst>
                  <a:path w="39" h="43">
                    <a:moveTo>
                      <a:pt x="39" y="0"/>
                    </a:moveTo>
                    <a:cubicBezTo>
                      <a:pt x="29" y="7"/>
                      <a:pt x="5" y="37"/>
                      <a:pt x="0" y="43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7" name="Freeform 104"/>
              <p:cNvSpPr/>
              <p:nvPr/>
            </p:nvSpPr>
            <p:spPr>
              <a:xfrm>
                <a:off x="3407" y="2233"/>
                <a:ext cx="43" cy="19"/>
              </a:xfrm>
              <a:custGeom>
                <a:avLst/>
                <a:gdLst/>
                <a:ahLst/>
                <a:cxnLst>
                  <a:cxn ang="0">
                    <a:pos x="698" y="0"/>
                  </a:cxn>
                  <a:cxn ang="0">
                    <a:pos x="0" y="383"/>
                  </a:cxn>
                </a:cxnLst>
                <a:pathLst>
                  <a:path w="17" h="7">
                    <a:moveTo>
                      <a:pt x="17" y="0"/>
                    </a:moveTo>
                    <a:cubicBezTo>
                      <a:pt x="12" y="2"/>
                      <a:pt x="1" y="6"/>
                      <a:pt x="0" y="7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8" name="Freeform 105"/>
              <p:cNvSpPr/>
              <p:nvPr/>
            </p:nvSpPr>
            <p:spPr>
              <a:xfrm>
                <a:off x="3407" y="2223"/>
                <a:ext cx="23" cy="21"/>
              </a:xfrm>
              <a:custGeom>
                <a:avLst/>
                <a:gdLst/>
                <a:ahLst/>
                <a:cxnLst>
                  <a:cxn ang="0">
                    <a:pos x="386" y="0"/>
                  </a:cxn>
                  <a:cxn ang="0">
                    <a:pos x="0" y="378"/>
                  </a:cxn>
                </a:cxnLst>
                <a:pathLst>
                  <a:path w="9" h="8">
                    <a:moveTo>
                      <a:pt x="9" y="0"/>
                    </a:moveTo>
                    <a:cubicBezTo>
                      <a:pt x="6" y="1"/>
                      <a:pt x="1" y="7"/>
                      <a:pt x="0" y="8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89" name="Freeform 106"/>
              <p:cNvSpPr/>
              <p:nvPr/>
            </p:nvSpPr>
            <p:spPr>
              <a:xfrm>
                <a:off x="3402" y="2188"/>
                <a:ext cx="33" cy="51"/>
              </a:xfrm>
              <a:custGeom>
                <a:avLst/>
                <a:gdLst/>
                <a:ahLst/>
                <a:cxnLst>
                  <a:cxn ang="0">
                    <a:pos x="541" y="0"/>
                  </a:cxn>
                  <a:cxn ang="0">
                    <a:pos x="0" y="988"/>
                  </a:cxn>
                </a:cxnLst>
                <a:pathLst>
                  <a:path w="13" h="19">
                    <a:moveTo>
                      <a:pt x="13" y="0"/>
                    </a:moveTo>
                    <a:cubicBezTo>
                      <a:pt x="8" y="3"/>
                      <a:pt x="1" y="15"/>
                      <a:pt x="0" y="19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0" name="Freeform 107"/>
              <p:cNvSpPr/>
              <p:nvPr/>
            </p:nvSpPr>
            <p:spPr>
              <a:xfrm>
                <a:off x="3295" y="2329"/>
                <a:ext cx="35" cy="139"/>
              </a:xfrm>
              <a:custGeom>
                <a:avLst/>
                <a:gdLst/>
                <a:ahLst/>
                <a:cxnLst>
                  <a:cxn ang="0">
                    <a:pos x="550" y="0"/>
                  </a:cxn>
                  <a:cxn ang="0">
                    <a:pos x="83" y="2657"/>
                  </a:cxn>
                </a:cxnLst>
                <a:pathLst>
                  <a:path w="14" h="52">
                    <a:moveTo>
                      <a:pt x="14" y="0"/>
                    </a:moveTo>
                    <a:cubicBezTo>
                      <a:pt x="10" y="5"/>
                      <a:pt x="0" y="36"/>
                      <a:pt x="2" y="52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1" name="Freeform 108"/>
              <p:cNvSpPr/>
              <p:nvPr/>
            </p:nvSpPr>
            <p:spPr>
              <a:xfrm>
                <a:off x="3185" y="2305"/>
                <a:ext cx="127" cy="78"/>
              </a:xfrm>
              <a:custGeom>
                <a:avLst/>
                <a:gdLst/>
                <a:ahLst/>
                <a:cxnLst>
                  <a:cxn ang="0">
                    <a:pos x="1960" y="0"/>
                  </a:cxn>
                  <a:cxn ang="0">
                    <a:pos x="0" y="1520"/>
                  </a:cxn>
                </a:cxnLst>
                <a:pathLst>
                  <a:path w="51" h="29">
                    <a:moveTo>
                      <a:pt x="51" y="0"/>
                    </a:moveTo>
                    <a:cubicBezTo>
                      <a:pt x="47" y="2"/>
                      <a:pt x="14" y="24"/>
                      <a:pt x="0" y="29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2" name="Freeform 109"/>
              <p:cNvSpPr/>
              <p:nvPr/>
            </p:nvSpPr>
            <p:spPr>
              <a:xfrm>
                <a:off x="3410" y="2249"/>
                <a:ext cx="27" cy="8"/>
              </a:xfrm>
              <a:custGeom>
                <a:avLst/>
                <a:gdLst/>
                <a:ahLst/>
                <a:cxnLst>
                  <a:cxn ang="0">
                    <a:pos x="0" y="93"/>
                  </a:cxn>
                  <a:cxn ang="0">
                    <a:pos x="398" y="149"/>
                  </a:cxn>
                </a:cxnLst>
                <a:pathLst>
                  <a:path w="11" h="3">
                    <a:moveTo>
                      <a:pt x="0" y="2"/>
                    </a:moveTo>
                    <a:cubicBezTo>
                      <a:pt x="3" y="1"/>
                      <a:pt x="6" y="0"/>
                      <a:pt x="11" y="3"/>
                    </a:cubicBezTo>
                  </a:path>
                </a:pathLst>
              </a:custGeom>
              <a:noFill/>
              <a:ln w="3175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3" name="Freeform 110"/>
              <p:cNvSpPr/>
              <p:nvPr/>
            </p:nvSpPr>
            <p:spPr>
              <a:xfrm>
                <a:off x="3217" y="2143"/>
                <a:ext cx="68" cy="69"/>
              </a:xfrm>
              <a:custGeom>
                <a:avLst/>
                <a:gdLst/>
                <a:ahLst/>
                <a:cxnLst>
                  <a:cxn ang="0">
                    <a:pos x="1007" y="1085"/>
                  </a:cxn>
                  <a:cxn ang="0">
                    <a:pos x="685" y="295"/>
                  </a:cxn>
                  <a:cxn ang="0">
                    <a:pos x="50" y="507"/>
                  </a:cxn>
                  <a:cxn ang="0">
                    <a:pos x="368" y="1197"/>
                  </a:cxn>
                  <a:cxn ang="0">
                    <a:pos x="881" y="1085"/>
                  </a:cxn>
                  <a:cxn ang="0">
                    <a:pos x="1007" y="1085"/>
                  </a:cxn>
                </a:cxnLst>
                <a:pathLst>
                  <a:path w="27" h="26">
                    <a:moveTo>
                      <a:pt x="25" y="22"/>
                    </a:moveTo>
                    <a:cubicBezTo>
                      <a:pt x="23" y="20"/>
                      <a:pt x="27" y="11"/>
                      <a:pt x="17" y="6"/>
                    </a:cubicBezTo>
                    <a:cubicBezTo>
                      <a:pt x="8" y="0"/>
                      <a:pt x="1" y="10"/>
                      <a:pt x="1" y="10"/>
                    </a:cubicBezTo>
                    <a:cubicBezTo>
                      <a:pt x="0" y="17"/>
                      <a:pt x="4" y="22"/>
                      <a:pt x="9" y="24"/>
                    </a:cubicBezTo>
                    <a:cubicBezTo>
                      <a:pt x="13" y="26"/>
                      <a:pt x="22" y="22"/>
                      <a:pt x="22" y="22"/>
                    </a:cubicBezTo>
                    <a:lnTo>
                      <a:pt x="25" y="22"/>
                    </a:lnTo>
                    <a:close/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4" name="Freeform 111"/>
              <p:cNvSpPr/>
              <p:nvPr/>
            </p:nvSpPr>
            <p:spPr>
              <a:xfrm>
                <a:off x="3222" y="2153"/>
                <a:ext cx="55" cy="56"/>
              </a:xfrm>
              <a:custGeom>
                <a:avLst/>
                <a:gdLst/>
                <a:ahLst/>
                <a:cxnLst>
                  <a:cxn ang="0">
                    <a:pos x="125" y="248"/>
                  </a:cxn>
                  <a:cxn ang="0">
                    <a:pos x="625" y="149"/>
                  </a:cxn>
                  <a:cxn ang="0">
                    <a:pos x="708" y="819"/>
                  </a:cxn>
                  <a:cxn ang="0">
                    <a:pos x="208" y="909"/>
                  </a:cxn>
                  <a:cxn ang="0">
                    <a:pos x="125" y="248"/>
                  </a:cxn>
                </a:cxnLst>
                <a:pathLst>
                  <a:path w="22" h="21">
                    <a:moveTo>
                      <a:pt x="3" y="5"/>
                    </a:moveTo>
                    <a:cubicBezTo>
                      <a:pt x="6" y="0"/>
                      <a:pt x="12" y="0"/>
                      <a:pt x="16" y="3"/>
                    </a:cubicBezTo>
                    <a:cubicBezTo>
                      <a:pt x="21" y="6"/>
                      <a:pt x="22" y="12"/>
                      <a:pt x="18" y="16"/>
                    </a:cubicBezTo>
                    <a:cubicBezTo>
                      <a:pt x="15" y="20"/>
                      <a:pt x="9" y="21"/>
                      <a:pt x="5" y="18"/>
                    </a:cubicBezTo>
                    <a:cubicBezTo>
                      <a:pt x="1" y="15"/>
                      <a:pt x="0" y="9"/>
                      <a:pt x="3" y="5"/>
                    </a:cubicBezTo>
                    <a:close/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5" name="Freeform 112"/>
              <p:cNvSpPr/>
              <p:nvPr/>
            </p:nvSpPr>
            <p:spPr>
              <a:xfrm>
                <a:off x="3237" y="2169"/>
                <a:ext cx="23" cy="24"/>
              </a:xfrm>
              <a:custGeom>
                <a:avLst/>
                <a:gdLst/>
                <a:ahLst/>
                <a:cxnLst>
                  <a:cxn ang="0">
                    <a:pos x="84" y="93"/>
                  </a:cxn>
                  <a:cxn ang="0">
                    <a:pos x="302" y="56"/>
                  </a:cxn>
                  <a:cxn ang="0">
                    <a:pos x="332" y="363"/>
                  </a:cxn>
                  <a:cxn ang="0">
                    <a:pos x="130" y="363"/>
                  </a:cxn>
                  <a:cxn ang="0">
                    <a:pos x="84" y="93"/>
                  </a:cxn>
                </a:cxnLst>
                <a:pathLst>
                  <a:path w="9" h="9">
                    <a:moveTo>
                      <a:pt x="2" y="2"/>
                    </a:moveTo>
                    <a:cubicBezTo>
                      <a:pt x="3" y="0"/>
                      <a:pt x="5" y="0"/>
                      <a:pt x="7" y="1"/>
                    </a:cubicBezTo>
                    <a:cubicBezTo>
                      <a:pt x="9" y="3"/>
                      <a:pt x="9" y="5"/>
                      <a:pt x="8" y="7"/>
                    </a:cubicBezTo>
                    <a:cubicBezTo>
                      <a:pt x="7" y="8"/>
                      <a:pt x="4" y="9"/>
                      <a:pt x="3" y="7"/>
                    </a:cubicBezTo>
                    <a:cubicBezTo>
                      <a:pt x="1" y="6"/>
                      <a:pt x="0" y="4"/>
                      <a:pt x="2" y="2"/>
                    </a:cubicBezTo>
                    <a:close/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6" name="Freeform 113"/>
              <p:cNvSpPr/>
              <p:nvPr/>
            </p:nvSpPr>
            <p:spPr>
              <a:xfrm>
                <a:off x="2682" y="2468"/>
                <a:ext cx="80" cy="40"/>
              </a:xfrm>
              <a:custGeom>
                <a:avLst/>
                <a:gdLst/>
                <a:ahLst/>
                <a:cxnLst>
                  <a:cxn ang="0">
                    <a:pos x="1250" y="760"/>
                  </a:cxn>
                  <a:cxn ang="0">
                    <a:pos x="708" y="307"/>
                  </a:cxn>
                  <a:cxn ang="0">
                    <a:pos x="0" y="0"/>
                  </a:cxn>
                </a:cxnLst>
                <a:pathLst>
                  <a:path w="32" h="15">
                    <a:moveTo>
                      <a:pt x="32" y="15"/>
                    </a:moveTo>
                    <a:cubicBezTo>
                      <a:pt x="27" y="10"/>
                      <a:pt x="23" y="7"/>
                      <a:pt x="18" y="6"/>
                    </a:cubicBezTo>
                    <a:cubicBezTo>
                      <a:pt x="14" y="5"/>
                      <a:pt x="1" y="0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7" name="Freeform 114"/>
              <p:cNvSpPr/>
              <p:nvPr/>
            </p:nvSpPr>
            <p:spPr>
              <a:xfrm>
                <a:off x="2659" y="2473"/>
                <a:ext cx="70" cy="40"/>
              </a:xfrm>
              <a:custGeom>
                <a:avLst/>
                <a:gdLst/>
                <a:ahLst/>
                <a:cxnLst>
                  <a:cxn ang="0">
                    <a:pos x="1095" y="760"/>
                  </a:cxn>
                  <a:cxn ang="0">
                    <a:pos x="863" y="363"/>
                  </a:cxn>
                  <a:cxn ang="0">
                    <a:pos x="0" y="0"/>
                  </a:cxn>
                </a:cxnLst>
                <a:pathLst>
                  <a:path w="28" h="15">
                    <a:moveTo>
                      <a:pt x="28" y="15"/>
                    </a:moveTo>
                    <a:cubicBezTo>
                      <a:pt x="26" y="12"/>
                      <a:pt x="24" y="8"/>
                      <a:pt x="22" y="7"/>
                    </a:cubicBezTo>
                    <a:cubicBezTo>
                      <a:pt x="20" y="6"/>
                      <a:pt x="2" y="0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8" name="Freeform 115"/>
              <p:cNvSpPr/>
              <p:nvPr/>
            </p:nvSpPr>
            <p:spPr>
              <a:xfrm>
                <a:off x="2644" y="2473"/>
                <a:ext cx="8" cy="19"/>
              </a:xfrm>
              <a:custGeom>
                <a:avLst/>
                <a:gdLst/>
                <a:ahLst/>
                <a:cxnLst>
                  <a:cxn ang="0">
                    <a:pos x="149" y="383"/>
                  </a:cxn>
                  <a:cxn ang="0">
                    <a:pos x="0" y="0"/>
                  </a:cxn>
                </a:cxnLst>
                <a:pathLst>
                  <a:path w="3" h="7">
                    <a:moveTo>
                      <a:pt x="3" y="7"/>
                    </a:moveTo>
                    <a:cubicBezTo>
                      <a:pt x="3" y="4"/>
                      <a:pt x="0" y="0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099" name="Freeform 116"/>
              <p:cNvSpPr/>
              <p:nvPr/>
            </p:nvSpPr>
            <p:spPr>
              <a:xfrm>
                <a:off x="2544" y="2441"/>
                <a:ext cx="238" cy="11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08" y="215"/>
                  </a:cxn>
                  <a:cxn ang="0">
                    <a:pos x="1180" y="735"/>
                  </a:cxn>
                  <a:cxn ang="0">
                    <a:pos x="1576" y="1505"/>
                  </a:cxn>
                  <a:cxn ang="0">
                    <a:pos x="1651" y="1604"/>
                  </a:cxn>
                  <a:cxn ang="0">
                    <a:pos x="1701" y="1757"/>
                  </a:cxn>
                  <a:cxn ang="0">
                    <a:pos x="1731" y="1663"/>
                  </a:cxn>
                  <a:cxn ang="0">
                    <a:pos x="1776" y="1446"/>
                  </a:cxn>
                  <a:cxn ang="0">
                    <a:pos x="1701" y="987"/>
                  </a:cxn>
                  <a:cxn ang="0">
                    <a:pos x="2277" y="1138"/>
                  </a:cxn>
                  <a:cxn ang="0">
                    <a:pos x="2673" y="1757"/>
                  </a:cxn>
                  <a:cxn ang="0">
                    <a:pos x="2874" y="1972"/>
                  </a:cxn>
                  <a:cxn ang="0">
                    <a:pos x="2956" y="2122"/>
                  </a:cxn>
                  <a:cxn ang="0">
                    <a:pos x="2956" y="1972"/>
                  </a:cxn>
                  <a:cxn ang="0">
                    <a:pos x="2906" y="1390"/>
                  </a:cxn>
                  <a:cxn ang="0">
                    <a:pos x="3194" y="1505"/>
                  </a:cxn>
                  <a:cxn ang="0">
                    <a:pos x="3427" y="1604"/>
                  </a:cxn>
                  <a:cxn ang="0">
                    <a:pos x="3507" y="1663"/>
                  </a:cxn>
                  <a:cxn ang="0">
                    <a:pos x="3507" y="1505"/>
                  </a:cxn>
                  <a:cxn ang="0">
                    <a:pos x="3427" y="1296"/>
                  </a:cxn>
                  <a:cxn ang="0">
                    <a:pos x="3615" y="1296"/>
                  </a:cxn>
                  <a:cxn ang="0">
                    <a:pos x="3740" y="1296"/>
                  </a:cxn>
                  <a:cxn ang="0">
                    <a:pos x="3665" y="1194"/>
                  </a:cxn>
                  <a:cxn ang="0">
                    <a:pos x="3352" y="770"/>
                  </a:cxn>
                  <a:cxn ang="0">
                    <a:pos x="2831" y="518"/>
                  </a:cxn>
                  <a:cxn ang="0">
                    <a:pos x="1380" y="461"/>
                  </a:cxn>
                  <a:cxn ang="0">
                    <a:pos x="0" y="0"/>
                  </a:cxn>
                </a:cxnLst>
                <a:pathLst>
                  <a:path w="95" h="41">
                    <a:moveTo>
                      <a:pt x="0" y="0"/>
                    </a:moveTo>
                    <a:cubicBezTo>
                      <a:pt x="1" y="2"/>
                      <a:pt x="3" y="3"/>
                      <a:pt x="5" y="4"/>
                    </a:cubicBezTo>
                    <a:cubicBezTo>
                      <a:pt x="10" y="6"/>
                      <a:pt x="26" y="12"/>
                      <a:pt x="30" y="14"/>
                    </a:cubicBezTo>
                    <a:cubicBezTo>
                      <a:pt x="33" y="16"/>
                      <a:pt x="37" y="24"/>
                      <a:pt x="40" y="29"/>
                    </a:cubicBezTo>
                    <a:cubicBezTo>
                      <a:pt x="40" y="30"/>
                      <a:pt x="41" y="31"/>
                      <a:pt x="42" y="31"/>
                    </a:cubicBezTo>
                    <a:cubicBezTo>
                      <a:pt x="43" y="33"/>
                      <a:pt x="43" y="34"/>
                      <a:pt x="43" y="34"/>
                    </a:cubicBezTo>
                    <a:cubicBezTo>
                      <a:pt x="44" y="34"/>
                      <a:pt x="44" y="33"/>
                      <a:pt x="44" y="32"/>
                    </a:cubicBezTo>
                    <a:cubicBezTo>
                      <a:pt x="44" y="31"/>
                      <a:pt x="45" y="29"/>
                      <a:pt x="45" y="28"/>
                    </a:cubicBezTo>
                    <a:cubicBezTo>
                      <a:pt x="44" y="23"/>
                      <a:pt x="43" y="19"/>
                      <a:pt x="43" y="19"/>
                    </a:cubicBezTo>
                    <a:cubicBezTo>
                      <a:pt x="43" y="19"/>
                      <a:pt x="55" y="19"/>
                      <a:pt x="58" y="22"/>
                    </a:cubicBezTo>
                    <a:cubicBezTo>
                      <a:pt x="61" y="25"/>
                      <a:pt x="67" y="32"/>
                      <a:pt x="68" y="34"/>
                    </a:cubicBezTo>
                    <a:cubicBezTo>
                      <a:pt x="69" y="36"/>
                      <a:pt x="71" y="37"/>
                      <a:pt x="73" y="38"/>
                    </a:cubicBezTo>
                    <a:cubicBezTo>
                      <a:pt x="74" y="39"/>
                      <a:pt x="74" y="41"/>
                      <a:pt x="75" y="41"/>
                    </a:cubicBezTo>
                    <a:cubicBezTo>
                      <a:pt x="76" y="41"/>
                      <a:pt x="75" y="39"/>
                      <a:pt x="75" y="38"/>
                    </a:cubicBezTo>
                    <a:cubicBezTo>
                      <a:pt x="75" y="35"/>
                      <a:pt x="74" y="27"/>
                      <a:pt x="74" y="27"/>
                    </a:cubicBezTo>
                    <a:cubicBezTo>
                      <a:pt x="74" y="27"/>
                      <a:pt x="78" y="28"/>
                      <a:pt x="81" y="29"/>
                    </a:cubicBezTo>
                    <a:cubicBezTo>
                      <a:pt x="83" y="29"/>
                      <a:pt x="86" y="31"/>
                      <a:pt x="87" y="31"/>
                    </a:cubicBezTo>
                    <a:cubicBezTo>
                      <a:pt x="88" y="31"/>
                      <a:pt x="88" y="32"/>
                      <a:pt x="89" y="32"/>
                    </a:cubicBezTo>
                    <a:cubicBezTo>
                      <a:pt x="90" y="31"/>
                      <a:pt x="90" y="31"/>
                      <a:pt x="89" y="29"/>
                    </a:cubicBezTo>
                    <a:cubicBezTo>
                      <a:pt x="88" y="28"/>
                      <a:pt x="88" y="25"/>
                      <a:pt x="87" y="25"/>
                    </a:cubicBezTo>
                    <a:cubicBezTo>
                      <a:pt x="87" y="24"/>
                      <a:pt x="90" y="24"/>
                      <a:pt x="92" y="25"/>
                    </a:cubicBezTo>
                    <a:cubicBezTo>
                      <a:pt x="93" y="26"/>
                      <a:pt x="94" y="27"/>
                      <a:pt x="95" y="25"/>
                    </a:cubicBezTo>
                    <a:cubicBezTo>
                      <a:pt x="95" y="25"/>
                      <a:pt x="94" y="24"/>
                      <a:pt x="93" y="23"/>
                    </a:cubicBezTo>
                    <a:cubicBezTo>
                      <a:pt x="91" y="20"/>
                      <a:pt x="87" y="16"/>
                      <a:pt x="85" y="15"/>
                    </a:cubicBezTo>
                    <a:cubicBezTo>
                      <a:pt x="82" y="13"/>
                      <a:pt x="78" y="11"/>
                      <a:pt x="72" y="10"/>
                    </a:cubicBezTo>
                    <a:cubicBezTo>
                      <a:pt x="57" y="10"/>
                      <a:pt x="42" y="9"/>
                      <a:pt x="35" y="9"/>
                    </a:cubicBezTo>
                    <a:cubicBezTo>
                      <a:pt x="29" y="9"/>
                      <a:pt x="14" y="5"/>
                      <a:pt x="0" y="0"/>
                    </a:cubicBezTo>
                    <a:close/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0" name="Freeform 117"/>
              <p:cNvSpPr/>
              <p:nvPr/>
            </p:nvSpPr>
            <p:spPr>
              <a:xfrm>
                <a:off x="3105" y="2529"/>
                <a:ext cx="70" cy="35"/>
              </a:xfrm>
              <a:custGeom>
                <a:avLst/>
                <a:gdLst/>
                <a:ahLst/>
                <a:cxnLst>
                  <a:cxn ang="0">
                    <a:pos x="1095" y="681"/>
                  </a:cxn>
                  <a:cxn ang="0">
                    <a:pos x="675" y="253"/>
                  </a:cxn>
                  <a:cxn ang="0">
                    <a:pos x="0" y="0"/>
                  </a:cxn>
                </a:cxnLst>
                <a:pathLst>
                  <a:path w="28" h="13">
                    <a:moveTo>
                      <a:pt x="28" y="13"/>
                    </a:moveTo>
                    <a:cubicBezTo>
                      <a:pt x="25" y="9"/>
                      <a:pt x="20" y="6"/>
                      <a:pt x="17" y="5"/>
                    </a:cubicBezTo>
                    <a:cubicBezTo>
                      <a:pt x="14" y="5"/>
                      <a:pt x="0" y="0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1" name="Freeform 118"/>
              <p:cNvSpPr/>
              <p:nvPr/>
            </p:nvSpPr>
            <p:spPr>
              <a:xfrm>
                <a:off x="3105" y="2543"/>
                <a:ext cx="30" cy="24"/>
              </a:xfrm>
              <a:custGeom>
                <a:avLst/>
                <a:gdLst/>
                <a:ahLst/>
                <a:cxnLst>
                  <a:cxn ang="0">
                    <a:pos x="470" y="456"/>
                  </a:cxn>
                  <a:cxn ang="0">
                    <a:pos x="0" y="0"/>
                  </a:cxn>
                </a:cxnLst>
                <a:pathLst>
                  <a:path w="12" h="9">
                    <a:moveTo>
                      <a:pt x="12" y="9"/>
                    </a:moveTo>
                    <a:cubicBezTo>
                      <a:pt x="10" y="7"/>
                      <a:pt x="2" y="1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2" name="Freeform 119"/>
              <p:cNvSpPr/>
              <p:nvPr/>
            </p:nvSpPr>
            <p:spPr>
              <a:xfrm>
                <a:off x="3097" y="2431"/>
                <a:ext cx="40" cy="56"/>
              </a:xfrm>
              <a:custGeom>
                <a:avLst/>
                <a:gdLst/>
                <a:ahLst/>
                <a:cxnLst>
                  <a:cxn ang="0">
                    <a:pos x="625" y="1059"/>
                  </a:cxn>
                  <a:cxn ang="0">
                    <a:pos x="395" y="363"/>
                  </a:cxn>
                  <a:cxn ang="0">
                    <a:pos x="0" y="0"/>
                  </a:cxn>
                </a:cxnLst>
                <a:pathLst>
                  <a:path w="16" h="21">
                    <a:moveTo>
                      <a:pt x="16" y="21"/>
                    </a:moveTo>
                    <a:cubicBezTo>
                      <a:pt x="14" y="16"/>
                      <a:pt x="13" y="11"/>
                      <a:pt x="10" y="7"/>
                    </a:cubicBezTo>
                    <a:cubicBezTo>
                      <a:pt x="6" y="3"/>
                      <a:pt x="1" y="0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3" name="Freeform 120"/>
              <p:cNvSpPr/>
              <p:nvPr/>
            </p:nvSpPr>
            <p:spPr>
              <a:xfrm>
                <a:off x="3132" y="2439"/>
                <a:ext cx="28" cy="26"/>
              </a:xfrm>
              <a:custGeom>
                <a:avLst/>
                <a:gdLst/>
                <a:ahLst/>
                <a:cxnLst>
                  <a:cxn ang="0">
                    <a:pos x="461" y="460"/>
                  </a:cxn>
                  <a:cxn ang="0">
                    <a:pos x="0" y="0"/>
                  </a:cxn>
                </a:cxnLst>
                <a:pathLst>
                  <a:path w="11" h="10">
                    <a:moveTo>
                      <a:pt x="11" y="10"/>
                    </a:moveTo>
                    <a:cubicBezTo>
                      <a:pt x="9" y="8"/>
                      <a:pt x="4" y="1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4" name="Freeform 121"/>
              <p:cNvSpPr/>
              <p:nvPr/>
            </p:nvSpPr>
            <p:spPr>
              <a:xfrm>
                <a:off x="3055" y="2380"/>
                <a:ext cx="27" cy="99"/>
              </a:xfrm>
              <a:custGeom>
                <a:avLst/>
                <a:gdLst/>
                <a:ahLst/>
                <a:cxnLst>
                  <a:cxn ang="0">
                    <a:pos x="326" y="1897"/>
                  </a:cxn>
                  <a:cxn ang="0">
                    <a:pos x="398" y="0"/>
                  </a:cxn>
                </a:cxnLst>
                <a:pathLst>
                  <a:path w="11" h="37">
                    <a:moveTo>
                      <a:pt x="9" y="37"/>
                    </a:moveTo>
                    <a:cubicBezTo>
                      <a:pt x="3" y="31"/>
                      <a:pt x="0" y="25"/>
                      <a:pt x="11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5" name="Freeform 122"/>
              <p:cNvSpPr/>
              <p:nvPr/>
            </p:nvSpPr>
            <p:spPr>
              <a:xfrm>
                <a:off x="3130" y="2527"/>
                <a:ext cx="25" cy="1"/>
              </a:xfrm>
              <a:custGeom>
                <a:avLst/>
                <a:gdLst/>
                <a:ahLst/>
                <a:cxnLst>
                  <a:cxn ang="0">
                    <a:pos x="395" y="0"/>
                  </a:cxn>
                  <a:cxn ang="0">
                    <a:pos x="0" y="0"/>
                  </a:cxn>
                </a:cxnLst>
                <a:pathLst>
                  <a:path w="10" h="1">
                    <a:moveTo>
                      <a:pt x="10" y="0"/>
                    </a:moveTo>
                    <a:cubicBezTo>
                      <a:pt x="7" y="0"/>
                      <a:pt x="1" y="0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6" name="Freeform 123"/>
              <p:cNvSpPr/>
              <p:nvPr/>
            </p:nvSpPr>
            <p:spPr>
              <a:xfrm>
                <a:off x="3125" y="1879"/>
                <a:ext cx="2" cy="21"/>
              </a:xfrm>
              <a:custGeom>
                <a:avLst/>
                <a:gdLst/>
                <a:ahLst/>
                <a:cxnLst>
                  <a:cxn ang="0">
                    <a:pos x="16" y="0"/>
                  </a:cxn>
                  <a:cxn ang="0">
                    <a:pos x="0" y="378"/>
                  </a:cxn>
                </a:cxnLst>
                <a:pathLst>
                  <a:path w="1" h="8">
                    <a:moveTo>
                      <a:pt x="1" y="0"/>
                    </a:moveTo>
                    <a:cubicBezTo>
                      <a:pt x="1" y="3"/>
                      <a:pt x="1" y="5"/>
                      <a:pt x="0" y="8"/>
                    </a:cubicBezTo>
                  </a:path>
                </a:pathLst>
              </a:custGeom>
              <a:noFill/>
              <a:ln w="7938" cap="rnd" cmpd="sng">
                <a:solidFill>
                  <a:srgbClr val="3333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7" name="Oval 124"/>
              <p:cNvSpPr/>
              <p:nvPr/>
            </p:nvSpPr>
            <p:spPr>
              <a:xfrm>
                <a:off x="3235" y="2167"/>
                <a:ext cx="12" cy="13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p>
                <a:endParaRPr lang="zh-CN" altLang="x-none" sz="100">
                  <a:latin typeface="Arial" panose="020B0604020202020204" pitchFamily="34" charset="0"/>
                  <a:ea typeface="华文楷体" panose="02010600040101010101" charset="-122"/>
                </a:endParaRPr>
              </a:p>
            </p:txBody>
          </p:sp>
          <p:sp>
            <p:nvSpPr>
              <p:cNvPr id="2108" name="Freeform 125"/>
              <p:cNvSpPr/>
              <p:nvPr/>
            </p:nvSpPr>
            <p:spPr>
              <a:xfrm>
                <a:off x="3120" y="1964"/>
                <a:ext cx="22" cy="21"/>
              </a:xfrm>
              <a:custGeom>
                <a:avLst/>
                <a:gdLst/>
                <a:ahLst/>
                <a:cxnLst>
                  <a:cxn ang="0">
                    <a:pos x="71" y="378"/>
                  </a:cxn>
                  <a:cxn ang="0">
                    <a:pos x="323" y="89"/>
                  </a:cxn>
                  <a:cxn ang="0">
                    <a:pos x="0" y="200"/>
                  </a:cxn>
                </a:cxnLst>
                <a:pathLst>
                  <a:path w="9" h="8">
                    <a:moveTo>
                      <a:pt x="2" y="8"/>
                    </a:moveTo>
                    <a:cubicBezTo>
                      <a:pt x="5" y="7"/>
                      <a:pt x="9" y="6"/>
                      <a:pt x="9" y="2"/>
                    </a:cubicBezTo>
                    <a:cubicBezTo>
                      <a:pt x="6" y="0"/>
                      <a:pt x="2" y="2"/>
                      <a:pt x="0" y="4"/>
                    </a:cubicBezTo>
                  </a:path>
                </a:pathLst>
              </a:custGeom>
              <a:noFill/>
              <a:ln w="15875" cap="flat" cmpd="sng">
                <a:solidFill>
                  <a:srgbClr val="E6E6E6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09" name="Freeform 126"/>
              <p:cNvSpPr/>
              <p:nvPr/>
            </p:nvSpPr>
            <p:spPr>
              <a:xfrm>
                <a:off x="3075" y="2113"/>
                <a:ext cx="7" cy="11"/>
              </a:xfrm>
              <a:custGeom>
                <a:avLst/>
                <a:gdLst/>
                <a:ahLst/>
                <a:cxnLst>
                  <a:cxn ang="0">
                    <a:pos x="28" y="228"/>
                  </a:cxn>
                  <a:cxn ang="0">
                    <a:pos x="86" y="0"/>
                  </a:cxn>
                </a:cxnLst>
                <a:pathLst>
                  <a:path w="3" h="4">
                    <a:moveTo>
                      <a:pt x="1" y="4"/>
                    </a:moveTo>
                    <a:cubicBezTo>
                      <a:pt x="0" y="4"/>
                      <a:pt x="3" y="1"/>
                      <a:pt x="3" y="0"/>
                    </a:cubicBezTo>
                  </a:path>
                </a:pathLst>
              </a:custGeom>
              <a:noFill/>
              <a:ln w="15875" cap="flat" cmpd="sng">
                <a:solidFill>
                  <a:srgbClr val="E6E6E6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0" name="Freeform 127"/>
              <p:cNvSpPr/>
              <p:nvPr/>
            </p:nvSpPr>
            <p:spPr>
              <a:xfrm>
                <a:off x="3090" y="1996"/>
                <a:ext cx="2" cy="11"/>
              </a:xfrm>
              <a:custGeom>
                <a:avLst/>
                <a:gdLst/>
                <a:ahLst/>
                <a:cxnLst>
                  <a:cxn ang="0">
                    <a:pos x="16" y="228"/>
                  </a:cxn>
                  <a:cxn ang="0">
                    <a:pos x="0" y="0"/>
                  </a:cxn>
                </a:cxnLst>
                <a:pathLst>
                  <a:path w="1" h="4">
                    <a:moveTo>
                      <a:pt x="1" y="4"/>
                    </a:moveTo>
                    <a:cubicBezTo>
                      <a:pt x="1" y="3"/>
                      <a:pt x="0" y="2"/>
                      <a:pt x="0" y="0"/>
                    </a:cubicBezTo>
                  </a:path>
                </a:pathLst>
              </a:custGeom>
              <a:noFill/>
              <a:ln w="15875" cap="flat" cmpd="sng">
                <a:solidFill>
                  <a:srgbClr val="E6E6E6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1" name="Freeform 128"/>
              <p:cNvSpPr/>
              <p:nvPr/>
            </p:nvSpPr>
            <p:spPr>
              <a:xfrm>
                <a:off x="3107" y="2540"/>
                <a:ext cx="8" cy="11"/>
              </a:xfrm>
              <a:custGeom>
                <a:avLst/>
                <a:gdLst/>
                <a:ahLst/>
                <a:cxnLst>
                  <a:cxn ang="0">
                    <a:pos x="149" y="0"/>
                  </a:cxn>
                  <a:cxn ang="0">
                    <a:pos x="0" y="228"/>
                  </a:cxn>
                </a:cxnLst>
                <a:pathLst>
                  <a:path w="3" h="4">
                    <a:moveTo>
                      <a:pt x="3" y="0"/>
                    </a:moveTo>
                    <a:cubicBezTo>
                      <a:pt x="2" y="2"/>
                      <a:pt x="1" y="3"/>
                      <a:pt x="0" y="4"/>
                    </a:cubicBezTo>
                  </a:path>
                </a:pathLst>
              </a:custGeom>
              <a:noFill/>
              <a:ln w="15875" cap="flat" cmpd="sng">
                <a:solidFill>
                  <a:srgbClr val="CCCCCC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2" name="Freeform 129"/>
              <p:cNvSpPr/>
              <p:nvPr/>
            </p:nvSpPr>
            <p:spPr>
              <a:xfrm>
                <a:off x="3100" y="2431"/>
                <a:ext cx="7" cy="10"/>
              </a:xfrm>
              <a:custGeom>
                <a:avLst/>
                <a:gdLst/>
                <a:ahLst/>
                <a:cxnLst>
                  <a:cxn ang="0">
                    <a:pos x="0" y="158"/>
                  </a:cxn>
                  <a:cxn ang="0">
                    <a:pos x="86" y="0"/>
                  </a:cxn>
                </a:cxnLst>
                <a:pathLst>
                  <a:path w="3" h="4">
                    <a:moveTo>
                      <a:pt x="0" y="4"/>
                    </a:moveTo>
                    <a:cubicBezTo>
                      <a:pt x="2" y="3"/>
                      <a:pt x="3" y="2"/>
                      <a:pt x="3" y="0"/>
                    </a:cubicBezTo>
                  </a:path>
                </a:pathLst>
              </a:custGeom>
              <a:noFill/>
              <a:ln w="15875" cap="flat" cmpd="sng">
                <a:solidFill>
                  <a:srgbClr val="CCCCCC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3" name="Freeform 130"/>
              <p:cNvSpPr/>
              <p:nvPr/>
            </p:nvSpPr>
            <p:spPr>
              <a:xfrm>
                <a:off x="3115" y="2447"/>
                <a:ext cx="10" cy="8"/>
              </a:xfrm>
              <a:custGeom>
                <a:avLst/>
                <a:gdLst/>
                <a:ahLst/>
                <a:cxnLst>
                  <a:cxn ang="0">
                    <a:pos x="0" y="149"/>
                  </a:cxn>
                  <a:cxn ang="0">
                    <a:pos x="158" y="0"/>
                  </a:cxn>
                </a:cxnLst>
                <a:pathLst>
                  <a:path w="4" h="3">
                    <a:moveTo>
                      <a:pt x="0" y="3"/>
                    </a:moveTo>
                    <a:cubicBezTo>
                      <a:pt x="1" y="2"/>
                      <a:pt x="3" y="1"/>
                      <a:pt x="4" y="0"/>
                    </a:cubicBezTo>
                  </a:path>
                </a:pathLst>
              </a:custGeom>
              <a:noFill/>
              <a:ln w="15875" cap="flat" cmpd="sng">
                <a:solidFill>
                  <a:srgbClr val="CCCCCC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</p:grpSp>
        <p:grpSp>
          <p:nvGrpSpPr>
            <p:cNvPr id="2114" name="Group 3"/>
            <p:cNvGrpSpPr/>
            <p:nvPr/>
          </p:nvGrpSpPr>
          <p:grpSpPr>
            <a:xfrm rot="3600000">
              <a:off x="3713" y="2122"/>
              <a:ext cx="557" cy="1016"/>
              <a:chOff x="814" y="1146"/>
              <a:chExt cx="1063" cy="2525"/>
            </a:xfrm>
          </p:grpSpPr>
          <p:sp>
            <p:nvSpPr>
              <p:cNvPr id="2115" name="Freeform 4"/>
              <p:cNvSpPr/>
              <p:nvPr/>
            </p:nvSpPr>
            <p:spPr>
              <a:xfrm>
                <a:off x="814" y="1147"/>
                <a:ext cx="1012" cy="2524"/>
              </a:xfrm>
              <a:custGeom>
                <a:avLst/>
                <a:gdLst/>
                <a:ahLst/>
                <a:cxnLst>
                  <a:cxn ang="0">
                    <a:pos x="680" y="28"/>
                  </a:cxn>
                  <a:cxn ang="0">
                    <a:pos x="562" y="510"/>
                  </a:cxn>
                  <a:cxn ang="0">
                    <a:pos x="647" y="3046"/>
                  </a:cxn>
                  <a:cxn ang="0">
                    <a:pos x="779" y="3667"/>
                  </a:cxn>
                  <a:cxn ang="0">
                    <a:pos x="909" y="3661"/>
                  </a:cxn>
                  <a:cxn ang="0">
                    <a:pos x="975" y="3079"/>
                  </a:cxn>
                  <a:cxn ang="0">
                    <a:pos x="953" y="513"/>
                  </a:cxn>
                  <a:cxn ang="0">
                    <a:pos x="832" y="23"/>
                  </a:cxn>
                  <a:cxn ang="0">
                    <a:pos x="680" y="28"/>
                  </a:cxn>
                </a:cxnLst>
                <a:pathLst>
                  <a:path w="828" h="2082">
                    <a:moveTo>
                      <a:pt x="372" y="16"/>
                    </a:moveTo>
                    <a:cubicBezTo>
                      <a:pt x="372" y="16"/>
                      <a:pt x="366" y="152"/>
                      <a:pt x="308" y="286"/>
                    </a:cubicBezTo>
                    <a:cubicBezTo>
                      <a:pt x="230" y="468"/>
                      <a:pt x="0" y="1134"/>
                      <a:pt x="354" y="1710"/>
                    </a:cubicBezTo>
                    <a:cubicBezTo>
                      <a:pt x="444" y="1857"/>
                      <a:pt x="426" y="2058"/>
                      <a:pt x="426" y="2058"/>
                    </a:cubicBezTo>
                    <a:cubicBezTo>
                      <a:pt x="426" y="2058"/>
                      <a:pt x="462" y="2082"/>
                      <a:pt x="498" y="2055"/>
                    </a:cubicBezTo>
                    <a:cubicBezTo>
                      <a:pt x="498" y="2055"/>
                      <a:pt x="478" y="1832"/>
                      <a:pt x="534" y="1728"/>
                    </a:cubicBezTo>
                    <a:cubicBezTo>
                      <a:pt x="615" y="1579"/>
                      <a:pt x="828" y="962"/>
                      <a:pt x="522" y="288"/>
                    </a:cubicBezTo>
                    <a:cubicBezTo>
                      <a:pt x="468" y="170"/>
                      <a:pt x="464" y="63"/>
                      <a:pt x="456" y="13"/>
                    </a:cubicBezTo>
                    <a:cubicBezTo>
                      <a:pt x="456" y="13"/>
                      <a:pt x="423" y="0"/>
                      <a:pt x="372" y="16"/>
                    </a:cubicBezTo>
                    <a:close/>
                  </a:path>
                </a:pathLst>
              </a:custGeom>
              <a:solidFill>
                <a:srgbClr val="ED9978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6" name="Freeform 5"/>
              <p:cNvSpPr/>
              <p:nvPr/>
            </p:nvSpPr>
            <p:spPr>
              <a:xfrm>
                <a:off x="864" y="1540"/>
                <a:ext cx="442" cy="1719"/>
              </a:xfrm>
              <a:custGeom>
                <a:avLst/>
                <a:gdLst/>
                <a:ahLst/>
                <a:cxnLst>
                  <a:cxn ang="0">
                    <a:pos x="521" y="0"/>
                  </a:cxn>
                  <a:cxn ang="0">
                    <a:pos x="659" y="2526"/>
                  </a:cxn>
                  <a:cxn ang="0">
                    <a:pos x="521" y="0"/>
                  </a:cxn>
                </a:cxnLst>
                <a:pathLst>
                  <a:path w="362" h="1418">
                    <a:moveTo>
                      <a:pt x="287" y="0"/>
                    </a:moveTo>
                    <a:cubicBezTo>
                      <a:pt x="287" y="0"/>
                      <a:pt x="0" y="810"/>
                      <a:pt x="362" y="1418"/>
                    </a:cubicBezTo>
                    <a:cubicBezTo>
                      <a:pt x="362" y="1418"/>
                      <a:pt x="69" y="782"/>
                      <a:pt x="287" y="0"/>
                    </a:cubicBezTo>
                    <a:close/>
                  </a:path>
                </a:pathLst>
              </a:custGeom>
              <a:solidFill>
                <a:srgbClr val="DD7F5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7" name="Freeform 6"/>
              <p:cNvSpPr/>
              <p:nvPr/>
            </p:nvSpPr>
            <p:spPr>
              <a:xfrm>
                <a:off x="1337" y="1511"/>
                <a:ext cx="154" cy="1796"/>
              </a:xfrm>
              <a:custGeom>
                <a:avLst/>
                <a:gdLst/>
                <a:ahLst/>
                <a:cxnLst>
                  <a:cxn ang="0">
                    <a:pos x="33" y="2638"/>
                  </a:cxn>
                  <a:cxn ang="0">
                    <a:pos x="0" y="0"/>
                  </a:cxn>
                  <a:cxn ang="0">
                    <a:pos x="33" y="2638"/>
                  </a:cxn>
                </a:cxnLst>
                <a:pathLst>
                  <a:path w="126" h="1482">
                    <a:moveTo>
                      <a:pt x="18" y="1482"/>
                    </a:moveTo>
                    <a:cubicBezTo>
                      <a:pt x="18" y="1482"/>
                      <a:pt x="126" y="566"/>
                      <a:pt x="0" y="0"/>
                    </a:cubicBezTo>
                    <a:cubicBezTo>
                      <a:pt x="0" y="0"/>
                      <a:pt x="49" y="73"/>
                      <a:pt x="18" y="1482"/>
                    </a:cubicBezTo>
                    <a:close/>
                  </a:path>
                </a:pathLst>
              </a:custGeom>
              <a:solidFill>
                <a:srgbClr val="DD7F5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8" name="Freeform 7"/>
              <p:cNvSpPr/>
              <p:nvPr/>
            </p:nvSpPr>
            <p:spPr>
              <a:xfrm>
                <a:off x="1436" y="1557"/>
                <a:ext cx="441" cy="167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4" y="2461"/>
                  </a:cxn>
                  <a:cxn ang="0">
                    <a:pos x="0" y="0"/>
                  </a:cxn>
                </a:cxnLst>
                <a:pathLst>
                  <a:path w="361" h="1383">
                    <a:moveTo>
                      <a:pt x="0" y="0"/>
                    </a:moveTo>
                    <a:cubicBezTo>
                      <a:pt x="0" y="0"/>
                      <a:pt x="361" y="646"/>
                      <a:pt x="13" y="1383"/>
                    </a:cubicBezTo>
                    <a:cubicBezTo>
                      <a:pt x="13" y="1383"/>
                      <a:pt x="301" y="807"/>
                      <a:pt x="0" y="0"/>
                    </a:cubicBezTo>
                    <a:close/>
                  </a:path>
                </a:pathLst>
              </a:custGeom>
              <a:solidFill>
                <a:srgbClr val="DD7F5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19" name="Freeform 8"/>
              <p:cNvSpPr/>
              <p:nvPr/>
            </p:nvSpPr>
            <p:spPr>
              <a:xfrm>
                <a:off x="1445" y="1738"/>
                <a:ext cx="215" cy="135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989"/>
                  </a:cxn>
                  <a:cxn ang="0">
                    <a:pos x="0" y="0"/>
                  </a:cxn>
                </a:cxnLst>
                <a:pathLst>
                  <a:path w="176" h="1117">
                    <a:moveTo>
                      <a:pt x="0" y="0"/>
                    </a:moveTo>
                    <a:cubicBezTo>
                      <a:pt x="0" y="0"/>
                      <a:pt x="176" y="365"/>
                      <a:pt x="0" y="1117"/>
                    </a:cubicBezTo>
                    <a:cubicBezTo>
                      <a:pt x="0" y="1117"/>
                      <a:pt x="111" y="332"/>
                      <a:pt x="0" y="0"/>
                    </a:cubicBezTo>
                    <a:close/>
                  </a:path>
                </a:pathLst>
              </a:custGeom>
              <a:solidFill>
                <a:srgbClr val="DD7F5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0" name="Freeform 9"/>
              <p:cNvSpPr/>
              <p:nvPr/>
            </p:nvSpPr>
            <p:spPr>
              <a:xfrm>
                <a:off x="1081" y="1662"/>
                <a:ext cx="216" cy="1455"/>
              </a:xfrm>
              <a:custGeom>
                <a:avLst/>
                <a:gdLst/>
                <a:ahLst/>
                <a:cxnLst>
                  <a:cxn ang="0">
                    <a:pos x="258" y="0"/>
                  </a:cxn>
                  <a:cxn ang="0">
                    <a:pos x="325" y="2139"/>
                  </a:cxn>
                  <a:cxn ang="0">
                    <a:pos x="258" y="0"/>
                  </a:cxn>
                </a:cxnLst>
                <a:pathLst>
                  <a:path w="176" h="1200">
                    <a:moveTo>
                      <a:pt x="139" y="0"/>
                    </a:moveTo>
                    <a:cubicBezTo>
                      <a:pt x="139" y="0"/>
                      <a:pt x="47" y="469"/>
                      <a:pt x="176" y="1200"/>
                    </a:cubicBezTo>
                    <a:cubicBezTo>
                      <a:pt x="176" y="1200"/>
                      <a:pt x="0" y="521"/>
                      <a:pt x="139" y="0"/>
                    </a:cubicBezTo>
                  </a:path>
                </a:pathLst>
              </a:custGeom>
              <a:solidFill>
                <a:srgbClr val="DD7F5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1" name="Freeform 10"/>
              <p:cNvSpPr/>
              <p:nvPr/>
            </p:nvSpPr>
            <p:spPr>
              <a:xfrm>
                <a:off x="1232" y="1812"/>
                <a:ext cx="76" cy="1076"/>
              </a:xfrm>
              <a:custGeom>
                <a:avLst/>
                <a:gdLst/>
                <a:ahLst/>
                <a:cxnLst>
                  <a:cxn ang="0">
                    <a:pos x="92" y="0"/>
                  </a:cxn>
                  <a:cxn ang="0">
                    <a:pos x="114" y="1580"/>
                  </a:cxn>
                  <a:cxn ang="0">
                    <a:pos x="92" y="0"/>
                  </a:cxn>
                </a:cxnLst>
                <a:pathLst>
                  <a:path w="62" h="888">
                    <a:moveTo>
                      <a:pt x="50" y="0"/>
                    </a:moveTo>
                    <a:cubicBezTo>
                      <a:pt x="50" y="0"/>
                      <a:pt x="0" y="256"/>
                      <a:pt x="62" y="888"/>
                    </a:cubicBezTo>
                    <a:cubicBezTo>
                      <a:pt x="62" y="888"/>
                      <a:pt x="60" y="242"/>
                      <a:pt x="50" y="0"/>
                    </a:cubicBezTo>
                    <a:close/>
                  </a:path>
                </a:pathLst>
              </a:custGeom>
              <a:solidFill>
                <a:srgbClr val="DD7F5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2" name="Freeform 11"/>
              <p:cNvSpPr/>
              <p:nvPr/>
            </p:nvSpPr>
            <p:spPr>
              <a:xfrm>
                <a:off x="1233" y="1146"/>
                <a:ext cx="157" cy="285"/>
              </a:xfrm>
              <a:custGeom>
                <a:avLst/>
                <a:gdLst/>
                <a:ahLst/>
                <a:cxnLst>
                  <a:cxn ang="0">
                    <a:pos x="55" y="28"/>
                  </a:cxn>
                  <a:cxn ang="0">
                    <a:pos x="39" y="159"/>
                  </a:cxn>
                  <a:cxn ang="0">
                    <a:pos x="20" y="284"/>
                  </a:cxn>
                  <a:cxn ang="0">
                    <a:pos x="18" y="417"/>
                  </a:cxn>
                  <a:cxn ang="0">
                    <a:pos x="66" y="320"/>
                  </a:cxn>
                  <a:cxn ang="0">
                    <a:pos x="107" y="228"/>
                  </a:cxn>
                  <a:cxn ang="0">
                    <a:pos x="152" y="392"/>
                  </a:cxn>
                  <a:cxn ang="0">
                    <a:pos x="164" y="320"/>
                  </a:cxn>
                  <a:cxn ang="0">
                    <a:pos x="164" y="233"/>
                  </a:cxn>
                  <a:cxn ang="0">
                    <a:pos x="173" y="126"/>
                  </a:cxn>
                  <a:cxn ang="0">
                    <a:pos x="213" y="258"/>
                  </a:cxn>
                  <a:cxn ang="0">
                    <a:pos x="218" y="169"/>
                  </a:cxn>
                  <a:cxn ang="0">
                    <a:pos x="213" y="99"/>
                  </a:cxn>
                  <a:cxn ang="0">
                    <a:pos x="209" y="49"/>
                  </a:cxn>
                  <a:cxn ang="0">
                    <a:pos x="206" y="25"/>
                  </a:cxn>
                  <a:cxn ang="0">
                    <a:pos x="55" y="27"/>
                  </a:cxn>
                </a:cxnLst>
                <a:pathLst>
                  <a:path w="128" h="235">
                    <a:moveTo>
                      <a:pt x="30" y="16"/>
                    </a:moveTo>
                    <a:cubicBezTo>
                      <a:pt x="30" y="41"/>
                      <a:pt x="24" y="64"/>
                      <a:pt x="21" y="89"/>
                    </a:cubicBezTo>
                    <a:cubicBezTo>
                      <a:pt x="19" y="113"/>
                      <a:pt x="16" y="136"/>
                      <a:pt x="11" y="159"/>
                    </a:cubicBezTo>
                    <a:cubicBezTo>
                      <a:pt x="9" y="169"/>
                      <a:pt x="0" y="233"/>
                      <a:pt x="10" y="234"/>
                    </a:cubicBezTo>
                    <a:cubicBezTo>
                      <a:pt x="18" y="235"/>
                      <a:pt x="33" y="187"/>
                      <a:pt x="36" y="180"/>
                    </a:cubicBezTo>
                    <a:cubicBezTo>
                      <a:pt x="42" y="164"/>
                      <a:pt x="47" y="142"/>
                      <a:pt x="58" y="128"/>
                    </a:cubicBezTo>
                    <a:cubicBezTo>
                      <a:pt x="65" y="132"/>
                      <a:pt x="64" y="233"/>
                      <a:pt x="82" y="219"/>
                    </a:cubicBezTo>
                    <a:cubicBezTo>
                      <a:pt x="89" y="213"/>
                      <a:pt x="88" y="188"/>
                      <a:pt x="89" y="180"/>
                    </a:cubicBezTo>
                    <a:cubicBezTo>
                      <a:pt x="90" y="164"/>
                      <a:pt x="89" y="147"/>
                      <a:pt x="89" y="130"/>
                    </a:cubicBezTo>
                    <a:cubicBezTo>
                      <a:pt x="89" y="114"/>
                      <a:pt x="85" y="85"/>
                      <a:pt x="94" y="71"/>
                    </a:cubicBezTo>
                    <a:cubicBezTo>
                      <a:pt x="104" y="90"/>
                      <a:pt x="93" y="133"/>
                      <a:pt x="116" y="145"/>
                    </a:cubicBezTo>
                    <a:cubicBezTo>
                      <a:pt x="128" y="137"/>
                      <a:pt x="120" y="107"/>
                      <a:pt x="118" y="95"/>
                    </a:cubicBezTo>
                    <a:cubicBezTo>
                      <a:pt x="116" y="83"/>
                      <a:pt x="117" y="69"/>
                      <a:pt x="116" y="56"/>
                    </a:cubicBezTo>
                    <a:cubicBezTo>
                      <a:pt x="115" y="47"/>
                      <a:pt x="114" y="35"/>
                      <a:pt x="113" y="27"/>
                    </a:cubicBezTo>
                    <a:cubicBezTo>
                      <a:pt x="112" y="20"/>
                      <a:pt x="114" y="20"/>
                      <a:pt x="112" y="14"/>
                    </a:cubicBezTo>
                    <a:cubicBezTo>
                      <a:pt x="107" y="0"/>
                      <a:pt x="38" y="2"/>
                      <a:pt x="30" y="15"/>
                    </a:cubicBezTo>
                  </a:path>
                </a:pathLst>
              </a:custGeom>
              <a:solidFill>
                <a:srgbClr val="F0E6E4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3" name="Freeform 12"/>
              <p:cNvSpPr/>
              <p:nvPr/>
            </p:nvSpPr>
            <p:spPr>
              <a:xfrm>
                <a:off x="1327" y="3349"/>
                <a:ext cx="94" cy="315"/>
              </a:xfrm>
              <a:custGeom>
                <a:avLst/>
                <a:gdLst/>
                <a:ahLst/>
                <a:cxnLst>
                  <a:cxn ang="0">
                    <a:pos x="11" y="431"/>
                  </a:cxn>
                  <a:cxn ang="0">
                    <a:pos x="13" y="285"/>
                  </a:cxn>
                  <a:cxn ang="0">
                    <a:pos x="1" y="137"/>
                  </a:cxn>
                  <a:cxn ang="0">
                    <a:pos x="32" y="251"/>
                  </a:cxn>
                  <a:cxn ang="0">
                    <a:pos x="60" y="380"/>
                  </a:cxn>
                  <a:cxn ang="0">
                    <a:pos x="56" y="296"/>
                  </a:cxn>
                  <a:cxn ang="0">
                    <a:pos x="46" y="166"/>
                  </a:cxn>
                  <a:cxn ang="0">
                    <a:pos x="48" y="0"/>
                  </a:cxn>
                  <a:cxn ang="0">
                    <a:pos x="72" y="125"/>
                  </a:cxn>
                  <a:cxn ang="0">
                    <a:pos x="89" y="262"/>
                  </a:cxn>
                  <a:cxn ang="0">
                    <a:pos x="107" y="160"/>
                  </a:cxn>
                  <a:cxn ang="0">
                    <a:pos x="133" y="303"/>
                  </a:cxn>
                  <a:cxn ang="0">
                    <a:pos x="140" y="430"/>
                  </a:cxn>
                  <a:cxn ang="0">
                    <a:pos x="11" y="430"/>
                  </a:cxn>
                </a:cxnLst>
                <a:pathLst>
                  <a:path w="77" h="260">
                    <a:moveTo>
                      <a:pt x="6" y="243"/>
                    </a:moveTo>
                    <a:cubicBezTo>
                      <a:pt x="10" y="215"/>
                      <a:pt x="7" y="182"/>
                      <a:pt x="7" y="160"/>
                    </a:cubicBezTo>
                    <a:cubicBezTo>
                      <a:pt x="7" y="132"/>
                      <a:pt x="0" y="105"/>
                      <a:pt x="1" y="77"/>
                    </a:cubicBezTo>
                    <a:cubicBezTo>
                      <a:pt x="15" y="78"/>
                      <a:pt x="15" y="130"/>
                      <a:pt x="17" y="141"/>
                    </a:cubicBezTo>
                    <a:cubicBezTo>
                      <a:pt x="19" y="158"/>
                      <a:pt x="16" y="205"/>
                      <a:pt x="33" y="214"/>
                    </a:cubicBezTo>
                    <a:cubicBezTo>
                      <a:pt x="39" y="202"/>
                      <a:pt x="32" y="180"/>
                      <a:pt x="31" y="166"/>
                    </a:cubicBezTo>
                    <a:cubicBezTo>
                      <a:pt x="29" y="142"/>
                      <a:pt x="27" y="118"/>
                      <a:pt x="25" y="93"/>
                    </a:cubicBezTo>
                    <a:cubicBezTo>
                      <a:pt x="23" y="62"/>
                      <a:pt x="25" y="31"/>
                      <a:pt x="26" y="0"/>
                    </a:cubicBezTo>
                    <a:cubicBezTo>
                      <a:pt x="37" y="16"/>
                      <a:pt x="37" y="50"/>
                      <a:pt x="39" y="70"/>
                    </a:cubicBezTo>
                    <a:cubicBezTo>
                      <a:pt x="42" y="96"/>
                      <a:pt x="44" y="122"/>
                      <a:pt x="49" y="147"/>
                    </a:cubicBezTo>
                    <a:cubicBezTo>
                      <a:pt x="53" y="135"/>
                      <a:pt x="49" y="94"/>
                      <a:pt x="59" y="90"/>
                    </a:cubicBezTo>
                    <a:cubicBezTo>
                      <a:pt x="60" y="103"/>
                      <a:pt x="59" y="165"/>
                      <a:pt x="73" y="170"/>
                    </a:cubicBezTo>
                    <a:cubicBezTo>
                      <a:pt x="75" y="194"/>
                      <a:pt x="77" y="219"/>
                      <a:pt x="77" y="242"/>
                    </a:cubicBezTo>
                    <a:cubicBezTo>
                      <a:pt x="65" y="249"/>
                      <a:pt x="35" y="260"/>
                      <a:pt x="6" y="242"/>
                    </a:cubicBezTo>
                  </a:path>
                </a:pathLst>
              </a:custGeom>
              <a:solidFill>
                <a:srgbClr val="F0E6E4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4" name="Freeform 13"/>
              <p:cNvSpPr/>
              <p:nvPr/>
            </p:nvSpPr>
            <p:spPr>
              <a:xfrm>
                <a:off x="854" y="1528"/>
                <a:ext cx="443" cy="1708"/>
              </a:xfrm>
              <a:custGeom>
                <a:avLst/>
                <a:gdLst/>
                <a:ahLst/>
                <a:cxnLst>
                  <a:cxn ang="0">
                    <a:pos x="540" y="0"/>
                  </a:cxn>
                  <a:cxn ang="0">
                    <a:pos x="663" y="2509"/>
                  </a:cxn>
                  <a:cxn ang="0">
                    <a:pos x="540" y="0"/>
                  </a:cxn>
                </a:cxnLst>
                <a:pathLst>
                  <a:path w="362" h="1409">
                    <a:moveTo>
                      <a:pt x="294" y="0"/>
                    </a:moveTo>
                    <a:cubicBezTo>
                      <a:pt x="294" y="0"/>
                      <a:pt x="0" y="801"/>
                      <a:pt x="362" y="1409"/>
                    </a:cubicBezTo>
                    <a:cubicBezTo>
                      <a:pt x="362" y="1409"/>
                      <a:pt x="21" y="851"/>
                      <a:pt x="294" y="0"/>
                    </a:cubicBezTo>
                    <a:close/>
                  </a:path>
                </a:pathLst>
              </a:custGeom>
              <a:solidFill>
                <a:srgbClr val="AB4E3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5" name="Freeform 14"/>
              <p:cNvSpPr/>
              <p:nvPr/>
            </p:nvSpPr>
            <p:spPr>
              <a:xfrm>
                <a:off x="1326" y="1488"/>
                <a:ext cx="90" cy="1796"/>
              </a:xfrm>
              <a:custGeom>
                <a:avLst/>
                <a:gdLst/>
                <a:ahLst/>
                <a:cxnLst>
                  <a:cxn ang="0">
                    <a:pos x="34" y="2638"/>
                  </a:cxn>
                  <a:cxn ang="0">
                    <a:pos x="0" y="0"/>
                  </a:cxn>
                  <a:cxn ang="0">
                    <a:pos x="34" y="2638"/>
                  </a:cxn>
                </a:cxnLst>
                <a:pathLst>
                  <a:path w="74" h="1482">
                    <a:moveTo>
                      <a:pt x="19" y="1482"/>
                    </a:moveTo>
                    <a:cubicBezTo>
                      <a:pt x="19" y="1482"/>
                      <a:pt x="74" y="466"/>
                      <a:pt x="0" y="0"/>
                    </a:cubicBezTo>
                    <a:cubicBezTo>
                      <a:pt x="0" y="0"/>
                      <a:pt x="49" y="73"/>
                      <a:pt x="19" y="1482"/>
                    </a:cubicBezTo>
                    <a:close/>
                  </a:path>
                </a:pathLst>
              </a:custGeom>
              <a:solidFill>
                <a:srgbClr val="AB4E3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6" name="Freeform 15"/>
              <p:cNvSpPr/>
              <p:nvPr/>
            </p:nvSpPr>
            <p:spPr>
              <a:xfrm>
                <a:off x="1426" y="1534"/>
                <a:ext cx="406" cy="167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2" y="2461"/>
                  </a:cxn>
                  <a:cxn ang="0">
                    <a:pos x="0" y="0"/>
                  </a:cxn>
                </a:cxnLst>
                <a:pathLst>
                  <a:path w="332" h="1383">
                    <a:moveTo>
                      <a:pt x="0" y="0"/>
                    </a:moveTo>
                    <a:cubicBezTo>
                      <a:pt x="0" y="0"/>
                      <a:pt x="332" y="636"/>
                      <a:pt x="12" y="1383"/>
                    </a:cubicBezTo>
                    <a:cubicBezTo>
                      <a:pt x="12" y="1383"/>
                      <a:pt x="301" y="807"/>
                      <a:pt x="0" y="0"/>
                    </a:cubicBezTo>
                    <a:close/>
                  </a:path>
                </a:pathLst>
              </a:custGeom>
              <a:solidFill>
                <a:srgbClr val="AB4E3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7" name="Freeform 16"/>
              <p:cNvSpPr/>
              <p:nvPr/>
            </p:nvSpPr>
            <p:spPr>
              <a:xfrm>
                <a:off x="1434" y="1715"/>
                <a:ext cx="166" cy="135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989"/>
                  </a:cxn>
                  <a:cxn ang="0">
                    <a:pos x="0" y="0"/>
                  </a:cxn>
                </a:cxnLst>
                <a:pathLst>
                  <a:path w="136" h="1117">
                    <a:moveTo>
                      <a:pt x="0" y="0"/>
                    </a:moveTo>
                    <a:cubicBezTo>
                      <a:pt x="0" y="0"/>
                      <a:pt x="136" y="338"/>
                      <a:pt x="0" y="1117"/>
                    </a:cubicBezTo>
                    <a:cubicBezTo>
                      <a:pt x="0" y="1117"/>
                      <a:pt x="112" y="332"/>
                      <a:pt x="0" y="0"/>
                    </a:cubicBezTo>
                    <a:close/>
                  </a:path>
                </a:pathLst>
              </a:custGeom>
              <a:solidFill>
                <a:srgbClr val="AB4E3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8" name="Freeform 17"/>
              <p:cNvSpPr/>
              <p:nvPr/>
            </p:nvSpPr>
            <p:spPr>
              <a:xfrm>
                <a:off x="1055" y="1655"/>
                <a:ext cx="231" cy="1439"/>
              </a:xfrm>
              <a:custGeom>
                <a:avLst/>
                <a:gdLst/>
                <a:ahLst/>
                <a:cxnLst>
                  <a:cxn ang="0">
                    <a:pos x="295" y="10"/>
                  </a:cxn>
                  <a:cxn ang="0">
                    <a:pos x="345" y="2114"/>
                  </a:cxn>
                  <a:cxn ang="0">
                    <a:pos x="298" y="0"/>
                  </a:cxn>
                </a:cxnLst>
                <a:pathLst>
                  <a:path w="189" h="1187">
                    <a:moveTo>
                      <a:pt x="161" y="6"/>
                    </a:moveTo>
                    <a:cubicBezTo>
                      <a:pt x="161" y="6"/>
                      <a:pt x="0" y="434"/>
                      <a:pt x="189" y="1187"/>
                    </a:cubicBezTo>
                    <a:cubicBezTo>
                      <a:pt x="189" y="1187"/>
                      <a:pt x="25" y="521"/>
                      <a:pt x="164" y="0"/>
                    </a:cubicBezTo>
                  </a:path>
                </a:pathLst>
              </a:custGeom>
              <a:solidFill>
                <a:srgbClr val="AB4E3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29" name="Freeform 18"/>
              <p:cNvSpPr/>
              <p:nvPr/>
            </p:nvSpPr>
            <p:spPr>
              <a:xfrm>
                <a:off x="1221" y="1801"/>
                <a:ext cx="76" cy="1064"/>
              </a:xfrm>
              <a:custGeom>
                <a:avLst/>
                <a:gdLst/>
                <a:ahLst/>
                <a:cxnLst>
                  <a:cxn ang="0">
                    <a:pos x="104" y="0"/>
                  </a:cxn>
                  <a:cxn ang="0">
                    <a:pos x="114" y="1562"/>
                  </a:cxn>
                  <a:cxn ang="0">
                    <a:pos x="104" y="0"/>
                  </a:cxn>
                </a:cxnLst>
                <a:pathLst>
                  <a:path w="62" h="878">
                    <a:moveTo>
                      <a:pt x="56" y="0"/>
                    </a:moveTo>
                    <a:cubicBezTo>
                      <a:pt x="56" y="0"/>
                      <a:pt x="0" y="245"/>
                      <a:pt x="62" y="878"/>
                    </a:cubicBezTo>
                    <a:cubicBezTo>
                      <a:pt x="62" y="878"/>
                      <a:pt x="22" y="174"/>
                      <a:pt x="56" y="0"/>
                    </a:cubicBezTo>
                    <a:close/>
                  </a:path>
                </a:pathLst>
              </a:custGeom>
              <a:solidFill>
                <a:srgbClr val="AB4E36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0" name="Freeform 19"/>
              <p:cNvSpPr/>
              <p:nvPr/>
            </p:nvSpPr>
            <p:spPr>
              <a:xfrm>
                <a:off x="947" y="1740"/>
                <a:ext cx="248" cy="1303"/>
              </a:xfrm>
              <a:custGeom>
                <a:avLst/>
                <a:gdLst/>
                <a:ahLst/>
                <a:cxnLst>
                  <a:cxn ang="0">
                    <a:pos x="297" y="0"/>
                  </a:cxn>
                  <a:cxn ang="0">
                    <a:pos x="370" y="1914"/>
                  </a:cxn>
                  <a:cxn ang="0">
                    <a:pos x="297" y="0"/>
                  </a:cxn>
                </a:cxnLst>
                <a:pathLst>
                  <a:path w="203" h="1075">
                    <a:moveTo>
                      <a:pt x="163" y="0"/>
                    </a:moveTo>
                    <a:cubicBezTo>
                      <a:pt x="163" y="0"/>
                      <a:pt x="6" y="539"/>
                      <a:pt x="203" y="1075"/>
                    </a:cubicBezTo>
                    <a:cubicBezTo>
                      <a:pt x="203" y="1075"/>
                      <a:pt x="0" y="694"/>
                      <a:pt x="163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1" name="Freeform 20"/>
              <p:cNvSpPr/>
              <p:nvPr/>
            </p:nvSpPr>
            <p:spPr>
              <a:xfrm>
                <a:off x="1078" y="1747"/>
                <a:ext cx="150" cy="1116"/>
              </a:xfrm>
              <a:custGeom>
                <a:avLst/>
                <a:gdLst/>
                <a:ahLst/>
                <a:cxnLst>
                  <a:cxn ang="0">
                    <a:pos x="209" y="0"/>
                  </a:cxn>
                  <a:cxn ang="0">
                    <a:pos x="223" y="1642"/>
                  </a:cxn>
                  <a:cxn ang="0">
                    <a:pos x="209" y="0"/>
                  </a:cxn>
                </a:cxnLst>
                <a:pathLst>
                  <a:path w="123" h="920">
                    <a:moveTo>
                      <a:pt x="115" y="0"/>
                    </a:moveTo>
                    <a:cubicBezTo>
                      <a:pt x="115" y="0"/>
                      <a:pt x="16" y="344"/>
                      <a:pt x="123" y="920"/>
                    </a:cubicBezTo>
                    <a:cubicBezTo>
                      <a:pt x="123" y="920"/>
                      <a:pt x="0" y="522"/>
                      <a:pt x="115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2" name="Freeform 21"/>
              <p:cNvSpPr/>
              <p:nvPr/>
            </p:nvSpPr>
            <p:spPr>
              <a:xfrm>
                <a:off x="1209" y="1692"/>
                <a:ext cx="84" cy="876"/>
              </a:xfrm>
              <a:custGeom>
                <a:avLst/>
                <a:gdLst/>
                <a:ahLst/>
                <a:cxnLst>
                  <a:cxn ang="0">
                    <a:pos x="124" y="0"/>
                  </a:cxn>
                  <a:cxn ang="0">
                    <a:pos x="86" y="1286"/>
                  </a:cxn>
                  <a:cxn ang="0">
                    <a:pos x="124" y="0"/>
                  </a:cxn>
                </a:cxnLst>
                <a:pathLst>
                  <a:path w="69" h="723">
                    <a:moveTo>
                      <a:pt x="69" y="0"/>
                    </a:moveTo>
                    <a:cubicBezTo>
                      <a:pt x="69" y="0"/>
                      <a:pt x="10" y="472"/>
                      <a:pt x="48" y="723"/>
                    </a:cubicBezTo>
                    <a:cubicBezTo>
                      <a:pt x="48" y="723"/>
                      <a:pt x="0" y="256"/>
                      <a:pt x="69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3" name="Freeform 22"/>
              <p:cNvSpPr/>
              <p:nvPr/>
            </p:nvSpPr>
            <p:spPr>
              <a:xfrm>
                <a:off x="1346" y="1841"/>
                <a:ext cx="15" cy="1293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0" y="1899"/>
                  </a:cxn>
                  <a:cxn ang="0">
                    <a:pos x="2" y="0"/>
                  </a:cxn>
                </a:cxnLst>
                <a:pathLst>
                  <a:path w="13" h="1067">
                    <a:moveTo>
                      <a:pt x="2" y="0"/>
                    </a:moveTo>
                    <a:cubicBezTo>
                      <a:pt x="2" y="0"/>
                      <a:pt x="13" y="592"/>
                      <a:pt x="0" y="1067"/>
                    </a:cubicBezTo>
                    <a:cubicBezTo>
                      <a:pt x="0" y="1067"/>
                      <a:pt x="0" y="53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4" name="Freeform 23"/>
              <p:cNvSpPr/>
              <p:nvPr/>
            </p:nvSpPr>
            <p:spPr>
              <a:xfrm>
                <a:off x="1404" y="1641"/>
                <a:ext cx="137" cy="93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13" y="1370"/>
                  </a:cxn>
                  <a:cxn ang="0">
                    <a:pos x="0" y="0"/>
                  </a:cxn>
                </a:cxnLst>
                <a:pathLst>
                  <a:path w="112" h="770">
                    <a:moveTo>
                      <a:pt x="0" y="0"/>
                    </a:moveTo>
                    <a:cubicBezTo>
                      <a:pt x="0" y="0"/>
                      <a:pt x="112" y="325"/>
                      <a:pt x="61" y="770"/>
                    </a:cubicBezTo>
                    <a:cubicBezTo>
                      <a:pt x="61" y="770"/>
                      <a:pt x="82" y="266"/>
                      <a:pt x="0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5" name="Freeform 24"/>
              <p:cNvSpPr/>
              <p:nvPr/>
            </p:nvSpPr>
            <p:spPr>
              <a:xfrm>
                <a:off x="1430" y="2254"/>
                <a:ext cx="209" cy="954"/>
              </a:xfrm>
              <a:custGeom>
                <a:avLst/>
                <a:gdLst/>
                <a:ahLst/>
                <a:cxnLst>
                  <a:cxn ang="0">
                    <a:pos x="229" y="0"/>
                  </a:cxn>
                  <a:cxn ang="0">
                    <a:pos x="0" y="1401"/>
                  </a:cxn>
                  <a:cxn ang="0">
                    <a:pos x="229" y="0"/>
                  </a:cxn>
                </a:cxnLst>
                <a:pathLst>
                  <a:path w="171" h="787">
                    <a:moveTo>
                      <a:pt x="125" y="0"/>
                    </a:moveTo>
                    <a:cubicBezTo>
                      <a:pt x="125" y="0"/>
                      <a:pt x="171" y="443"/>
                      <a:pt x="0" y="787"/>
                    </a:cubicBezTo>
                    <a:cubicBezTo>
                      <a:pt x="0" y="787"/>
                      <a:pt x="144" y="518"/>
                      <a:pt x="125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6" name="Freeform 25"/>
              <p:cNvSpPr/>
              <p:nvPr/>
            </p:nvSpPr>
            <p:spPr>
              <a:xfrm>
                <a:off x="1180" y="1375"/>
                <a:ext cx="170" cy="418"/>
              </a:xfrm>
              <a:custGeom>
                <a:avLst/>
                <a:gdLst/>
                <a:ahLst/>
                <a:cxnLst>
                  <a:cxn ang="0">
                    <a:pos x="68" y="104"/>
                  </a:cxn>
                  <a:cxn ang="0">
                    <a:pos x="60" y="227"/>
                  </a:cxn>
                  <a:cxn ang="0">
                    <a:pos x="67" y="327"/>
                  </a:cxn>
                  <a:cxn ang="0">
                    <a:pos x="2" y="613"/>
                  </a:cxn>
                  <a:cxn ang="0">
                    <a:pos x="46" y="521"/>
                  </a:cxn>
                  <a:cxn ang="0">
                    <a:pos x="76" y="425"/>
                  </a:cxn>
                  <a:cxn ang="0">
                    <a:pos x="139" y="344"/>
                  </a:cxn>
                  <a:cxn ang="0">
                    <a:pos x="139" y="425"/>
                  </a:cxn>
                  <a:cxn ang="0">
                    <a:pos x="125" y="515"/>
                  </a:cxn>
                  <a:cxn ang="0">
                    <a:pos x="175" y="420"/>
                  </a:cxn>
                  <a:cxn ang="0">
                    <a:pos x="194" y="468"/>
                  </a:cxn>
                  <a:cxn ang="0">
                    <a:pos x="221" y="548"/>
                  </a:cxn>
                  <a:cxn ang="0">
                    <a:pos x="220" y="360"/>
                  </a:cxn>
                  <a:cxn ang="0">
                    <a:pos x="194" y="116"/>
                  </a:cxn>
                  <a:cxn ang="0">
                    <a:pos x="175" y="0"/>
                  </a:cxn>
                  <a:cxn ang="0">
                    <a:pos x="136" y="84"/>
                  </a:cxn>
                  <a:cxn ang="0">
                    <a:pos x="68" y="111"/>
                  </a:cxn>
                </a:cxnLst>
                <a:pathLst>
                  <a:path w="139" h="345">
                    <a:moveTo>
                      <a:pt x="38" y="59"/>
                    </a:moveTo>
                    <a:cubicBezTo>
                      <a:pt x="39" y="84"/>
                      <a:pt x="18" y="101"/>
                      <a:pt x="33" y="127"/>
                    </a:cubicBezTo>
                    <a:cubicBezTo>
                      <a:pt x="45" y="148"/>
                      <a:pt x="42" y="159"/>
                      <a:pt x="37" y="184"/>
                    </a:cubicBezTo>
                    <a:cubicBezTo>
                      <a:pt x="24" y="235"/>
                      <a:pt x="0" y="292"/>
                      <a:pt x="2" y="345"/>
                    </a:cubicBezTo>
                    <a:cubicBezTo>
                      <a:pt x="15" y="337"/>
                      <a:pt x="19" y="307"/>
                      <a:pt x="25" y="293"/>
                    </a:cubicBezTo>
                    <a:cubicBezTo>
                      <a:pt x="31" y="275"/>
                      <a:pt x="35" y="257"/>
                      <a:pt x="42" y="239"/>
                    </a:cubicBezTo>
                    <a:cubicBezTo>
                      <a:pt x="46" y="231"/>
                      <a:pt x="62" y="178"/>
                      <a:pt x="76" y="193"/>
                    </a:cubicBezTo>
                    <a:cubicBezTo>
                      <a:pt x="82" y="199"/>
                      <a:pt x="77" y="231"/>
                      <a:pt x="76" y="239"/>
                    </a:cubicBezTo>
                    <a:cubicBezTo>
                      <a:pt x="74" y="255"/>
                      <a:pt x="65" y="274"/>
                      <a:pt x="68" y="290"/>
                    </a:cubicBezTo>
                    <a:cubicBezTo>
                      <a:pt x="79" y="278"/>
                      <a:pt x="82" y="243"/>
                      <a:pt x="96" y="236"/>
                    </a:cubicBezTo>
                    <a:cubicBezTo>
                      <a:pt x="111" y="229"/>
                      <a:pt x="106" y="252"/>
                      <a:pt x="106" y="263"/>
                    </a:cubicBezTo>
                    <a:cubicBezTo>
                      <a:pt x="106" y="271"/>
                      <a:pt x="106" y="318"/>
                      <a:pt x="121" y="308"/>
                    </a:cubicBezTo>
                    <a:cubicBezTo>
                      <a:pt x="139" y="296"/>
                      <a:pt x="122" y="220"/>
                      <a:pt x="120" y="202"/>
                    </a:cubicBezTo>
                    <a:cubicBezTo>
                      <a:pt x="116" y="156"/>
                      <a:pt x="108" y="111"/>
                      <a:pt x="106" y="65"/>
                    </a:cubicBezTo>
                    <a:cubicBezTo>
                      <a:pt x="105" y="44"/>
                      <a:pt x="104" y="19"/>
                      <a:pt x="96" y="0"/>
                    </a:cubicBezTo>
                    <a:cubicBezTo>
                      <a:pt x="87" y="2"/>
                      <a:pt x="80" y="37"/>
                      <a:pt x="74" y="47"/>
                    </a:cubicBezTo>
                    <a:cubicBezTo>
                      <a:pt x="66" y="61"/>
                      <a:pt x="53" y="70"/>
                      <a:pt x="38" y="63"/>
                    </a:cubicBezTo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7" name="Freeform 26"/>
              <p:cNvSpPr/>
              <p:nvPr/>
            </p:nvSpPr>
            <p:spPr>
              <a:xfrm>
                <a:off x="1349" y="1344"/>
                <a:ext cx="97" cy="315"/>
              </a:xfrm>
              <a:custGeom>
                <a:avLst/>
                <a:gdLst/>
                <a:ahLst/>
                <a:cxnLst>
                  <a:cxn ang="0">
                    <a:pos x="48" y="0"/>
                  </a:cxn>
                  <a:cxn ang="0">
                    <a:pos x="6" y="2"/>
                  </a:cxn>
                  <a:cxn ang="0">
                    <a:pos x="18" y="250"/>
                  </a:cxn>
                  <a:cxn ang="0">
                    <a:pos x="39" y="347"/>
                  </a:cxn>
                  <a:cxn ang="0">
                    <a:pos x="61" y="456"/>
                  </a:cxn>
                  <a:cxn ang="0">
                    <a:pos x="71" y="355"/>
                  </a:cxn>
                  <a:cxn ang="0">
                    <a:pos x="136" y="463"/>
                  </a:cxn>
                  <a:cxn ang="0">
                    <a:pos x="79" y="201"/>
                  </a:cxn>
                  <a:cxn ang="0">
                    <a:pos x="122" y="235"/>
                  </a:cxn>
                  <a:cxn ang="0">
                    <a:pos x="71" y="92"/>
                  </a:cxn>
                  <a:cxn ang="0">
                    <a:pos x="47" y="12"/>
                  </a:cxn>
                </a:cxnLst>
                <a:pathLst>
                  <a:path w="79" h="260">
                    <a:moveTo>
                      <a:pt x="26" y="0"/>
                    </a:moveTo>
                    <a:cubicBezTo>
                      <a:pt x="20" y="10"/>
                      <a:pt x="11" y="3"/>
                      <a:pt x="3" y="2"/>
                    </a:cubicBezTo>
                    <a:cubicBezTo>
                      <a:pt x="1" y="46"/>
                      <a:pt x="0" y="97"/>
                      <a:pt x="10" y="140"/>
                    </a:cubicBezTo>
                    <a:cubicBezTo>
                      <a:pt x="14" y="158"/>
                      <a:pt x="18" y="176"/>
                      <a:pt x="21" y="195"/>
                    </a:cubicBezTo>
                    <a:cubicBezTo>
                      <a:pt x="23" y="214"/>
                      <a:pt x="20" y="241"/>
                      <a:pt x="33" y="256"/>
                    </a:cubicBezTo>
                    <a:cubicBezTo>
                      <a:pt x="39" y="242"/>
                      <a:pt x="25" y="209"/>
                      <a:pt x="38" y="200"/>
                    </a:cubicBezTo>
                    <a:cubicBezTo>
                      <a:pt x="55" y="212"/>
                      <a:pt x="51" y="258"/>
                      <a:pt x="73" y="260"/>
                    </a:cubicBezTo>
                    <a:cubicBezTo>
                      <a:pt x="79" y="217"/>
                      <a:pt x="17" y="156"/>
                      <a:pt x="42" y="113"/>
                    </a:cubicBezTo>
                    <a:cubicBezTo>
                      <a:pt x="51" y="118"/>
                      <a:pt x="57" y="128"/>
                      <a:pt x="66" y="132"/>
                    </a:cubicBezTo>
                    <a:cubicBezTo>
                      <a:pt x="58" y="105"/>
                      <a:pt x="44" y="80"/>
                      <a:pt x="38" y="52"/>
                    </a:cubicBezTo>
                    <a:cubicBezTo>
                      <a:pt x="34" y="37"/>
                      <a:pt x="33" y="20"/>
                      <a:pt x="25" y="7"/>
                    </a:cubicBezTo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8" name="Freeform 27"/>
              <p:cNvSpPr/>
              <p:nvPr/>
            </p:nvSpPr>
            <p:spPr>
              <a:xfrm>
                <a:off x="1404" y="1821"/>
                <a:ext cx="74" cy="97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33" y="732"/>
                  </a:cxn>
                  <a:cxn ang="0">
                    <a:pos x="46" y="1059"/>
                  </a:cxn>
                  <a:cxn ang="0">
                    <a:pos x="31" y="1426"/>
                  </a:cxn>
                  <a:cxn ang="0">
                    <a:pos x="70" y="1203"/>
                  </a:cxn>
                  <a:cxn ang="0">
                    <a:pos x="90" y="1008"/>
                  </a:cxn>
                  <a:cxn ang="0">
                    <a:pos x="99" y="586"/>
                  </a:cxn>
                  <a:cxn ang="0">
                    <a:pos x="70" y="242"/>
                  </a:cxn>
                  <a:cxn ang="0">
                    <a:pos x="15" y="23"/>
                  </a:cxn>
                </a:cxnLst>
                <a:pathLst>
                  <a:path w="60" h="800">
                    <a:moveTo>
                      <a:pt x="0" y="0"/>
                    </a:moveTo>
                    <a:cubicBezTo>
                      <a:pt x="27" y="135"/>
                      <a:pt x="12" y="274"/>
                      <a:pt x="18" y="411"/>
                    </a:cubicBezTo>
                    <a:cubicBezTo>
                      <a:pt x="21" y="471"/>
                      <a:pt x="24" y="532"/>
                      <a:pt x="24" y="594"/>
                    </a:cubicBezTo>
                    <a:cubicBezTo>
                      <a:pt x="24" y="663"/>
                      <a:pt x="12" y="731"/>
                      <a:pt x="16" y="800"/>
                    </a:cubicBezTo>
                    <a:cubicBezTo>
                      <a:pt x="45" y="788"/>
                      <a:pt x="34" y="702"/>
                      <a:pt x="37" y="675"/>
                    </a:cubicBezTo>
                    <a:cubicBezTo>
                      <a:pt x="41" y="638"/>
                      <a:pt x="43" y="601"/>
                      <a:pt x="48" y="565"/>
                    </a:cubicBezTo>
                    <a:cubicBezTo>
                      <a:pt x="57" y="486"/>
                      <a:pt x="60" y="407"/>
                      <a:pt x="53" y="328"/>
                    </a:cubicBezTo>
                    <a:cubicBezTo>
                      <a:pt x="48" y="264"/>
                      <a:pt x="43" y="200"/>
                      <a:pt x="37" y="136"/>
                    </a:cubicBezTo>
                    <a:cubicBezTo>
                      <a:pt x="34" y="108"/>
                      <a:pt x="33" y="27"/>
                      <a:pt x="8" y="13"/>
                    </a:cubicBezTo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39" name="Freeform 28"/>
              <p:cNvSpPr/>
              <p:nvPr/>
            </p:nvSpPr>
            <p:spPr>
              <a:xfrm>
                <a:off x="1363" y="2923"/>
                <a:ext cx="122" cy="472"/>
              </a:xfrm>
              <a:custGeom>
                <a:avLst/>
                <a:gdLst/>
                <a:ahLst/>
                <a:cxnLst>
                  <a:cxn ang="0">
                    <a:pos x="76" y="0"/>
                  </a:cxn>
                  <a:cxn ang="0">
                    <a:pos x="35" y="243"/>
                  </a:cxn>
                  <a:cxn ang="0">
                    <a:pos x="33" y="430"/>
                  </a:cxn>
                  <a:cxn ang="0">
                    <a:pos x="50" y="695"/>
                  </a:cxn>
                  <a:cxn ang="0">
                    <a:pos x="72" y="561"/>
                  </a:cxn>
                  <a:cxn ang="0">
                    <a:pos x="117" y="457"/>
                  </a:cxn>
                  <a:cxn ang="0">
                    <a:pos x="76" y="470"/>
                  </a:cxn>
                  <a:cxn ang="0">
                    <a:pos x="173" y="119"/>
                  </a:cxn>
                  <a:cxn ang="0">
                    <a:pos x="142" y="200"/>
                  </a:cxn>
                  <a:cxn ang="0">
                    <a:pos x="94" y="285"/>
                  </a:cxn>
                  <a:cxn ang="0">
                    <a:pos x="82" y="285"/>
                  </a:cxn>
                  <a:cxn ang="0">
                    <a:pos x="72" y="34"/>
                  </a:cxn>
                </a:cxnLst>
                <a:pathLst>
                  <a:path w="100" h="389">
                    <a:moveTo>
                      <a:pt x="42" y="0"/>
                    </a:moveTo>
                    <a:cubicBezTo>
                      <a:pt x="22" y="24"/>
                      <a:pt x="24" y="103"/>
                      <a:pt x="20" y="136"/>
                    </a:cubicBezTo>
                    <a:cubicBezTo>
                      <a:pt x="16" y="170"/>
                      <a:pt x="18" y="206"/>
                      <a:pt x="18" y="241"/>
                    </a:cubicBezTo>
                    <a:cubicBezTo>
                      <a:pt x="18" y="277"/>
                      <a:pt x="0" y="365"/>
                      <a:pt x="28" y="389"/>
                    </a:cubicBezTo>
                    <a:cubicBezTo>
                      <a:pt x="35" y="366"/>
                      <a:pt x="32" y="338"/>
                      <a:pt x="39" y="314"/>
                    </a:cubicBezTo>
                    <a:cubicBezTo>
                      <a:pt x="45" y="293"/>
                      <a:pt x="63" y="278"/>
                      <a:pt x="65" y="256"/>
                    </a:cubicBezTo>
                    <a:cubicBezTo>
                      <a:pt x="58" y="258"/>
                      <a:pt x="49" y="259"/>
                      <a:pt x="42" y="263"/>
                    </a:cubicBezTo>
                    <a:cubicBezTo>
                      <a:pt x="9" y="220"/>
                      <a:pt x="100" y="121"/>
                      <a:pt x="95" y="67"/>
                    </a:cubicBezTo>
                    <a:cubicBezTo>
                      <a:pt x="80" y="77"/>
                      <a:pt x="84" y="97"/>
                      <a:pt x="78" y="112"/>
                    </a:cubicBezTo>
                    <a:cubicBezTo>
                      <a:pt x="72" y="128"/>
                      <a:pt x="60" y="146"/>
                      <a:pt x="52" y="160"/>
                    </a:cubicBezTo>
                    <a:cubicBezTo>
                      <a:pt x="51" y="160"/>
                      <a:pt x="46" y="160"/>
                      <a:pt x="45" y="160"/>
                    </a:cubicBezTo>
                    <a:cubicBezTo>
                      <a:pt x="42" y="112"/>
                      <a:pt x="46" y="65"/>
                      <a:pt x="39" y="19"/>
                    </a:cubicBezTo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0" name="Freeform 29"/>
              <p:cNvSpPr/>
              <p:nvPr/>
            </p:nvSpPr>
            <p:spPr>
              <a:xfrm>
                <a:off x="1260" y="2867"/>
                <a:ext cx="79" cy="506"/>
              </a:xfrm>
              <a:custGeom>
                <a:avLst/>
                <a:gdLst/>
                <a:ahLst/>
                <a:cxnLst>
                  <a:cxn ang="0">
                    <a:pos x="34" y="74"/>
                  </a:cxn>
                  <a:cxn ang="0">
                    <a:pos x="95" y="203"/>
                  </a:cxn>
                  <a:cxn ang="0">
                    <a:pos x="111" y="442"/>
                  </a:cxn>
                  <a:cxn ang="0">
                    <a:pos x="109" y="745"/>
                  </a:cxn>
                  <a:cxn ang="0">
                    <a:pos x="77" y="551"/>
                  </a:cxn>
                  <a:cxn ang="0">
                    <a:pos x="11" y="346"/>
                  </a:cxn>
                  <a:cxn ang="0">
                    <a:pos x="49" y="377"/>
                  </a:cxn>
                  <a:cxn ang="0">
                    <a:pos x="34" y="78"/>
                  </a:cxn>
                </a:cxnLst>
                <a:pathLst>
                  <a:path w="65" h="417">
                    <a:moveTo>
                      <a:pt x="19" y="41"/>
                    </a:moveTo>
                    <a:cubicBezTo>
                      <a:pt x="49" y="0"/>
                      <a:pt x="51" y="98"/>
                      <a:pt x="53" y="114"/>
                    </a:cubicBezTo>
                    <a:cubicBezTo>
                      <a:pt x="59" y="158"/>
                      <a:pt x="64" y="202"/>
                      <a:pt x="62" y="247"/>
                    </a:cubicBezTo>
                    <a:cubicBezTo>
                      <a:pt x="59" y="303"/>
                      <a:pt x="65" y="361"/>
                      <a:pt x="61" y="417"/>
                    </a:cubicBezTo>
                    <a:cubicBezTo>
                      <a:pt x="37" y="397"/>
                      <a:pt x="44" y="337"/>
                      <a:pt x="43" y="308"/>
                    </a:cubicBezTo>
                    <a:cubicBezTo>
                      <a:pt x="41" y="268"/>
                      <a:pt x="5" y="235"/>
                      <a:pt x="6" y="194"/>
                    </a:cubicBezTo>
                    <a:cubicBezTo>
                      <a:pt x="10" y="203"/>
                      <a:pt x="17" y="210"/>
                      <a:pt x="27" y="211"/>
                    </a:cubicBezTo>
                    <a:cubicBezTo>
                      <a:pt x="36" y="159"/>
                      <a:pt x="0" y="95"/>
                      <a:pt x="19" y="44"/>
                    </a:cubicBezTo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1" name="Freeform 30"/>
              <p:cNvSpPr/>
              <p:nvPr/>
            </p:nvSpPr>
            <p:spPr>
              <a:xfrm>
                <a:off x="1309" y="2054"/>
                <a:ext cx="35" cy="45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5" y="358"/>
                  </a:cxn>
                  <a:cxn ang="0">
                    <a:pos x="28" y="510"/>
                  </a:cxn>
                  <a:cxn ang="0">
                    <a:pos x="28" y="670"/>
                  </a:cxn>
                  <a:cxn ang="0">
                    <a:pos x="40" y="209"/>
                  </a:cxn>
                  <a:cxn ang="0">
                    <a:pos x="6" y="0"/>
                  </a:cxn>
                </a:cxnLst>
                <a:pathLst>
                  <a:path w="29" h="375">
                    <a:moveTo>
                      <a:pt x="0" y="0"/>
                    </a:moveTo>
                    <a:cubicBezTo>
                      <a:pt x="19" y="60"/>
                      <a:pt x="11" y="138"/>
                      <a:pt x="14" y="200"/>
                    </a:cubicBezTo>
                    <a:cubicBezTo>
                      <a:pt x="16" y="228"/>
                      <a:pt x="16" y="257"/>
                      <a:pt x="16" y="285"/>
                    </a:cubicBezTo>
                    <a:cubicBezTo>
                      <a:pt x="16" y="311"/>
                      <a:pt x="8" y="353"/>
                      <a:pt x="16" y="375"/>
                    </a:cubicBezTo>
                    <a:cubicBezTo>
                      <a:pt x="29" y="292"/>
                      <a:pt x="21" y="202"/>
                      <a:pt x="22" y="117"/>
                    </a:cubicBezTo>
                    <a:cubicBezTo>
                      <a:pt x="22" y="84"/>
                      <a:pt x="22" y="26"/>
                      <a:pt x="3" y="0"/>
                    </a:cubicBezTo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2" name="Freeform 31"/>
              <p:cNvSpPr/>
              <p:nvPr/>
            </p:nvSpPr>
            <p:spPr>
              <a:xfrm>
                <a:off x="1124" y="2069"/>
                <a:ext cx="43" cy="402"/>
              </a:xfrm>
              <a:custGeom>
                <a:avLst/>
                <a:gdLst/>
                <a:ahLst/>
                <a:cxnLst>
                  <a:cxn ang="0">
                    <a:pos x="27" y="12"/>
                  </a:cxn>
                  <a:cxn ang="0">
                    <a:pos x="27" y="0"/>
                  </a:cxn>
                  <a:cxn ang="0">
                    <a:pos x="14" y="368"/>
                  </a:cxn>
                  <a:cxn ang="0">
                    <a:pos x="38" y="590"/>
                  </a:cxn>
                  <a:cxn ang="0">
                    <a:pos x="32" y="396"/>
                  </a:cxn>
                  <a:cxn ang="0">
                    <a:pos x="54" y="209"/>
                  </a:cxn>
                  <a:cxn ang="0">
                    <a:pos x="42" y="7"/>
                  </a:cxn>
                </a:cxnLst>
                <a:pathLst>
                  <a:path w="35" h="332">
                    <a:moveTo>
                      <a:pt x="15" y="7"/>
                    </a:moveTo>
                    <a:cubicBezTo>
                      <a:pt x="15" y="4"/>
                      <a:pt x="15" y="2"/>
                      <a:pt x="15" y="0"/>
                    </a:cubicBezTo>
                    <a:cubicBezTo>
                      <a:pt x="18" y="68"/>
                      <a:pt x="5" y="137"/>
                      <a:pt x="7" y="207"/>
                    </a:cubicBezTo>
                    <a:cubicBezTo>
                      <a:pt x="8" y="232"/>
                      <a:pt x="0" y="315"/>
                      <a:pt x="20" y="332"/>
                    </a:cubicBezTo>
                    <a:cubicBezTo>
                      <a:pt x="22" y="295"/>
                      <a:pt x="13" y="259"/>
                      <a:pt x="17" y="223"/>
                    </a:cubicBezTo>
                    <a:cubicBezTo>
                      <a:pt x="21" y="188"/>
                      <a:pt x="27" y="153"/>
                      <a:pt x="29" y="118"/>
                    </a:cubicBezTo>
                    <a:cubicBezTo>
                      <a:pt x="30" y="85"/>
                      <a:pt x="35" y="33"/>
                      <a:pt x="23" y="4"/>
                    </a:cubicBezTo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3" name="Freeform 32"/>
              <p:cNvSpPr/>
              <p:nvPr/>
            </p:nvSpPr>
            <p:spPr>
              <a:xfrm>
                <a:off x="944" y="1885"/>
                <a:ext cx="167" cy="987"/>
              </a:xfrm>
              <a:custGeom>
                <a:avLst/>
                <a:gdLst/>
                <a:ahLst/>
                <a:cxnLst>
                  <a:cxn ang="0">
                    <a:pos x="211" y="0"/>
                  </a:cxn>
                  <a:cxn ang="0">
                    <a:pos x="252" y="1451"/>
                  </a:cxn>
                  <a:cxn ang="0">
                    <a:pos x="211" y="0"/>
                  </a:cxn>
                </a:cxnLst>
                <a:pathLst>
                  <a:path w="136" h="814">
                    <a:moveTo>
                      <a:pt x="114" y="0"/>
                    </a:moveTo>
                    <a:cubicBezTo>
                      <a:pt x="114" y="0"/>
                      <a:pt x="0" y="443"/>
                      <a:pt x="136" y="814"/>
                    </a:cubicBezTo>
                    <a:cubicBezTo>
                      <a:pt x="136" y="814"/>
                      <a:pt x="58" y="176"/>
                      <a:pt x="114" y="0"/>
                    </a:cubicBezTo>
                    <a:close/>
                  </a:path>
                </a:pathLst>
              </a:custGeom>
              <a:solidFill>
                <a:srgbClr val="F1A690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4" name="Freeform 33"/>
              <p:cNvSpPr/>
              <p:nvPr/>
            </p:nvSpPr>
            <p:spPr>
              <a:xfrm>
                <a:off x="1370" y="1165"/>
                <a:ext cx="456" cy="2475"/>
              </a:xfrm>
              <a:custGeom>
                <a:avLst/>
                <a:gdLst/>
                <a:ahLst/>
                <a:cxnLst>
                  <a:cxn ang="0">
                    <a:pos x="76" y="3639"/>
                  </a:cxn>
                  <a:cxn ang="0">
                    <a:pos x="145" y="3056"/>
                  </a:cxn>
                  <a:cxn ang="0">
                    <a:pos x="122" y="489"/>
                  </a:cxn>
                  <a:cxn ang="0">
                    <a:pos x="0" y="0"/>
                  </a:cxn>
                </a:cxnLst>
                <a:pathLst>
                  <a:path w="373" h="2041">
                    <a:moveTo>
                      <a:pt x="42" y="2041"/>
                    </a:moveTo>
                    <a:cubicBezTo>
                      <a:pt x="42" y="2041"/>
                      <a:pt x="23" y="1819"/>
                      <a:pt x="79" y="1714"/>
                    </a:cubicBezTo>
                    <a:cubicBezTo>
                      <a:pt x="160" y="1565"/>
                      <a:pt x="373" y="948"/>
                      <a:pt x="67" y="274"/>
                    </a:cubicBezTo>
                    <a:cubicBezTo>
                      <a:pt x="13" y="156"/>
                      <a:pt x="9" y="50"/>
                      <a:pt x="0" y="0"/>
                    </a:cubicBezTo>
                  </a:path>
                </a:pathLst>
              </a:custGeom>
              <a:noFill/>
              <a:ln w="7938" cap="rnd" cmpd="sng">
                <a:solidFill>
                  <a:srgbClr val="494E4E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5" name="Freeform 34"/>
              <p:cNvSpPr/>
              <p:nvPr/>
            </p:nvSpPr>
            <p:spPr>
              <a:xfrm>
                <a:off x="814" y="1168"/>
                <a:ext cx="543" cy="2475"/>
              </a:xfrm>
              <a:custGeom>
                <a:avLst/>
                <a:gdLst/>
                <a:ahLst/>
                <a:cxnLst>
                  <a:cxn ang="0">
                    <a:pos x="680" y="0"/>
                  </a:cxn>
                  <a:cxn ang="0">
                    <a:pos x="564" y="480"/>
                  </a:cxn>
                  <a:cxn ang="0">
                    <a:pos x="648" y="3016"/>
                  </a:cxn>
                  <a:cxn ang="0">
                    <a:pos x="779" y="3636"/>
                  </a:cxn>
                </a:cxnLst>
                <a:pathLst>
                  <a:path w="444" h="2042">
                    <a:moveTo>
                      <a:pt x="372" y="0"/>
                    </a:moveTo>
                    <a:cubicBezTo>
                      <a:pt x="372" y="0"/>
                      <a:pt x="365" y="136"/>
                      <a:pt x="308" y="270"/>
                    </a:cubicBezTo>
                    <a:cubicBezTo>
                      <a:pt x="230" y="452"/>
                      <a:pt x="0" y="1118"/>
                      <a:pt x="354" y="1694"/>
                    </a:cubicBezTo>
                    <a:cubicBezTo>
                      <a:pt x="444" y="1841"/>
                      <a:pt x="426" y="2042"/>
                      <a:pt x="426" y="2042"/>
                    </a:cubicBezTo>
                  </a:path>
                </a:pathLst>
              </a:custGeom>
              <a:noFill/>
              <a:ln w="7938" cap="rnd" cmpd="sng">
                <a:solidFill>
                  <a:srgbClr val="494E4E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6" name="Freeform 35"/>
              <p:cNvSpPr/>
              <p:nvPr/>
            </p:nvSpPr>
            <p:spPr>
              <a:xfrm>
                <a:off x="1368" y="3540"/>
                <a:ext cx="41" cy="107"/>
              </a:xfrm>
              <a:custGeom>
                <a:avLst/>
                <a:gdLst/>
                <a:ahLst/>
                <a:cxnLst>
                  <a:cxn ang="0">
                    <a:pos x="59" y="39"/>
                  </a:cxn>
                  <a:cxn ang="0">
                    <a:pos x="14" y="1"/>
                  </a:cxn>
                  <a:cxn ang="0">
                    <a:pos x="16" y="81"/>
                  </a:cxn>
                  <a:cxn ang="0">
                    <a:pos x="12" y="136"/>
                  </a:cxn>
                  <a:cxn ang="0">
                    <a:pos x="42" y="133"/>
                  </a:cxn>
                  <a:cxn ang="0">
                    <a:pos x="48" y="35"/>
                  </a:cxn>
                </a:cxnLst>
                <a:pathLst>
                  <a:path w="34" h="88">
                    <a:moveTo>
                      <a:pt x="34" y="21"/>
                    </a:moveTo>
                    <a:cubicBezTo>
                      <a:pt x="23" y="26"/>
                      <a:pt x="18" y="0"/>
                      <a:pt x="8" y="1"/>
                    </a:cubicBezTo>
                    <a:cubicBezTo>
                      <a:pt x="0" y="1"/>
                      <a:pt x="9" y="37"/>
                      <a:pt x="9" y="45"/>
                    </a:cubicBezTo>
                    <a:cubicBezTo>
                      <a:pt x="9" y="55"/>
                      <a:pt x="5" y="67"/>
                      <a:pt x="7" y="76"/>
                    </a:cubicBezTo>
                    <a:cubicBezTo>
                      <a:pt x="9" y="88"/>
                      <a:pt x="18" y="81"/>
                      <a:pt x="24" y="74"/>
                    </a:cubicBezTo>
                    <a:cubicBezTo>
                      <a:pt x="34" y="60"/>
                      <a:pt x="32" y="34"/>
                      <a:pt x="27" y="20"/>
                    </a:cubicBezTo>
                  </a:path>
                </a:pathLst>
              </a:custGeom>
              <a:solidFill>
                <a:srgbClr val="F7F4F3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2147" name="Freeform 36"/>
              <p:cNvSpPr/>
              <p:nvPr/>
            </p:nvSpPr>
            <p:spPr>
              <a:xfrm>
                <a:off x="1251" y="1161"/>
                <a:ext cx="110" cy="194"/>
              </a:xfrm>
              <a:custGeom>
                <a:avLst/>
                <a:gdLst/>
                <a:ahLst/>
                <a:cxnLst>
                  <a:cxn ang="0">
                    <a:pos x="154" y="12"/>
                  </a:cxn>
                  <a:cxn ang="0">
                    <a:pos x="89" y="8"/>
                  </a:cxn>
                  <a:cxn ang="0">
                    <a:pos x="49" y="35"/>
                  </a:cxn>
                  <a:cxn ang="0">
                    <a:pos x="29" y="137"/>
                  </a:cxn>
                  <a:cxn ang="0">
                    <a:pos x="15" y="217"/>
                  </a:cxn>
                  <a:cxn ang="0">
                    <a:pos x="20" y="263"/>
                  </a:cxn>
                  <a:cxn ang="0">
                    <a:pos x="48" y="189"/>
                  </a:cxn>
                  <a:cxn ang="0">
                    <a:pos x="79" y="150"/>
                  </a:cxn>
                  <a:cxn ang="0">
                    <a:pos x="101" y="179"/>
                  </a:cxn>
                  <a:cxn ang="0">
                    <a:pos x="128" y="76"/>
                  </a:cxn>
                  <a:cxn ang="0">
                    <a:pos x="159" y="75"/>
                  </a:cxn>
                  <a:cxn ang="0">
                    <a:pos x="150" y="16"/>
                  </a:cxn>
                </a:cxnLst>
                <a:pathLst>
                  <a:path w="90" h="160">
                    <a:moveTo>
                      <a:pt x="84" y="7"/>
                    </a:moveTo>
                    <a:cubicBezTo>
                      <a:pt x="75" y="0"/>
                      <a:pt x="59" y="4"/>
                      <a:pt x="49" y="5"/>
                    </a:cubicBezTo>
                    <a:cubicBezTo>
                      <a:pt x="35" y="6"/>
                      <a:pt x="31" y="6"/>
                      <a:pt x="27" y="20"/>
                    </a:cubicBezTo>
                    <a:cubicBezTo>
                      <a:pt x="22" y="39"/>
                      <a:pt x="20" y="59"/>
                      <a:pt x="16" y="77"/>
                    </a:cubicBezTo>
                    <a:cubicBezTo>
                      <a:pt x="12" y="92"/>
                      <a:pt x="10" y="107"/>
                      <a:pt x="8" y="122"/>
                    </a:cubicBezTo>
                    <a:cubicBezTo>
                      <a:pt x="8" y="128"/>
                      <a:pt x="0" y="160"/>
                      <a:pt x="11" y="148"/>
                    </a:cubicBezTo>
                    <a:cubicBezTo>
                      <a:pt x="20" y="139"/>
                      <a:pt x="21" y="118"/>
                      <a:pt x="26" y="106"/>
                    </a:cubicBezTo>
                    <a:cubicBezTo>
                      <a:pt x="28" y="102"/>
                      <a:pt x="36" y="83"/>
                      <a:pt x="43" y="84"/>
                    </a:cubicBezTo>
                    <a:cubicBezTo>
                      <a:pt x="47" y="85"/>
                      <a:pt x="49" y="122"/>
                      <a:pt x="56" y="101"/>
                    </a:cubicBezTo>
                    <a:cubicBezTo>
                      <a:pt x="60" y="87"/>
                      <a:pt x="50" y="50"/>
                      <a:pt x="70" y="43"/>
                    </a:cubicBezTo>
                    <a:cubicBezTo>
                      <a:pt x="78" y="41"/>
                      <a:pt x="82" y="52"/>
                      <a:pt x="87" y="42"/>
                    </a:cubicBezTo>
                    <a:cubicBezTo>
                      <a:pt x="90" y="35"/>
                      <a:pt x="86" y="15"/>
                      <a:pt x="83" y="9"/>
                    </a:cubicBezTo>
                  </a:path>
                </a:pathLst>
              </a:custGeom>
              <a:solidFill>
                <a:srgbClr val="F7F4F3"/>
              </a:solidFill>
              <a:ln w="9525">
                <a:noFill/>
              </a:ln>
            </p:spPr>
            <p:txBody>
              <a:bodyPr/>
              <a:p>
                <a:endParaRPr lang="zh-CN" altLang="en-US"/>
              </a:p>
            </p:txBody>
          </p:sp>
        </p:grpSp>
      </p:grpSp>
      <p:sp>
        <p:nvSpPr>
          <p:cNvPr id="2" name="文本框 1"/>
          <p:cNvSpPr txBox="1"/>
          <p:nvPr/>
        </p:nvSpPr>
        <p:spPr>
          <a:xfrm>
            <a:off x="158115" y="66675"/>
            <a:ext cx="4392295" cy="3371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2">
                    <a:lumMod val="75000"/>
                  </a:schemeClr>
                </a:solidFill>
              </a14:hiddenFill>
            </a:ext>
          </a:extLst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itle"/>
              </a:ext>
            </a:extLst>
          </a:bodyPr>
          <a:p>
            <a:pPr algn="just"/>
            <a:r>
              <a:rPr lang="zh-CN" altLang="en-US" sz="800" b="1" kern="1000">
                <a:solidFill>
                  <a:schemeClr val="accent2">
                    <a:lumMod val="7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charset="-122"/>
              </a:rPr>
              <a:t>PSATF-6mA: An integrated learning fusion feature-encoded DNA-6mA </a:t>
            </a:r>
            <a:endParaRPr lang="zh-CN" altLang="en-US" sz="800" b="1" kern="1000">
              <a:solidFill>
                <a:schemeClr val="accent2">
                  <a:lumMod val="75000"/>
                </a:schemeClr>
              </a:solidFill>
              <a:uFillTx/>
              <a:latin typeface="Arial" panose="020B0604020202020204" pitchFamily="34" charset="0"/>
              <a:ea typeface="微软雅黑" panose="020B0503020204020204" charset="-122"/>
            </a:endParaRPr>
          </a:p>
          <a:p>
            <a:pPr algn="just"/>
            <a:r>
              <a:rPr lang="zh-CN" altLang="en-US" sz="800" b="1" kern="1000">
                <a:solidFill>
                  <a:schemeClr val="accent2">
                    <a:lumMod val="7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charset="-122"/>
              </a:rPr>
              <a:t>methylcytosine modification site recognition model based on attentional mechanisms</a:t>
            </a:r>
            <a:endParaRPr lang="zh-CN" altLang="en-US" sz="800" b="1" kern="1000">
              <a:solidFill>
                <a:schemeClr val="accent2">
                  <a:lumMod val="75000"/>
                </a:schemeClr>
              </a:solidFill>
              <a:uFillTx/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08000" y="379685"/>
            <a:ext cx="4441190" cy="142240"/>
          </a:xfrm>
          <a:prstGeom prst="rect">
            <a:avLst/>
          </a:prstGeom>
          <a:solidFill>
            <a:srgbClr val="F58D14"/>
          </a:solidFill>
        </p:spPr>
        <p:txBody>
          <a:bodyPr wrap="square" lIns="36195" tIns="28575" rIns="53975" bIns="28575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600" b="1">
                <a:latin typeface="微软雅黑" panose="020B0503020204020204" charset="-122"/>
                <a:ea typeface="微软雅黑" panose="020B0503020204020204" charset="-122"/>
              </a:rPr>
              <a:t>      Data processing         Feature &amp; approach evaluation                                             Results</a:t>
            </a:r>
            <a:endParaRPr lang="en-US" altLang="zh-CN" sz="6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右箭头 3"/>
          <p:cNvSpPr/>
          <p:nvPr/>
        </p:nvSpPr>
        <p:spPr>
          <a:xfrm>
            <a:off x="1021715" y="1027430"/>
            <a:ext cx="144145" cy="144145"/>
          </a:xfrm>
          <a:prstGeom prst="rightArrow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151" name="图片 3" descr="Figure 3"/>
          <p:cNvPicPr>
            <a:picLocks noChangeAspect="1"/>
          </p:cNvPicPr>
          <p:nvPr/>
        </p:nvPicPr>
        <p:blipFill>
          <a:blip r:embed="rId5"/>
          <a:srcRect l="7008" t="-5097" r="4524"/>
          <a:stretch>
            <a:fillRect/>
          </a:stretch>
        </p:blipFill>
        <p:spPr>
          <a:xfrm>
            <a:off x="3486150" y="560070"/>
            <a:ext cx="1153795" cy="72644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7" name="右箭头 6"/>
          <p:cNvSpPr/>
          <p:nvPr/>
        </p:nvSpPr>
        <p:spPr>
          <a:xfrm>
            <a:off x="2141855" y="1027430"/>
            <a:ext cx="144145" cy="144145"/>
          </a:xfrm>
          <a:prstGeom prst="rightArrow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3110230" y="1388110"/>
            <a:ext cx="753745" cy="142240"/>
          </a:xfrm>
          <a:prstGeom prst="rect">
            <a:avLst/>
          </a:prstGeom>
          <a:solidFill>
            <a:srgbClr val="F58D14"/>
          </a:solidFill>
        </p:spPr>
        <p:txBody>
          <a:bodyPr wrap="square" lIns="36195" tIns="28575" rIns="53975" bIns="28575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ctr"/>
            <a:r>
              <a:rPr lang="en-US" altLang="zh-CN" sz="600" b="1">
                <a:solidFill>
                  <a:schemeClr val="tx1"/>
                </a:solidFill>
                <a:latin typeface="微软雅黑" panose="020B0503020204020204" charset="-122"/>
                <a:ea typeface="微软雅黑" panose="020B0503020204020204" charset="-122"/>
              </a:rPr>
              <a:t>Conclusion</a:t>
            </a:r>
            <a:endParaRPr lang="en-US" altLang="zh-CN" sz="600" b="1">
              <a:solidFill>
                <a:schemeClr val="tx1"/>
              </a:solidFill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379980" y="1532255"/>
            <a:ext cx="2275840" cy="266065"/>
          </a:xfrm>
          <a:prstGeom prst="rect">
            <a:avLst/>
          </a:prstGeom>
          <a:solidFill>
            <a:srgbClr val="D9D9D9"/>
          </a:solidFill>
          <a:ln w="6350" cmpd="sng">
            <a:solidFill>
              <a:srgbClr val="D9D9D9"/>
            </a:solidFill>
            <a:prstDash val="solid"/>
          </a:ln>
        </p:spPr>
        <p:txBody>
          <a:bodyPr wrap="square" lIns="36195" tIns="17780" rIns="36195" bIns="17780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just"/>
            <a:r>
              <a:rPr lang="zh-CN" altLang="en-US" sz="5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rPr>
              <a:t>PSATF-6mA model, leveraging multi-head self-attention and ensemble learning, offers improved accuracy in 6mA site recognition, empowering biologists to formulate novel testable hypotheses.</a:t>
            </a:r>
            <a:endParaRPr lang="zh-CN" altLang="en-US" sz="500">
              <a:solidFill>
                <a:schemeClr val="tx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318385" y="523875"/>
            <a:ext cx="2232025" cy="112395"/>
          </a:xfrm>
          <a:prstGeom prst="rect">
            <a:avLst/>
          </a:prstGeom>
          <a:solidFill>
            <a:srgbClr val="D9D9D9"/>
          </a:solidFill>
          <a:ln w="6350" cmpd="sng">
            <a:solidFill>
              <a:srgbClr val="D9D9D9"/>
            </a:solidFill>
            <a:prstDash val="solid"/>
          </a:ln>
        </p:spPr>
        <p:txBody>
          <a:bodyPr wrap="square" lIns="36195" tIns="17780" rIns="36195" bIns="17780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ctr"/>
            <a:r>
              <a:rPr lang="zh-CN" altLang="en-US" sz="5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rPr>
              <a:t>PSATF-6mA model outperforms the baseline model. </a:t>
            </a:r>
            <a:endParaRPr lang="zh-CN" altLang="en-US" sz="500">
              <a:solidFill>
                <a:schemeClr val="tx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OTc3M2Y5NzIzMDFlZjAyY2Q4Njk5ODkyYjFjNzBiNTQifQ==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4</Words>
  <Application>WPS 演示</Application>
  <PresentationFormat/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华文楷体</vt:lpstr>
      <vt:lpstr>微软雅黑</vt:lpstr>
      <vt:lpstr>Arial Unicode MS</vt:lpstr>
      <vt:lpstr>Calibri</vt:lpstr>
      <vt:lpstr>微软雅黑 Light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 X</dc:creator>
  <cp:lastModifiedBy>嗯呐</cp:lastModifiedBy>
  <cp:revision>7</cp:revision>
  <dcterms:created xsi:type="dcterms:W3CDTF">2024-08-08T15:56:00Z</dcterms:created>
  <dcterms:modified xsi:type="dcterms:W3CDTF">2024-08-22T08:05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7827</vt:lpwstr>
  </property>
  <property fmtid="{D5CDD505-2E9C-101B-9397-08002B2CF9AE}" pid="3" name="ICV">
    <vt:lpwstr>4BDD86CB4FB74D61AEC74AF6A56F70D7_12</vt:lpwstr>
  </property>
</Properties>
</file>